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9186" autoAdjust="0"/>
  </p:normalViewPr>
  <p:slideViewPr>
    <p:cSldViewPr snapToGrid="0">
      <p:cViewPr varScale="1">
        <p:scale>
          <a:sx n="75" d="100"/>
          <a:sy n="75" d="100"/>
        </p:scale>
        <p:origin x="97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42B5377-80C6-49AB-BC0B-D3A8BA9E38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1485ADA-A6D0-47A4-932F-2B2F731563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60548C5-15A6-4CC0-A3C2-80FB575B3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A529C04-EDEF-47FA-BB5C-FB060A0E7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48FA2E1-4BE7-452A-8CD4-A66E5A345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046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06BE86-7E79-42AF-AD8C-02F796CEE5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4EE503B-F734-4BEE-9135-67A39BC7D7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88CBE50-853D-4260-8906-841D01EBF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F7CD825-8FE9-444A-A92F-5DE2A0E35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669DFBD-F2B3-473D-B6CC-AF0561C5D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633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6E491FB-89FE-4BD2-B3CB-C2CAD6757C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EABD33B-5828-4D40-A78D-73397619B3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3A86240-20B2-4228-9FA6-91402658D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EB452C-74E2-4B17-AC09-E80802230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CCB365-6306-4196-8517-5EB2A2E00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440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8A3EE34-5E9C-42FC-8B3E-8B9A8BD32F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C434D1B-BF00-499B-B1C1-B5108C1F88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E3B50A4-0C6F-4AE0-91D6-4EB967F52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5EA8117-AF16-4349-9461-18CB3BD0B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70F5E47-7B32-4BE4-B074-C065D68E0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337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0548362-16A2-48A9-B6CC-C8579B9316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A2D810E-4D25-49B1-9689-A441A3F20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3ED4B9A-3F8B-4BDE-A0D9-49263C219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7AD352-D132-4F19-A436-1DF68FD09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EACF0DB-0DF3-4D94-8492-63DCC769C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8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239E097-E633-4B75-9C62-00E6DF196B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2B8A792-B0B0-4385-9D26-533CFC2FB1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5D83F8E-3990-47DE-A82A-DBC86CA06A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BD40D3F-5934-4A4D-AD17-BC4B76A7D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8269F1A-5C9B-4CEE-9A7C-2A5341A3D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224D072-BCB2-4F88-BF89-A69B3C891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007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B43B6C-8C0A-4B87-AF4F-CCDA68EB6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5FD6550-0CA6-4EE0-85E0-824B51EE03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66B319C-20E3-4F9A-8C7B-7D313F65A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533C488-3C48-45C7-B309-ECBF2C4D18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18D8F87-A5D2-4814-B588-D2FBFC4A7E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E195143-F2C0-4708-A67A-296107EF3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19B1C1D-0E79-4DCA-8E31-F8C45B182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5BB7229-0DFF-47C1-BDCF-76F2DC293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643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FAD0C9-AB12-46F1-B4B4-17B928C5B0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67FF6001-2A71-49DC-925B-D01DA7ACC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EC1251A-AE2D-4FAD-AE84-5FA27A1D6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C689CDC-9053-4E68-B5FE-9F5C803B0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278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635D6F2-422A-44A0-80D8-1053DA9AB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2C3F823-C737-411A-BF19-8BE851CFC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B48AFB10-08EE-4502-B154-9B7A20BEAE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051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B134CDF-1990-444A-8CB2-36D9A0E7E9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24C6D87-14A2-4F30-99A1-44DA9431CA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5B13B90-3A20-4170-8BF2-B80D7BDE93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C15A85B-8CC9-4650-A46A-F644AAFB0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AAFF3D6-EFB7-477C-8C67-52AF085E41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7E0FCFE-CBE5-4205-BB5B-80C0BEF2F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79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33EE5DC-CDC4-422A-AB0C-FF52364C5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E7476A0-3B76-4883-9425-97670F91D2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0D127D-4F6A-4AD6-A673-1DEE2782FD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42EB98B-8622-45EB-8B75-931FA99D1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DADACF6-99C6-4DEB-BB0B-CD88EA93C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9C393AE-5DDE-4339-882D-B536A13F9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636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FD59D97-E23E-47CF-B3B7-2637FB3865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029CCEE-DD00-481C-B752-3874EA9A1E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F13DAB8-B941-490A-8B96-5DF7105019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6E820D-8DF3-4C6E-8698-13954CAD7AED}" type="datetimeFigureOut">
              <a:rPr lang="en-US" smtClean="0"/>
              <a:t>9/27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358BB06-8EB7-40F7-9324-7B47E819A5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DDAA8FA-45DC-49BA-9A94-143E820CAC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788330-B045-4EBD-8947-F504F4989CC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98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E4323EDA-5850-43D7-9489-DAC676832F84}"/>
              </a:ext>
            </a:extLst>
          </p:cNvPr>
          <p:cNvGrpSpPr/>
          <p:nvPr/>
        </p:nvGrpSpPr>
        <p:grpSpPr>
          <a:xfrm>
            <a:off x="487680" y="83489"/>
            <a:ext cx="10800673" cy="4354432"/>
            <a:chOff x="-313330" y="592649"/>
            <a:chExt cx="11776943" cy="4748028"/>
          </a:xfrm>
        </p:grpSpPr>
        <p:grpSp>
          <p:nvGrpSpPr>
            <p:cNvPr id="5" name="Groupe 4">
              <a:extLst>
                <a:ext uri="{FF2B5EF4-FFF2-40B4-BE49-F238E27FC236}">
                  <a16:creationId xmlns:a16="http://schemas.microsoft.com/office/drawing/2014/main" id="{7F504AC9-1A03-405B-A9EE-24869E9751A0}"/>
                </a:ext>
              </a:extLst>
            </p:cNvPr>
            <p:cNvGrpSpPr/>
            <p:nvPr/>
          </p:nvGrpSpPr>
          <p:grpSpPr>
            <a:xfrm>
              <a:off x="7713003" y="1099740"/>
              <a:ext cx="3750610" cy="4240937"/>
              <a:chOff x="7713003" y="1099740"/>
              <a:chExt cx="3750610" cy="4240937"/>
            </a:xfrm>
          </p:grpSpPr>
          <p:sp>
            <p:nvSpPr>
              <p:cNvPr id="267" name="Rectangle 531">
                <a:extLst>
                  <a:ext uri="{FF2B5EF4-FFF2-40B4-BE49-F238E27FC236}">
                    <a16:creationId xmlns:a16="http://schemas.microsoft.com/office/drawing/2014/main" id="{A58EBE24-9063-403A-90C4-2D73B8ACC6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7665762" y="2275693"/>
                <a:ext cx="279400" cy="1849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S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8" name="Freeform 452">
                <a:extLst>
                  <a:ext uri="{FF2B5EF4-FFF2-40B4-BE49-F238E27FC236}">
                    <a16:creationId xmlns:a16="http://schemas.microsoft.com/office/drawing/2014/main" id="{CA2C2BE4-0F71-44E7-9F6E-78604D3F24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21269" y="1220390"/>
                <a:ext cx="2471446" cy="801688"/>
              </a:xfrm>
              <a:custGeom>
                <a:avLst/>
                <a:gdLst>
                  <a:gd name="T0" fmla="*/ 4 w 333"/>
                  <a:gd name="T1" fmla="*/ 0 h 100"/>
                  <a:gd name="T2" fmla="*/ 18 w 333"/>
                  <a:gd name="T3" fmla="*/ 6 h 100"/>
                  <a:gd name="T4" fmla="*/ 20 w 333"/>
                  <a:gd name="T5" fmla="*/ 6 h 100"/>
                  <a:gd name="T6" fmla="*/ 24 w 333"/>
                  <a:gd name="T7" fmla="*/ 6 h 100"/>
                  <a:gd name="T8" fmla="*/ 27 w 333"/>
                  <a:gd name="T9" fmla="*/ 12 h 100"/>
                  <a:gd name="T10" fmla="*/ 39 w 333"/>
                  <a:gd name="T11" fmla="*/ 18 h 100"/>
                  <a:gd name="T12" fmla="*/ 41 w 333"/>
                  <a:gd name="T13" fmla="*/ 24 h 100"/>
                  <a:gd name="T14" fmla="*/ 52 w 333"/>
                  <a:gd name="T15" fmla="*/ 30 h 100"/>
                  <a:gd name="T16" fmla="*/ 52 w 333"/>
                  <a:gd name="T17" fmla="*/ 30 h 100"/>
                  <a:gd name="T18" fmla="*/ 59 w 333"/>
                  <a:gd name="T19" fmla="*/ 30 h 100"/>
                  <a:gd name="T20" fmla="*/ 62 w 333"/>
                  <a:gd name="T21" fmla="*/ 36 h 100"/>
                  <a:gd name="T22" fmla="*/ 68 w 333"/>
                  <a:gd name="T23" fmla="*/ 43 h 100"/>
                  <a:gd name="T24" fmla="*/ 82 w 333"/>
                  <a:gd name="T25" fmla="*/ 49 h 100"/>
                  <a:gd name="T26" fmla="*/ 113 w 333"/>
                  <a:gd name="T27" fmla="*/ 56 h 100"/>
                  <a:gd name="T28" fmla="*/ 114 w 333"/>
                  <a:gd name="T29" fmla="*/ 62 h 100"/>
                  <a:gd name="T30" fmla="*/ 116 w 333"/>
                  <a:gd name="T31" fmla="*/ 68 h 100"/>
                  <a:gd name="T32" fmla="*/ 124 w 333"/>
                  <a:gd name="T33" fmla="*/ 75 h 100"/>
                  <a:gd name="T34" fmla="*/ 130 w 333"/>
                  <a:gd name="T35" fmla="*/ 81 h 100"/>
                  <a:gd name="T36" fmla="*/ 135 w 333"/>
                  <a:gd name="T37" fmla="*/ 88 h 100"/>
                  <a:gd name="T38" fmla="*/ 137 w 333"/>
                  <a:gd name="T39" fmla="*/ 94 h 100"/>
                  <a:gd name="T40" fmla="*/ 187 w 333"/>
                  <a:gd name="T41" fmla="*/ 100 h 100"/>
                  <a:gd name="T42" fmla="*/ 195 w 333"/>
                  <a:gd name="T43" fmla="*/ 100 h 100"/>
                  <a:gd name="T44" fmla="*/ 196 w 333"/>
                  <a:gd name="T45" fmla="*/ 100 h 100"/>
                  <a:gd name="T46" fmla="*/ 196 w 333"/>
                  <a:gd name="T47" fmla="*/ 100 h 100"/>
                  <a:gd name="T48" fmla="*/ 198 w 333"/>
                  <a:gd name="T49" fmla="*/ 100 h 100"/>
                  <a:gd name="T50" fmla="*/ 198 w 333"/>
                  <a:gd name="T51" fmla="*/ 100 h 100"/>
                  <a:gd name="T52" fmla="*/ 200 w 333"/>
                  <a:gd name="T53" fmla="*/ 100 h 100"/>
                  <a:gd name="T54" fmla="*/ 202 w 333"/>
                  <a:gd name="T55" fmla="*/ 100 h 100"/>
                  <a:gd name="T56" fmla="*/ 207 w 333"/>
                  <a:gd name="T57" fmla="*/ 100 h 100"/>
                  <a:gd name="T58" fmla="*/ 208 w 333"/>
                  <a:gd name="T59" fmla="*/ 100 h 100"/>
                  <a:gd name="T60" fmla="*/ 215 w 333"/>
                  <a:gd name="T61" fmla="*/ 100 h 100"/>
                  <a:gd name="T62" fmla="*/ 216 w 333"/>
                  <a:gd name="T63" fmla="*/ 100 h 100"/>
                  <a:gd name="T64" fmla="*/ 220 w 333"/>
                  <a:gd name="T65" fmla="*/ 100 h 100"/>
                  <a:gd name="T66" fmla="*/ 226 w 333"/>
                  <a:gd name="T67" fmla="*/ 100 h 100"/>
                  <a:gd name="T68" fmla="*/ 226 w 333"/>
                  <a:gd name="T69" fmla="*/ 100 h 100"/>
                  <a:gd name="T70" fmla="*/ 241 w 333"/>
                  <a:gd name="T71" fmla="*/ 100 h 100"/>
                  <a:gd name="T72" fmla="*/ 245 w 333"/>
                  <a:gd name="T73" fmla="*/ 100 h 100"/>
                  <a:gd name="T74" fmla="*/ 248 w 333"/>
                  <a:gd name="T75" fmla="*/ 100 h 100"/>
                  <a:gd name="T76" fmla="*/ 257 w 333"/>
                  <a:gd name="T77" fmla="*/ 100 h 100"/>
                  <a:gd name="T78" fmla="*/ 274 w 333"/>
                  <a:gd name="T79" fmla="*/ 100 h 100"/>
                  <a:gd name="T80" fmla="*/ 280 w 333"/>
                  <a:gd name="T81" fmla="*/ 100 h 100"/>
                  <a:gd name="T82" fmla="*/ 286 w 333"/>
                  <a:gd name="T83" fmla="*/ 100 h 100"/>
                  <a:gd name="T84" fmla="*/ 286 w 333"/>
                  <a:gd name="T85" fmla="*/ 100 h 100"/>
                  <a:gd name="T86" fmla="*/ 292 w 333"/>
                  <a:gd name="T87" fmla="*/ 100 h 100"/>
                  <a:gd name="T88" fmla="*/ 302 w 333"/>
                  <a:gd name="T89" fmla="*/ 100 h 100"/>
                  <a:gd name="T90" fmla="*/ 308 w 333"/>
                  <a:gd name="T91" fmla="*/ 100 h 100"/>
                  <a:gd name="T92" fmla="*/ 318 w 333"/>
                  <a:gd name="T93" fmla="*/ 100 h 100"/>
                  <a:gd name="T94" fmla="*/ 333 w 333"/>
                  <a:gd name="T95" fmla="*/ 10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</a:cxnLst>
                <a:rect l="0" t="0" r="r" b="b"/>
                <a:pathLst>
                  <a:path w="333" h="100">
                    <a:moveTo>
                      <a:pt x="0" y="0"/>
                    </a:moveTo>
                    <a:lnTo>
                      <a:pt x="4" y="0"/>
                    </a:lnTo>
                    <a:lnTo>
                      <a:pt x="4" y="6"/>
                    </a:lnTo>
                    <a:lnTo>
                      <a:pt x="18" y="6"/>
                    </a:lnTo>
                    <a:lnTo>
                      <a:pt x="18" y="6"/>
                    </a:lnTo>
                    <a:lnTo>
                      <a:pt x="20" y="6"/>
                    </a:lnTo>
                    <a:lnTo>
                      <a:pt x="20" y="6"/>
                    </a:lnTo>
                    <a:lnTo>
                      <a:pt x="24" y="6"/>
                    </a:lnTo>
                    <a:lnTo>
                      <a:pt x="24" y="12"/>
                    </a:lnTo>
                    <a:lnTo>
                      <a:pt x="27" y="12"/>
                    </a:lnTo>
                    <a:lnTo>
                      <a:pt x="27" y="18"/>
                    </a:lnTo>
                    <a:lnTo>
                      <a:pt x="39" y="18"/>
                    </a:lnTo>
                    <a:lnTo>
                      <a:pt x="39" y="24"/>
                    </a:lnTo>
                    <a:lnTo>
                      <a:pt x="41" y="24"/>
                    </a:lnTo>
                    <a:lnTo>
                      <a:pt x="41" y="30"/>
                    </a:lnTo>
                    <a:lnTo>
                      <a:pt x="52" y="30"/>
                    </a:lnTo>
                    <a:lnTo>
                      <a:pt x="52" y="30"/>
                    </a:lnTo>
                    <a:lnTo>
                      <a:pt x="52" y="30"/>
                    </a:lnTo>
                    <a:lnTo>
                      <a:pt x="52" y="30"/>
                    </a:lnTo>
                    <a:lnTo>
                      <a:pt x="59" y="30"/>
                    </a:lnTo>
                    <a:lnTo>
                      <a:pt x="59" y="36"/>
                    </a:lnTo>
                    <a:lnTo>
                      <a:pt x="62" y="36"/>
                    </a:lnTo>
                    <a:lnTo>
                      <a:pt x="62" y="43"/>
                    </a:lnTo>
                    <a:lnTo>
                      <a:pt x="68" y="43"/>
                    </a:lnTo>
                    <a:lnTo>
                      <a:pt x="68" y="49"/>
                    </a:lnTo>
                    <a:lnTo>
                      <a:pt x="82" y="49"/>
                    </a:lnTo>
                    <a:lnTo>
                      <a:pt x="82" y="56"/>
                    </a:lnTo>
                    <a:lnTo>
                      <a:pt x="113" y="56"/>
                    </a:lnTo>
                    <a:lnTo>
                      <a:pt x="113" y="62"/>
                    </a:lnTo>
                    <a:lnTo>
                      <a:pt x="114" y="62"/>
                    </a:lnTo>
                    <a:lnTo>
                      <a:pt x="114" y="68"/>
                    </a:lnTo>
                    <a:lnTo>
                      <a:pt x="116" y="68"/>
                    </a:lnTo>
                    <a:lnTo>
                      <a:pt x="116" y="75"/>
                    </a:lnTo>
                    <a:lnTo>
                      <a:pt x="124" y="75"/>
                    </a:lnTo>
                    <a:lnTo>
                      <a:pt x="124" y="81"/>
                    </a:lnTo>
                    <a:lnTo>
                      <a:pt x="130" y="81"/>
                    </a:lnTo>
                    <a:lnTo>
                      <a:pt x="130" y="88"/>
                    </a:lnTo>
                    <a:lnTo>
                      <a:pt x="135" y="88"/>
                    </a:lnTo>
                    <a:lnTo>
                      <a:pt x="135" y="94"/>
                    </a:lnTo>
                    <a:lnTo>
                      <a:pt x="137" y="94"/>
                    </a:lnTo>
                    <a:lnTo>
                      <a:pt x="137" y="100"/>
                    </a:lnTo>
                    <a:lnTo>
                      <a:pt x="187" y="100"/>
                    </a:lnTo>
                    <a:lnTo>
                      <a:pt x="187" y="100"/>
                    </a:lnTo>
                    <a:lnTo>
                      <a:pt x="195" y="100"/>
                    </a:lnTo>
                    <a:lnTo>
                      <a:pt x="195" y="100"/>
                    </a:lnTo>
                    <a:lnTo>
                      <a:pt x="196" y="100"/>
                    </a:lnTo>
                    <a:lnTo>
                      <a:pt x="196" y="100"/>
                    </a:lnTo>
                    <a:lnTo>
                      <a:pt x="196" y="100"/>
                    </a:lnTo>
                    <a:lnTo>
                      <a:pt x="196" y="100"/>
                    </a:lnTo>
                    <a:lnTo>
                      <a:pt x="198" y="100"/>
                    </a:lnTo>
                    <a:lnTo>
                      <a:pt x="198" y="100"/>
                    </a:lnTo>
                    <a:lnTo>
                      <a:pt x="198" y="100"/>
                    </a:lnTo>
                    <a:lnTo>
                      <a:pt x="198" y="100"/>
                    </a:lnTo>
                    <a:lnTo>
                      <a:pt x="200" y="100"/>
                    </a:lnTo>
                    <a:lnTo>
                      <a:pt x="200" y="100"/>
                    </a:lnTo>
                    <a:lnTo>
                      <a:pt x="202" y="100"/>
                    </a:lnTo>
                    <a:lnTo>
                      <a:pt x="202" y="100"/>
                    </a:lnTo>
                    <a:lnTo>
                      <a:pt x="207" y="100"/>
                    </a:lnTo>
                    <a:lnTo>
                      <a:pt x="207" y="100"/>
                    </a:lnTo>
                    <a:lnTo>
                      <a:pt x="208" y="100"/>
                    </a:lnTo>
                    <a:lnTo>
                      <a:pt x="208" y="100"/>
                    </a:lnTo>
                    <a:lnTo>
                      <a:pt x="215" y="100"/>
                    </a:lnTo>
                    <a:lnTo>
                      <a:pt x="215" y="100"/>
                    </a:lnTo>
                    <a:lnTo>
                      <a:pt x="216" y="100"/>
                    </a:lnTo>
                    <a:lnTo>
                      <a:pt x="216" y="100"/>
                    </a:lnTo>
                    <a:lnTo>
                      <a:pt x="220" y="100"/>
                    </a:lnTo>
                    <a:lnTo>
                      <a:pt x="220" y="100"/>
                    </a:lnTo>
                    <a:lnTo>
                      <a:pt x="226" y="100"/>
                    </a:lnTo>
                    <a:lnTo>
                      <a:pt x="226" y="100"/>
                    </a:lnTo>
                    <a:lnTo>
                      <a:pt x="226" y="100"/>
                    </a:lnTo>
                    <a:lnTo>
                      <a:pt x="226" y="100"/>
                    </a:lnTo>
                    <a:lnTo>
                      <a:pt x="241" y="100"/>
                    </a:lnTo>
                    <a:lnTo>
                      <a:pt x="241" y="100"/>
                    </a:lnTo>
                    <a:lnTo>
                      <a:pt x="245" y="100"/>
                    </a:lnTo>
                    <a:lnTo>
                      <a:pt x="245" y="100"/>
                    </a:lnTo>
                    <a:lnTo>
                      <a:pt x="248" y="100"/>
                    </a:lnTo>
                    <a:lnTo>
                      <a:pt x="248" y="100"/>
                    </a:lnTo>
                    <a:lnTo>
                      <a:pt x="257" y="100"/>
                    </a:lnTo>
                    <a:lnTo>
                      <a:pt x="257" y="100"/>
                    </a:lnTo>
                    <a:lnTo>
                      <a:pt x="274" y="100"/>
                    </a:lnTo>
                    <a:lnTo>
                      <a:pt x="274" y="100"/>
                    </a:lnTo>
                    <a:lnTo>
                      <a:pt x="280" y="100"/>
                    </a:lnTo>
                    <a:lnTo>
                      <a:pt x="280" y="100"/>
                    </a:lnTo>
                    <a:lnTo>
                      <a:pt x="286" y="100"/>
                    </a:lnTo>
                    <a:lnTo>
                      <a:pt x="286" y="100"/>
                    </a:lnTo>
                    <a:lnTo>
                      <a:pt x="286" y="100"/>
                    </a:lnTo>
                    <a:lnTo>
                      <a:pt x="286" y="100"/>
                    </a:lnTo>
                    <a:lnTo>
                      <a:pt x="292" y="100"/>
                    </a:lnTo>
                    <a:lnTo>
                      <a:pt x="292" y="100"/>
                    </a:lnTo>
                    <a:lnTo>
                      <a:pt x="302" y="100"/>
                    </a:lnTo>
                    <a:lnTo>
                      <a:pt x="302" y="100"/>
                    </a:lnTo>
                    <a:lnTo>
                      <a:pt x="308" y="100"/>
                    </a:lnTo>
                    <a:lnTo>
                      <a:pt x="308" y="100"/>
                    </a:lnTo>
                    <a:lnTo>
                      <a:pt x="318" y="100"/>
                    </a:lnTo>
                    <a:lnTo>
                      <a:pt x="318" y="100"/>
                    </a:lnTo>
                    <a:lnTo>
                      <a:pt x="333" y="100"/>
                    </a:lnTo>
                    <a:lnTo>
                      <a:pt x="333" y="100"/>
                    </a:lnTo>
                  </a:path>
                </a:pathLst>
              </a:custGeom>
              <a:noFill/>
              <a:ln w="15875" cap="flat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9" name="Freeform 453">
                <a:extLst>
                  <a:ext uri="{FF2B5EF4-FFF2-40B4-BE49-F238E27FC236}">
                    <a16:creationId xmlns:a16="http://schemas.microsoft.com/office/drawing/2014/main" id="{6E5BF3D5-4489-4C68-AECA-DAA0126068D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21269" y="1220390"/>
                <a:ext cx="1447058" cy="2197100"/>
              </a:xfrm>
              <a:custGeom>
                <a:avLst/>
                <a:gdLst>
                  <a:gd name="T0" fmla="*/ 0 w 195"/>
                  <a:gd name="T1" fmla="*/ 0 h 274"/>
                  <a:gd name="T2" fmla="*/ 5 w 195"/>
                  <a:gd name="T3" fmla="*/ 0 h 274"/>
                  <a:gd name="T4" fmla="*/ 5 w 195"/>
                  <a:gd name="T5" fmla="*/ 10 h 274"/>
                  <a:gd name="T6" fmla="*/ 9 w 195"/>
                  <a:gd name="T7" fmla="*/ 10 h 274"/>
                  <a:gd name="T8" fmla="*/ 9 w 195"/>
                  <a:gd name="T9" fmla="*/ 21 h 274"/>
                  <a:gd name="T10" fmla="*/ 13 w 195"/>
                  <a:gd name="T11" fmla="*/ 21 h 274"/>
                  <a:gd name="T12" fmla="*/ 13 w 195"/>
                  <a:gd name="T13" fmla="*/ 31 h 274"/>
                  <a:gd name="T14" fmla="*/ 16 w 195"/>
                  <a:gd name="T15" fmla="*/ 31 h 274"/>
                  <a:gd name="T16" fmla="*/ 16 w 195"/>
                  <a:gd name="T17" fmla="*/ 42 h 274"/>
                  <a:gd name="T18" fmla="*/ 28 w 195"/>
                  <a:gd name="T19" fmla="*/ 42 h 274"/>
                  <a:gd name="T20" fmla="*/ 28 w 195"/>
                  <a:gd name="T21" fmla="*/ 53 h 274"/>
                  <a:gd name="T22" fmla="*/ 32 w 195"/>
                  <a:gd name="T23" fmla="*/ 53 h 274"/>
                  <a:gd name="T24" fmla="*/ 32 w 195"/>
                  <a:gd name="T25" fmla="*/ 63 h 274"/>
                  <a:gd name="T26" fmla="*/ 35 w 195"/>
                  <a:gd name="T27" fmla="*/ 63 h 274"/>
                  <a:gd name="T28" fmla="*/ 35 w 195"/>
                  <a:gd name="T29" fmla="*/ 74 h 274"/>
                  <a:gd name="T30" fmla="*/ 37 w 195"/>
                  <a:gd name="T31" fmla="*/ 74 h 274"/>
                  <a:gd name="T32" fmla="*/ 37 w 195"/>
                  <a:gd name="T33" fmla="*/ 74 h 274"/>
                  <a:gd name="T34" fmla="*/ 38 w 195"/>
                  <a:gd name="T35" fmla="*/ 74 h 274"/>
                  <a:gd name="T36" fmla="*/ 38 w 195"/>
                  <a:gd name="T37" fmla="*/ 85 h 274"/>
                  <a:gd name="T38" fmla="*/ 42 w 195"/>
                  <a:gd name="T39" fmla="*/ 85 h 274"/>
                  <a:gd name="T40" fmla="*/ 42 w 195"/>
                  <a:gd name="T41" fmla="*/ 96 h 274"/>
                  <a:gd name="T42" fmla="*/ 46 w 195"/>
                  <a:gd name="T43" fmla="*/ 96 h 274"/>
                  <a:gd name="T44" fmla="*/ 46 w 195"/>
                  <a:gd name="T45" fmla="*/ 107 h 274"/>
                  <a:gd name="T46" fmla="*/ 48 w 195"/>
                  <a:gd name="T47" fmla="*/ 107 h 274"/>
                  <a:gd name="T48" fmla="*/ 48 w 195"/>
                  <a:gd name="T49" fmla="*/ 119 h 274"/>
                  <a:gd name="T50" fmla="*/ 55 w 195"/>
                  <a:gd name="T51" fmla="*/ 119 h 274"/>
                  <a:gd name="T52" fmla="*/ 55 w 195"/>
                  <a:gd name="T53" fmla="*/ 130 h 274"/>
                  <a:gd name="T54" fmla="*/ 55 w 195"/>
                  <a:gd name="T55" fmla="*/ 130 h 274"/>
                  <a:gd name="T56" fmla="*/ 55 w 195"/>
                  <a:gd name="T57" fmla="*/ 130 h 274"/>
                  <a:gd name="T58" fmla="*/ 65 w 195"/>
                  <a:gd name="T59" fmla="*/ 130 h 274"/>
                  <a:gd name="T60" fmla="*/ 65 w 195"/>
                  <a:gd name="T61" fmla="*/ 142 h 274"/>
                  <a:gd name="T62" fmla="*/ 65 w 195"/>
                  <a:gd name="T63" fmla="*/ 142 h 274"/>
                  <a:gd name="T64" fmla="*/ 65 w 195"/>
                  <a:gd name="T65" fmla="*/ 154 h 274"/>
                  <a:gd name="T66" fmla="*/ 87 w 195"/>
                  <a:gd name="T67" fmla="*/ 154 h 274"/>
                  <a:gd name="T68" fmla="*/ 87 w 195"/>
                  <a:gd name="T69" fmla="*/ 166 h 274"/>
                  <a:gd name="T70" fmla="*/ 90 w 195"/>
                  <a:gd name="T71" fmla="*/ 166 h 274"/>
                  <a:gd name="T72" fmla="*/ 90 w 195"/>
                  <a:gd name="T73" fmla="*/ 178 h 274"/>
                  <a:gd name="T74" fmla="*/ 90 w 195"/>
                  <a:gd name="T75" fmla="*/ 178 h 274"/>
                  <a:gd name="T76" fmla="*/ 90 w 195"/>
                  <a:gd name="T77" fmla="*/ 190 h 274"/>
                  <a:gd name="T78" fmla="*/ 96 w 195"/>
                  <a:gd name="T79" fmla="*/ 190 h 274"/>
                  <a:gd name="T80" fmla="*/ 96 w 195"/>
                  <a:gd name="T81" fmla="*/ 202 h 274"/>
                  <a:gd name="T82" fmla="*/ 108 w 195"/>
                  <a:gd name="T83" fmla="*/ 202 h 274"/>
                  <a:gd name="T84" fmla="*/ 108 w 195"/>
                  <a:gd name="T85" fmla="*/ 214 h 274"/>
                  <a:gd name="T86" fmla="*/ 110 w 195"/>
                  <a:gd name="T87" fmla="*/ 214 h 274"/>
                  <a:gd name="T88" fmla="*/ 110 w 195"/>
                  <a:gd name="T89" fmla="*/ 226 h 274"/>
                  <a:gd name="T90" fmla="*/ 120 w 195"/>
                  <a:gd name="T91" fmla="*/ 226 h 274"/>
                  <a:gd name="T92" fmla="*/ 120 w 195"/>
                  <a:gd name="T93" fmla="*/ 238 h 274"/>
                  <a:gd name="T94" fmla="*/ 139 w 195"/>
                  <a:gd name="T95" fmla="*/ 238 h 274"/>
                  <a:gd name="T96" fmla="*/ 139 w 195"/>
                  <a:gd name="T97" fmla="*/ 250 h 274"/>
                  <a:gd name="T98" fmla="*/ 169 w 195"/>
                  <a:gd name="T99" fmla="*/ 250 h 274"/>
                  <a:gd name="T100" fmla="*/ 169 w 195"/>
                  <a:gd name="T101" fmla="*/ 262 h 274"/>
                  <a:gd name="T102" fmla="*/ 191 w 195"/>
                  <a:gd name="T103" fmla="*/ 262 h 274"/>
                  <a:gd name="T104" fmla="*/ 191 w 195"/>
                  <a:gd name="T105" fmla="*/ 274 h 274"/>
                  <a:gd name="T106" fmla="*/ 195 w 195"/>
                  <a:gd name="T107" fmla="*/ 274 h 274"/>
                  <a:gd name="T108" fmla="*/ 195 w 195"/>
                  <a:gd name="T109" fmla="*/ 274 h 2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</a:cxnLst>
                <a:rect l="0" t="0" r="r" b="b"/>
                <a:pathLst>
                  <a:path w="195" h="274">
                    <a:moveTo>
                      <a:pt x="0" y="0"/>
                    </a:moveTo>
                    <a:lnTo>
                      <a:pt x="5" y="0"/>
                    </a:lnTo>
                    <a:lnTo>
                      <a:pt x="5" y="10"/>
                    </a:lnTo>
                    <a:lnTo>
                      <a:pt x="9" y="10"/>
                    </a:lnTo>
                    <a:lnTo>
                      <a:pt x="9" y="21"/>
                    </a:lnTo>
                    <a:lnTo>
                      <a:pt x="13" y="21"/>
                    </a:lnTo>
                    <a:lnTo>
                      <a:pt x="13" y="31"/>
                    </a:lnTo>
                    <a:lnTo>
                      <a:pt x="16" y="31"/>
                    </a:lnTo>
                    <a:lnTo>
                      <a:pt x="16" y="42"/>
                    </a:lnTo>
                    <a:lnTo>
                      <a:pt x="28" y="42"/>
                    </a:lnTo>
                    <a:lnTo>
                      <a:pt x="28" y="53"/>
                    </a:lnTo>
                    <a:lnTo>
                      <a:pt x="32" y="53"/>
                    </a:lnTo>
                    <a:lnTo>
                      <a:pt x="32" y="63"/>
                    </a:lnTo>
                    <a:lnTo>
                      <a:pt x="35" y="63"/>
                    </a:lnTo>
                    <a:lnTo>
                      <a:pt x="35" y="74"/>
                    </a:lnTo>
                    <a:lnTo>
                      <a:pt x="37" y="74"/>
                    </a:lnTo>
                    <a:lnTo>
                      <a:pt x="37" y="74"/>
                    </a:lnTo>
                    <a:lnTo>
                      <a:pt x="38" y="74"/>
                    </a:lnTo>
                    <a:lnTo>
                      <a:pt x="38" y="85"/>
                    </a:lnTo>
                    <a:lnTo>
                      <a:pt x="42" y="85"/>
                    </a:lnTo>
                    <a:lnTo>
                      <a:pt x="42" y="96"/>
                    </a:lnTo>
                    <a:lnTo>
                      <a:pt x="46" y="96"/>
                    </a:lnTo>
                    <a:lnTo>
                      <a:pt x="46" y="107"/>
                    </a:lnTo>
                    <a:lnTo>
                      <a:pt x="48" y="107"/>
                    </a:lnTo>
                    <a:lnTo>
                      <a:pt x="48" y="119"/>
                    </a:lnTo>
                    <a:lnTo>
                      <a:pt x="55" y="119"/>
                    </a:lnTo>
                    <a:lnTo>
                      <a:pt x="55" y="130"/>
                    </a:lnTo>
                    <a:lnTo>
                      <a:pt x="55" y="130"/>
                    </a:lnTo>
                    <a:lnTo>
                      <a:pt x="55" y="130"/>
                    </a:lnTo>
                    <a:lnTo>
                      <a:pt x="65" y="130"/>
                    </a:lnTo>
                    <a:lnTo>
                      <a:pt x="65" y="142"/>
                    </a:lnTo>
                    <a:lnTo>
                      <a:pt x="65" y="142"/>
                    </a:lnTo>
                    <a:lnTo>
                      <a:pt x="65" y="154"/>
                    </a:lnTo>
                    <a:lnTo>
                      <a:pt x="87" y="154"/>
                    </a:lnTo>
                    <a:lnTo>
                      <a:pt x="87" y="166"/>
                    </a:lnTo>
                    <a:lnTo>
                      <a:pt x="90" y="166"/>
                    </a:lnTo>
                    <a:lnTo>
                      <a:pt x="90" y="178"/>
                    </a:lnTo>
                    <a:lnTo>
                      <a:pt x="90" y="178"/>
                    </a:lnTo>
                    <a:lnTo>
                      <a:pt x="90" y="190"/>
                    </a:lnTo>
                    <a:lnTo>
                      <a:pt x="96" y="190"/>
                    </a:lnTo>
                    <a:lnTo>
                      <a:pt x="96" y="202"/>
                    </a:lnTo>
                    <a:lnTo>
                      <a:pt x="108" y="202"/>
                    </a:lnTo>
                    <a:lnTo>
                      <a:pt x="108" y="214"/>
                    </a:lnTo>
                    <a:lnTo>
                      <a:pt x="110" y="214"/>
                    </a:lnTo>
                    <a:lnTo>
                      <a:pt x="110" y="226"/>
                    </a:lnTo>
                    <a:lnTo>
                      <a:pt x="120" y="226"/>
                    </a:lnTo>
                    <a:lnTo>
                      <a:pt x="120" y="238"/>
                    </a:lnTo>
                    <a:lnTo>
                      <a:pt x="139" y="238"/>
                    </a:lnTo>
                    <a:lnTo>
                      <a:pt x="139" y="250"/>
                    </a:lnTo>
                    <a:lnTo>
                      <a:pt x="169" y="250"/>
                    </a:lnTo>
                    <a:lnTo>
                      <a:pt x="169" y="262"/>
                    </a:lnTo>
                    <a:lnTo>
                      <a:pt x="191" y="262"/>
                    </a:lnTo>
                    <a:lnTo>
                      <a:pt x="191" y="274"/>
                    </a:lnTo>
                    <a:lnTo>
                      <a:pt x="195" y="274"/>
                    </a:lnTo>
                    <a:lnTo>
                      <a:pt x="195" y="274"/>
                    </a:lnTo>
                  </a:path>
                </a:pathLst>
              </a:custGeom>
              <a:noFill/>
              <a:ln w="15875" cap="flat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0" name="Freeform 454">
                <a:extLst>
                  <a:ext uri="{FF2B5EF4-FFF2-40B4-BE49-F238E27FC236}">
                    <a16:creationId xmlns:a16="http://schemas.microsoft.com/office/drawing/2014/main" id="{DD1E0E2B-7DEE-4B0A-AB58-8A17C8A0258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21269" y="1220390"/>
                <a:ext cx="1774334" cy="2036763"/>
              </a:xfrm>
              <a:custGeom>
                <a:avLst/>
                <a:gdLst>
                  <a:gd name="T0" fmla="*/ 0 w 239"/>
                  <a:gd name="T1" fmla="*/ 0 h 254"/>
                  <a:gd name="T2" fmla="*/ 5 w 239"/>
                  <a:gd name="T3" fmla="*/ 0 h 254"/>
                  <a:gd name="T4" fmla="*/ 5 w 239"/>
                  <a:gd name="T5" fmla="*/ 24 h 254"/>
                  <a:gd name="T6" fmla="*/ 7 w 239"/>
                  <a:gd name="T7" fmla="*/ 24 h 254"/>
                  <a:gd name="T8" fmla="*/ 7 w 239"/>
                  <a:gd name="T9" fmla="*/ 47 h 254"/>
                  <a:gd name="T10" fmla="*/ 10 w 239"/>
                  <a:gd name="T11" fmla="*/ 47 h 254"/>
                  <a:gd name="T12" fmla="*/ 10 w 239"/>
                  <a:gd name="T13" fmla="*/ 71 h 254"/>
                  <a:gd name="T14" fmla="*/ 27 w 239"/>
                  <a:gd name="T15" fmla="*/ 71 h 254"/>
                  <a:gd name="T16" fmla="*/ 27 w 239"/>
                  <a:gd name="T17" fmla="*/ 95 h 254"/>
                  <a:gd name="T18" fmla="*/ 36 w 239"/>
                  <a:gd name="T19" fmla="*/ 95 h 254"/>
                  <a:gd name="T20" fmla="*/ 36 w 239"/>
                  <a:gd name="T21" fmla="*/ 119 h 254"/>
                  <a:gd name="T22" fmla="*/ 42 w 239"/>
                  <a:gd name="T23" fmla="*/ 119 h 254"/>
                  <a:gd name="T24" fmla="*/ 42 w 239"/>
                  <a:gd name="T25" fmla="*/ 143 h 254"/>
                  <a:gd name="T26" fmla="*/ 49 w 239"/>
                  <a:gd name="T27" fmla="*/ 143 h 254"/>
                  <a:gd name="T28" fmla="*/ 49 w 239"/>
                  <a:gd name="T29" fmla="*/ 167 h 254"/>
                  <a:gd name="T30" fmla="*/ 53 w 239"/>
                  <a:gd name="T31" fmla="*/ 167 h 254"/>
                  <a:gd name="T32" fmla="*/ 53 w 239"/>
                  <a:gd name="T33" fmla="*/ 190 h 254"/>
                  <a:gd name="T34" fmla="*/ 60 w 239"/>
                  <a:gd name="T35" fmla="*/ 190 h 254"/>
                  <a:gd name="T36" fmla="*/ 60 w 239"/>
                  <a:gd name="T37" fmla="*/ 190 h 254"/>
                  <a:gd name="T38" fmla="*/ 74 w 239"/>
                  <a:gd name="T39" fmla="*/ 190 h 254"/>
                  <a:gd name="T40" fmla="*/ 74 w 239"/>
                  <a:gd name="T41" fmla="*/ 222 h 254"/>
                  <a:gd name="T42" fmla="*/ 81 w 239"/>
                  <a:gd name="T43" fmla="*/ 222 h 254"/>
                  <a:gd name="T44" fmla="*/ 81 w 239"/>
                  <a:gd name="T45" fmla="*/ 254 h 254"/>
                  <a:gd name="T46" fmla="*/ 239 w 239"/>
                  <a:gd name="T47" fmla="*/ 254 h 254"/>
                  <a:gd name="T48" fmla="*/ 239 w 239"/>
                  <a:gd name="T49" fmla="*/ 254 h 2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239" h="254">
                    <a:moveTo>
                      <a:pt x="0" y="0"/>
                    </a:moveTo>
                    <a:lnTo>
                      <a:pt x="5" y="0"/>
                    </a:lnTo>
                    <a:lnTo>
                      <a:pt x="5" y="24"/>
                    </a:lnTo>
                    <a:lnTo>
                      <a:pt x="7" y="24"/>
                    </a:lnTo>
                    <a:lnTo>
                      <a:pt x="7" y="47"/>
                    </a:lnTo>
                    <a:lnTo>
                      <a:pt x="10" y="47"/>
                    </a:lnTo>
                    <a:lnTo>
                      <a:pt x="10" y="71"/>
                    </a:lnTo>
                    <a:lnTo>
                      <a:pt x="27" y="71"/>
                    </a:lnTo>
                    <a:lnTo>
                      <a:pt x="27" y="95"/>
                    </a:lnTo>
                    <a:lnTo>
                      <a:pt x="36" y="95"/>
                    </a:lnTo>
                    <a:lnTo>
                      <a:pt x="36" y="119"/>
                    </a:lnTo>
                    <a:lnTo>
                      <a:pt x="42" y="119"/>
                    </a:lnTo>
                    <a:lnTo>
                      <a:pt x="42" y="143"/>
                    </a:lnTo>
                    <a:lnTo>
                      <a:pt x="49" y="143"/>
                    </a:lnTo>
                    <a:lnTo>
                      <a:pt x="49" y="167"/>
                    </a:lnTo>
                    <a:lnTo>
                      <a:pt x="53" y="167"/>
                    </a:lnTo>
                    <a:lnTo>
                      <a:pt x="53" y="190"/>
                    </a:lnTo>
                    <a:lnTo>
                      <a:pt x="60" y="190"/>
                    </a:lnTo>
                    <a:lnTo>
                      <a:pt x="60" y="190"/>
                    </a:lnTo>
                    <a:lnTo>
                      <a:pt x="74" y="190"/>
                    </a:lnTo>
                    <a:lnTo>
                      <a:pt x="74" y="222"/>
                    </a:lnTo>
                    <a:lnTo>
                      <a:pt x="81" y="222"/>
                    </a:lnTo>
                    <a:lnTo>
                      <a:pt x="81" y="254"/>
                    </a:lnTo>
                    <a:lnTo>
                      <a:pt x="239" y="254"/>
                    </a:lnTo>
                    <a:lnTo>
                      <a:pt x="239" y="254"/>
                    </a:lnTo>
                  </a:path>
                </a:pathLst>
              </a:custGeom>
              <a:noFill/>
              <a:ln w="15875" cap="flat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1" name="Freeform 455">
                <a:extLst>
                  <a:ext uri="{FF2B5EF4-FFF2-40B4-BE49-F238E27FC236}">
                    <a16:creationId xmlns:a16="http://schemas.microsoft.com/office/drawing/2014/main" id="{E3E8B822-6A2E-4D30-9F8A-AF0F0BD4116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21269" y="1220390"/>
                <a:ext cx="1878534" cy="2293938"/>
              </a:xfrm>
              <a:custGeom>
                <a:avLst/>
                <a:gdLst>
                  <a:gd name="T0" fmla="*/ 0 w 253"/>
                  <a:gd name="T1" fmla="*/ 0 h 286"/>
                  <a:gd name="T2" fmla="*/ 27 w 253"/>
                  <a:gd name="T3" fmla="*/ 0 h 286"/>
                  <a:gd name="T4" fmla="*/ 27 w 253"/>
                  <a:gd name="T5" fmla="*/ 57 h 286"/>
                  <a:gd name="T6" fmla="*/ 50 w 253"/>
                  <a:gd name="T7" fmla="*/ 57 h 286"/>
                  <a:gd name="T8" fmla="*/ 50 w 253"/>
                  <a:gd name="T9" fmla="*/ 114 h 286"/>
                  <a:gd name="T10" fmla="*/ 94 w 253"/>
                  <a:gd name="T11" fmla="*/ 114 h 286"/>
                  <a:gd name="T12" fmla="*/ 94 w 253"/>
                  <a:gd name="T13" fmla="*/ 171 h 286"/>
                  <a:gd name="T14" fmla="*/ 209 w 253"/>
                  <a:gd name="T15" fmla="*/ 171 h 286"/>
                  <a:gd name="T16" fmla="*/ 209 w 253"/>
                  <a:gd name="T17" fmla="*/ 171 h 286"/>
                  <a:gd name="T18" fmla="*/ 253 w 253"/>
                  <a:gd name="T19" fmla="*/ 171 h 286"/>
                  <a:gd name="T20" fmla="*/ 253 w 253"/>
                  <a:gd name="T21" fmla="*/ 286 h 2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253" h="286">
                    <a:moveTo>
                      <a:pt x="0" y="0"/>
                    </a:moveTo>
                    <a:lnTo>
                      <a:pt x="27" y="0"/>
                    </a:lnTo>
                    <a:lnTo>
                      <a:pt x="27" y="57"/>
                    </a:lnTo>
                    <a:lnTo>
                      <a:pt x="50" y="57"/>
                    </a:lnTo>
                    <a:lnTo>
                      <a:pt x="50" y="114"/>
                    </a:lnTo>
                    <a:lnTo>
                      <a:pt x="94" y="114"/>
                    </a:lnTo>
                    <a:lnTo>
                      <a:pt x="94" y="171"/>
                    </a:lnTo>
                    <a:lnTo>
                      <a:pt x="209" y="171"/>
                    </a:lnTo>
                    <a:lnTo>
                      <a:pt x="209" y="171"/>
                    </a:lnTo>
                    <a:lnTo>
                      <a:pt x="253" y="171"/>
                    </a:lnTo>
                    <a:lnTo>
                      <a:pt x="253" y="286"/>
                    </a:lnTo>
                  </a:path>
                </a:pathLst>
              </a:custGeom>
              <a:noFill/>
              <a:ln w="15875" cap="flat">
                <a:solidFill>
                  <a:srgbClr val="A020F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2" name="Freeform 456">
                <a:extLst>
                  <a:ext uri="{FF2B5EF4-FFF2-40B4-BE49-F238E27FC236}">
                    <a16:creationId xmlns:a16="http://schemas.microsoft.com/office/drawing/2014/main" id="{5C55DEC9-8FCE-48D0-9129-EE78D55D41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21269" y="1220390"/>
                <a:ext cx="2694522" cy="0"/>
              </a:xfrm>
              <a:custGeom>
                <a:avLst/>
                <a:gdLst>
                  <a:gd name="T0" fmla="*/ 0 w 363"/>
                  <a:gd name="T1" fmla="*/ 109 w 363"/>
                  <a:gd name="T2" fmla="*/ 109 w 363"/>
                  <a:gd name="T3" fmla="*/ 120 w 363"/>
                  <a:gd name="T4" fmla="*/ 120 w 363"/>
                  <a:gd name="T5" fmla="*/ 133 w 363"/>
                  <a:gd name="T6" fmla="*/ 133 w 363"/>
                  <a:gd name="T7" fmla="*/ 165 w 363"/>
                  <a:gd name="T8" fmla="*/ 165 w 363"/>
                  <a:gd name="T9" fmla="*/ 176 w 363"/>
                  <a:gd name="T10" fmla="*/ 176 w 363"/>
                  <a:gd name="T11" fmla="*/ 205 w 363"/>
                  <a:gd name="T12" fmla="*/ 205 w 363"/>
                  <a:gd name="T13" fmla="*/ 231 w 363"/>
                  <a:gd name="T14" fmla="*/ 231 w 363"/>
                  <a:gd name="T15" fmla="*/ 280 w 363"/>
                  <a:gd name="T16" fmla="*/ 280 w 363"/>
                  <a:gd name="T17" fmla="*/ 292 w 363"/>
                  <a:gd name="T18" fmla="*/ 292 w 363"/>
                  <a:gd name="T19" fmla="*/ 297 w 363"/>
                  <a:gd name="T20" fmla="*/ 297 w 363"/>
                  <a:gd name="T21" fmla="*/ 316 w 363"/>
                  <a:gd name="T22" fmla="*/ 316 w 363"/>
                  <a:gd name="T23" fmla="*/ 363 w 363"/>
                  <a:gd name="T24" fmla="*/ 363 w 36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</a:cxnLst>
                <a:rect l="0" t="0" r="r" b="b"/>
                <a:pathLst>
                  <a:path w="363">
                    <a:moveTo>
                      <a:pt x="0" y="0"/>
                    </a:moveTo>
                    <a:lnTo>
                      <a:pt x="109" y="0"/>
                    </a:lnTo>
                    <a:lnTo>
                      <a:pt x="109" y="0"/>
                    </a:lnTo>
                    <a:lnTo>
                      <a:pt x="120" y="0"/>
                    </a:lnTo>
                    <a:lnTo>
                      <a:pt x="120" y="0"/>
                    </a:lnTo>
                    <a:lnTo>
                      <a:pt x="133" y="0"/>
                    </a:lnTo>
                    <a:lnTo>
                      <a:pt x="133" y="0"/>
                    </a:lnTo>
                    <a:lnTo>
                      <a:pt x="165" y="0"/>
                    </a:lnTo>
                    <a:lnTo>
                      <a:pt x="165" y="0"/>
                    </a:lnTo>
                    <a:lnTo>
                      <a:pt x="176" y="0"/>
                    </a:lnTo>
                    <a:lnTo>
                      <a:pt x="176" y="0"/>
                    </a:lnTo>
                    <a:lnTo>
                      <a:pt x="205" y="0"/>
                    </a:lnTo>
                    <a:lnTo>
                      <a:pt x="205" y="0"/>
                    </a:lnTo>
                    <a:lnTo>
                      <a:pt x="231" y="0"/>
                    </a:lnTo>
                    <a:lnTo>
                      <a:pt x="231" y="0"/>
                    </a:lnTo>
                    <a:lnTo>
                      <a:pt x="280" y="0"/>
                    </a:lnTo>
                    <a:lnTo>
                      <a:pt x="280" y="0"/>
                    </a:lnTo>
                    <a:lnTo>
                      <a:pt x="292" y="0"/>
                    </a:lnTo>
                    <a:lnTo>
                      <a:pt x="292" y="0"/>
                    </a:lnTo>
                    <a:lnTo>
                      <a:pt x="297" y="0"/>
                    </a:lnTo>
                    <a:lnTo>
                      <a:pt x="297" y="0"/>
                    </a:lnTo>
                    <a:lnTo>
                      <a:pt x="316" y="0"/>
                    </a:lnTo>
                    <a:lnTo>
                      <a:pt x="316" y="0"/>
                    </a:lnTo>
                    <a:lnTo>
                      <a:pt x="363" y="0"/>
                    </a:lnTo>
                    <a:lnTo>
                      <a:pt x="363" y="0"/>
                    </a:lnTo>
                  </a:path>
                </a:pathLst>
              </a:custGeom>
              <a:noFill/>
              <a:ln w="15875" cap="flat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3" name="Rectangle 457">
                <a:extLst>
                  <a:ext uri="{FF2B5EF4-FFF2-40B4-BE49-F238E27FC236}">
                    <a16:creationId xmlns:a16="http://schemas.microsoft.com/office/drawing/2014/main" id="{A5C5D538-D8C7-41F1-818D-7E2F83891F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84376" y="118864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4" name="Rectangle 458">
                <a:extLst>
                  <a:ext uri="{FF2B5EF4-FFF2-40B4-BE49-F238E27FC236}">
                    <a16:creationId xmlns:a16="http://schemas.microsoft.com/office/drawing/2014/main" id="{7F175EF5-5525-4517-99B0-B199AF5ED7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99052" y="118864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5" name="Rectangle 459">
                <a:extLst>
                  <a:ext uri="{FF2B5EF4-FFF2-40B4-BE49-F238E27FC236}">
                    <a16:creationId xmlns:a16="http://schemas.microsoft.com/office/drawing/2014/main" id="{F46A84B4-9601-4692-A273-08F53F6CF2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36804" y="13807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6" name="Rectangle 460">
                <a:extLst>
                  <a:ext uri="{FF2B5EF4-FFF2-40B4-BE49-F238E27FC236}">
                    <a16:creationId xmlns:a16="http://schemas.microsoft.com/office/drawing/2014/main" id="{BB0923D8-0261-4649-9034-B220E98D62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36804" y="13807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7" name="Rectangle 461">
                <a:extLst>
                  <a:ext uri="{FF2B5EF4-FFF2-40B4-BE49-F238E27FC236}">
                    <a16:creationId xmlns:a16="http://schemas.microsoft.com/office/drawing/2014/main" id="{080477B8-C532-4AFD-932D-E8846AE602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39177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8" name="Rectangle 462">
                <a:extLst>
                  <a:ext uri="{FF2B5EF4-FFF2-40B4-BE49-F238E27FC236}">
                    <a16:creationId xmlns:a16="http://schemas.microsoft.com/office/drawing/2014/main" id="{72144360-FD01-4FBA-8324-6C5DE5E84B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97882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79" name="Rectangle 463">
                <a:extLst>
                  <a:ext uri="{FF2B5EF4-FFF2-40B4-BE49-F238E27FC236}">
                    <a16:creationId xmlns:a16="http://schemas.microsoft.com/office/drawing/2014/main" id="{89F129B4-FD38-4FDF-9BF7-6AD278CD6D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05220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0" name="Rectangle 464">
                <a:extLst>
                  <a:ext uri="{FF2B5EF4-FFF2-40B4-BE49-F238E27FC236}">
                    <a16:creationId xmlns:a16="http://schemas.microsoft.com/office/drawing/2014/main" id="{1E5487A8-0AB5-4899-81E3-A82ACB0403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05220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1" name="Rectangle 465">
                <a:extLst>
                  <a:ext uri="{FF2B5EF4-FFF2-40B4-BE49-F238E27FC236}">
                    <a16:creationId xmlns:a16="http://schemas.microsoft.com/office/drawing/2014/main" id="{634797F5-705E-4735-B244-C326B29A5D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989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2" name="Rectangle 466">
                <a:extLst>
                  <a:ext uri="{FF2B5EF4-FFF2-40B4-BE49-F238E27FC236}">
                    <a16:creationId xmlns:a16="http://schemas.microsoft.com/office/drawing/2014/main" id="{CCC5508A-F72E-476C-A83E-940F793EDB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1989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3" name="Rectangle 467">
                <a:extLst>
                  <a:ext uri="{FF2B5EF4-FFF2-40B4-BE49-F238E27FC236}">
                    <a16:creationId xmlns:a16="http://schemas.microsoft.com/office/drawing/2014/main" id="{5E8E5415-7421-4C1E-9384-4E6E1ADE3E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36039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4" name="Rectangle 468">
                <a:extLst>
                  <a:ext uri="{FF2B5EF4-FFF2-40B4-BE49-F238E27FC236}">
                    <a16:creationId xmlns:a16="http://schemas.microsoft.com/office/drawing/2014/main" id="{AA53CD5B-4712-4475-819F-ACB7FECC28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50715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5" name="Rectangle 469">
                <a:extLst>
                  <a:ext uri="{FF2B5EF4-FFF2-40B4-BE49-F238E27FC236}">
                    <a16:creationId xmlns:a16="http://schemas.microsoft.com/office/drawing/2014/main" id="{1B9F7EC4-04F3-4930-B022-0F82F54CAA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8740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6" name="Rectangle 470">
                <a:extLst>
                  <a:ext uri="{FF2B5EF4-FFF2-40B4-BE49-F238E27FC236}">
                    <a16:creationId xmlns:a16="http://schemas.microsoft.com/office/drawing/2014/main" id="{ADBAD6AE-4A0A-4A18-B2E1-AB5CB2790E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94744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7" name="Rectangle 471">
                <a:extLst>
                  <a:ext uri="{FF2B5EF4-FFF2-40B4-BE49-F238E27FC236}">
                    <a16:creationId xmlns:a16="http://schemas.microsoft.com/office/drawing/2014/main" id="{02D5423F-0181-49D9-8952-A56E0B5EDD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46110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8" name="Rectangle 472">
                <a:extLst>
                  <a:ext uri="{FF2B5EF4-FFF2-40B4-BE49-F238E27FC236}">
                    <a16:creationId xmlns:a16="http://schemas.microsoft.com/office/drawing/2014/main" id="{EA9C4F38-B65D-4B99-B75D-516F4A41DE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5491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9" name="Rectangle 473">
                <a:extLst>
                  <a:ext uri="{FF2B5EF4-FFF2-40B4-BE49-F238E27FC236}">
                    <a16:creationId xmlns:a16="http://schemas.microsoft.com/office/drawing/2014/main" id="{4D96810A-B315-4047-B01E-3DE59B7710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84268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0" name="Rectangle 474">
                <a:extLst>
                  <a:ext uri="{FF2B5EF4-FFF2-40B4-BE49-F238E27FC236}">
                    <a16:creationId xmlns:a16="http://schemas.microsoft.com/office/drawing/2014/main" id="{89FCC7AD-3C4F-4E44-95F5-D0AC74291F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2829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1" name="Rectangle 475">
                <a:extLst>
                  <a:ext uri="{FF2B5EF4-FFF2-40B4-BE49-F238E27FC236}">
                    <a16:creationId xmlns:a16="http://schemas.microsoft.com/office/drawing/2014/main" id="{07D105BD-28E9-4427-A131-D7AFA1A67B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2829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2" name="Rectangle 476">
                <a:extLst>
                  <a:ext uri="{FF2B5EF4-FFF2-40B4-BE49-F238E27FC236}">
                    <a16:creationId xmlns:a16="http://schemas.microsoft.com/office/drawing/2014/main" id="{AE5AA1A2-57B4-41BF-9535-6B1397F991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39834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3" name="Rectangle 477">
                <a:extLst>
                  <a:ext uri="{FF2B5EF4-FFF2-40B4-BE49-F238E27FC236}">
                    <a16:creationId xmlns:a16="http://schemas.microsoft.com/office/drawing/2014/main" id="{6BEEF89E-66EE-45D3-8498-8A527D541F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6918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4" name="Rectangle 478">
                <a:extLst>
                  <a:ext uri="{FF2B5EF4-FFF2-40B4-BE49-F238E27FC236}">
                    <a16:creationId xmlns:a16="http://schemas.microsoft.com/office/drawing/2014/main" id="{8CA4D42E-8133-4308-B933-457CE867C0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91200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5" name="Rectangle 479">
                <a:extLst>
                  <a:ext uri="{FF2B5EF4-FFF2-40B4-BE49-F238E27FC236}">
                    <a16:creationId xmlns:a16="http://schemas.microsoft.com/office/drawing/2014/main" id="{4F8E2BC9-CE27-4E85-A363-5BCD1300CF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258709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6" name="Rectangle 480">
                <a:extLst>
                  <a:ext uri="{FF2B5EF4-FFF2-40B4-BE49-F238E27FC236}">
                    <a16:creationId xmlns:a16="http://schemas.microsoft.com/office/drawing/2014/main" id="{C6D96958-71D7-4A19-AD47-06760C999E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84923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7" name="Rectangle 481">
                <a:extLst>
                  <a:ext uri="{FF2B5EF4-FFF2-40B4-BE49-F238E27FC236}">
                    <a16:creationId xmlns:a16="http://schemas.microsoft.com/office/drawing/2014/main" id="{C9F80464-BAA7-4C0C-ACD0-97316338F9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28952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8" name="Rectangle 482">
                <a:extLst>
                  <a:ext uri="{FF2B5EF4-FFF2-40B4-BE49-F238E27FC236}">
                    <a16:creationId xmlns:a16="http://schemas.microsoft.com/office/drawing/2014/main" id="{A40A0B43-76C0-44CE-A336-60640EA377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72980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99" name="Rectangle 483">
                <a:extLst>
                  <a:ext uri="{FF2B5EF4-FFF2-40B4-BE49-F238E27FC236}">
                    <a16:creationId xmlns:a16="http://schemas.microsoft.com/office/drawing/2014/main" id="{C8D74E57-505E-4AA8-A160-61474BBF87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72980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0" name="Rectangle 484">
                <a:extLst>
                  <a:ext uri="{FF2B5EF4-FFF2-40B4-BE49-F238E27FC236}">
                    <a16:creationId xmlns:a16="http://schemas.microsoft.com/office/drawing/2014/main" id="{0DFF7A79-8774-42E1-97FF-ADDDE9D260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1847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1" name="Rectangle 485">
                <a:extLst>
                  <a:ext uri="{FF2B5EF4-FFF2-40B4-BE49-F238E27FC236}">
                    <a16:creationId xmlns:a16="http://schemas.microsoft.com/office/drawing/2014/main" id="{CF23D292-EA3A-464B-956A-6FEDEBCB92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91856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2" name="Rectangle 486">
                <a:extLst>
                  <a:ext uri="{FF2B5EF4-FFF2-40B4-BE49-F238E27FC236}">
                    <a16:creationId xmlns:a16="http://schemas.microsoft.com/office/drawing/2014/main" id="{47AA2159-ED21-4714-A017-08996707D5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37351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3" name="Rectangle 487">
                <a:extLst>
                  <a:ext uri="{FF2B5EF4-FFF2-40B4-BE49-F238E27FC236}">
                    <a16:creationId xmlns:a16="http://schemas.microsoft.com/office/drawing/2014/main" id="{941A35FE-5AEA-4296-A944-8B4BC05CFB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710732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4" name="Rectangle 488">
                <a:extLst>
                  <a:ext uri="{FF2B5EF4-FFF2-40B4-BE49-F238E27FC236}">
                    <a16:creationId xmlns:a16="http://schemas.microsoft.com/office/drawing/2014/main" id="{3542850A-AF8F-4A3C-B5DE-CEFF1DF4F8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22269" y="1927780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5" name="Rectangle 489">
                <a:extLst>
                  <a:ext uri="{FF2B5EF4-FFF2-40B4-BE49-F238E27FC236}">
                    <a16:creationId xmlns:a16="http://schemas.microsoft.com/office/drawing/2014/main" id="{0DAB1147-3534-4BB0-BC0F-E42DCFD0EC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25266" y="1733152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6" name="Rectangle 490">
                <a:extLst>
                  <a:ext uri="{FF2B5EF4-FFF2-40B4-BE49-F238E27FC236}">
                    <a16:creationId xmlns:a16="http://schemas.microsoft.com/office/drawing/2014/main" id="{2BFB8928-AAFC-4076-A188-959699E699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14063" y="2167175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7" name="Rectangle 491">
                <a:extLst>
                  <a:ext uri="{FF2B5EF4-FFF2-40B4-BE49-F238E27FC236}">
                    <a16:creationId xmlns:a16="http://schemas.microsoft.com/office/drawing/2014/main" id="{B4FD1F6D-2BEE-4733-9ADE-6C82E38DAA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97882" y="3322875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8" name="Rectangle 492">
                <a:extLst>
                  <a:ext uri="{FF2B5EF4-FFF2-40B4-BE49-F238E27FC236}">
                    <a16:creationId xmlns:a16="http://schemas.microsoft.com/office/drawing/2014/main" id="{E1868B05-7F31-497D-A9AE-7FEE475D15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96976" y="2652315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>
                    <a:ln>
                      <a:noFill/>
                    </a:ln>
                    <a:solidFill>
                      <a:srgbClr val="FFA5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09" name="Rectangle 493">
                <a:extLst>
                  <a:ext uri="{FF2B5EF4-FFF2-40B4-BE49-F238E27FC236}">
                    <a16:creationId xmlns:a16="http://schemas.microsoft.com/office/drawing/2014/main" id="{CDD42EC7-CA18-4825-8005-233A6F038D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25158" y="3185715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FFA5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0" name="Rectangle 494">
                <a:extLst>
                  <a:ext uri="{FF2B5EF4-FFF2-40B4-BE49-F238E27FC236}">
                    <a16:creationId xmlns:a16="http://schemas.microsoft.com/office/drawing/2014/main" id="{A11588C4-AAD1-45F5-8D5B-2ADCFFE428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02082" y="2496105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>
                    <a:ln>
                      <a:noFill/>
                    </a:ln>
                    <a:solidFill>
                      <a:srgbClr val="A020F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1" name="Rectangle 495">
                <a:extLst>
                  <a:ext uri="{FF2B5EF4-FFF2-40B4-BE49-F238E27FC236}">
                    <a16:creationId xmlns:a16="http://schemas.microsoft.com/office/drawing/2014/main" id="{73612C11-B283-4C99-ADE0-17B41EF12A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59474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2" name="Rectangle 496">
                <a:extLst>
                  <a:ext uri="{FF2B5EF4-FFF2-40B4-BE49-F238E27FC236}">
                    <a16:creationId xmlns:a16="http://schemas.microsoft.com/office/drawing/2014/main" id="{17DF3348-798E-4009-B744-336D2E4C93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41660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3" name="Rectangle 497">
                <a:extLst>
                  <a:ext uri="{FF2B5EF4-FFF2-40B4-BE49-F238E27FC236}">
                    <a16:creationId xmlns:a16="http://schemas.microsoft.com/office/drawing/2014/main" id="{2CEECE37-E0EA-4531-AFCF-F24BA5B52C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38522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4" name="Rectangle 498">
                <a:extLst>
                  <a:ext uri="{FF2B5EF4-FFF2-40B4-BE49-F238E27FC236}">
                    <a16:creationId xmlns:a16="http://schemas.microsoft.com/office/drawing/2014/main" id="{0AAC609A-E008-49DB-B795-C26A7D6BB0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76274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5" name="Rectangle 499">
                <a:extLst>
                  <a:ext uri="{FF2B5EF4-FFF2-40B4-BE49-F238E27FC236}">
                    <a16:creationId xmlns:a16="http://schemas.microsoft.com/office/drawing/2014/main" id="{EE426328-2DF6-4087-8718-1EB23EB8A2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56992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6" name="Rectangle 500">
                <a:extLst>
                  <a:ext uri="{FF2B5EF4-FFF2-40B4-BE49-F238E27FC236}">
                    <a16:creationId xmlns:a16="http://schemas.microsoft.com/office/drawing/2014/main" id="{96F43A06-C1CA-4939-BB84-AC5A520A3F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72730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7" name="Rectangle 501">
                <a:extLst>
                  <a:ext uri="{FF2B5EF4-FFF2-40B4-BE49-F238E27FC236}">
                    <a16:creationId xmlns:a16="http://schemas.microsoft.com/office/drawing/2014/main" id="{D0CE2EEE-BE5E-450B-AA49-7E34D2CA7E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64986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8" name="Rectangle 502">
                <a:extLst>
                  <a:ext uri="{FF2B5EF4-FFF2-40B4-BE49-F238E27FC236}">
                    <a16:creationId xmlns:a16="http://schemas.microsoft.com/office/drawing/2014/main" id="{4A8935FF-674C-431C-8F9D-C1F5BBB631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28952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19" name="Rectangle 503">
                <a:extLst>
                  <a:ext uri="{FF2B5EF4-FFF2-40B4-BE49-F238E27FC236}">
                    <a16:creationId xmlns:a16="http://schemas.microsoft.com/office/drawing/2014/main" id="{39943F6F-914D-4E41-BB29-3F7F30BCD5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18476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0" name="Rectangle 504">
                <a:extLst>
                  <a:ext uri="{FF2B5EF4-FFF2-40B4-BE49-F238E27FC236}">
                    <a16:creationId xmlns:a16="http://schemas.microsoft.com/office/drawing/2014/main" id="{300BF730-01F2-47A2-A0F6-D9EC1D5D5E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55165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1" name="Rectangle 505">
                <a:extLst>
                  <a:ext uri="{FF2B5EF4-FFF2-40B4-BE49-F238E27FC236}">
                    <a16:creationId xmlns:a16="http://schemas.microsoft.com/office/drawing/2014/main" id="{1B5B604A-A807-4C59-970C-BEC30DF0E0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96055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2" name="Rectangle 506">
                <a:extLst>
                  <a:ext uri="{FF2B5EF4-FFF2-40B4-BE49-F238E27FC236}">
                    <a16:creationId xmlns:a16="http://schemas.microsoft.com/office/drawing/2014/main" id="{D55417C6-FA2D-4A27-828A-C40B2172E1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45345" y="1139427"/>
                <a:ext cx="140890" cy="2000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>
                    <a:ln>
                      <a:noFill/>
                    </a:ln>
                    <a:solidFill>
                      <a:srgbClr val="00FF00"/>
                    </a:solidFill>
                    <a:effectLst/>
                    <a:latin typeface="Arial" panose="020B0604020202020204" pitchFamily="34" charset="0"/>
                  </a:rPr>
                  <a:t>+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3" name="Rectangle 507">
                <a:extLst>
                  <a:ext uri="{FF2B5EF4-FFF2-40B4-BE49-F238E27FC236}">
                    <a16:creationId xmlns:a16="http://schemas.microsoft.com/office/drawing/2014/main" id="{EAFBCC52-F9A3-496F-8117-69DF352A82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48622" y="3408553"/>
                <a:ext cx="55869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 &lt; 0.0001</a:t>
                </a:r>
                <a:endParaRPr kumimoji="0" lang="fr-FR" altLang="fr-FR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4" name="Line 508">
                <a:extLst>
                  <a:ext uri="{FF2B5EF4-FFF2-40B4-BE49-F238E27FC236}">
                    <a16:creationId xmlns:a16="http://schemas.microsoft.com/office/drawing/2014/main" id="{6C11089E-D303-479B-AE83-73B7E015C3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280379" y="1099740"/>
                <a:ext cx="0" cy="252730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5" name="Rectangle 509">
                <a:extLst>
                  <a:ext uri="{FF2B5EF4-FFF2-40B4-BE49-F238E27FC236}">
                    <a16:creationId xmlns:a16="http://schemas.microsoft.com/office/drawing/2014/main" id="{BC14553C-E53B-441C-9DA8-2E2C0A8DA1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17881" y="3457177"/>
                <a:ext cx="303795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6" name="Rectangle 510">
                <a:extLst>
                  <a:ext uri="{FF2B5EF4-FFF2-40B4-BE49-F238E27FC236}">
                    <a16:creationId xmlns:a16="http://schemas.microsoft.com/office/drawing/2014/main" id="{ECD8AC1C-D7CB-4631-86C0-795CAFF60D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17881" y="2888852"/>
                <a:ext cx="303795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25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7" name="Rectangle 511">
                <a:extLst>
                  <a:ext uri="{FF2B5EF4-FFF2-40B4-BE49-F238E27FC236}">
                    <a16:creationId xmlns:a16="http://schemas.microsoft.com/office/drawing/2014/main" id="{4E7A6842-A4AE-4BC6-A0A2-7EA7478B12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17881" y="2311002"/>
                <a:ext cx="303795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5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8" name="Rectangle 512">
                <a:extLst>
                  <a:ext uri="{FF2B5EF4-FFF2-40B4-BE49-F238E27FC236}">
                    <a16:creationId xmlns:a16="http://schemas.microsoft.com/office/drawing/2014/main" id="{DC248023-CD32-400B-A10D-88F5F6EEC6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17881" y="1741090"/>
                <a:ext cx="303795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75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29" name="Rectangle 513">
                <a:extLst>
                  <a:ext uri="{FF2B5EF4-FFF2-40B4-BE49-F238E27FC236}">
                    <a16:creationId xmlns:a16="http://schemas.microsoft.com/office/drawing/2014/main" id="{76E3385B-8F6E-453D-9B90-C81DD34D38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17881" y="1163240"/>
                <a:ext cx="303795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.0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30" name="Line 514">
                <a:extLst>
                  <a:ext uri="{FF2B5EF4-FFF2-40B4-BE49-F238E27FC236}">
                    <a16:creationId xmlns:a16="http://schemas.microsoft.com/office/drawing/2014/main" id="{E6F45811-6426-4AC2-BC1F-34E76E99F6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51027" y="3514327"/>
                <a:ext cx="2935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1" name="Line 515">
                <a:extLst>
                  <a:ext uri="{FF2B5EF4-FFF2-40B4-BE49-F238E27FC236}">
                    <a16:creationId xmlns:a16="http://schemas.microsoft.com/office/drawing/2014/main" id="{7DAA1790-A680-4216-8AC6-FD5E9DF407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51027" y="2936477"/>
                <a:ext cx="2935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2" name="Line 516">
                <a:extLst>
                  <a:ext uri="{FF2B5EF4-FFF2-40B4-BE49-F238E27FC236}">
                    <a16:creationId xmlns:a16="http://schemas.microsoft.com/office/drawing/2014/main" id="{BD633F49-E9E1-4B0B-A456-99FE522344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51027" y="2368152"/>
                <a:ext cx="2935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3" name="Line 517">
                <a:extLst>
                  <a:ext uri="{FF2B5EF4-FFF2-40B4-BE49-F238E27FC236}">
                    <a16:creationId xmlns:a16="http://schemas.microsoft.com/office/drawing/2014/main" id="{E1CB4534-68F3-4DDB-BF49-1DF5794734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51027" y="1790302"/>
                <a:ext cx="2935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4" name="Line 518">
                <a:extLst>
                  <a:ext uri="{FF2B5EF4-FFF2-40B4-BE49-F238E27FC236}">
                    <a16:creationId xmlns:a16="http://schemas.microsoft.com/office/drawing/2014/main" id="{B56B088E-9076-4026-83B2-53BC78C0AB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51027" y="1220390"/>
                <a:ext cx="29352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5" name="Line 519">
                <a:extLst>
                  <a:ext uri="{FF2B5EF4-FFF2-40B4-BE49-F238E27FC236}">
                    <a16:creationId xmlns:a16="http://schemas.microsoft.com/office/drawing/2014/main" id="{913A5C24-8FE9-4D07-86E0-B688FF95D6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80379" y="3627040"/>
                <a:ext cx="3183234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6" name="Line 520">
                <a:extLst>
                  <a:ext uri="{FF2B5EF4-FFF2-40B4-BE49-F238E27FC236}">
                    <a16:creationId xmlns:a16="http://schemas.microsoft.com/office/drawing/2014/main" id="{53DC5FF2-EEF3-44D8-8647-8755961CCB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421269" y="3627040"/>
                <a:ext cx="0" cy="3175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7" name="Line 521">
                <a:extLst>
                  <a:ext uri="{FF2B5EF4-FFF2-40B4-BE49-F238E27FC236}">
                    <a16:creationId xmlns:a16="http://schemas.microsoft.com/office/drawing/2014/main" id="{F6535A84-D59F-4C82-823F-D5A2A63D19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149201" y="3627040"/>
                <a:ext cx="0" cy="3175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8" name="Line 522">
                <a:extLst>
                  <a:ext uri="{FF2B5EF4-FFF2-40B4-BE49-F238E27FC236}">
                    <a16:creationId xmlns:a16="http://schemas.microsoft.com/office/drawing/2014/main" id="{7E095BB8-DD49-4280-89CC-93FE593BDB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868327" y="3627040"/>
                <a:ext cx="0" cy="3175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9" name="Line 523">
                <a:extLst>
                  <a:ext uri="{FF2B5EF4-FFF2-40B4-BE49-F238E27FC236}">
                    <a16:creationId xmlns:a16="http://schemas.microsoft.com/office/drawing/2014/main" id="{99D25F44-B617-4D86-928A-2E51F3D391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596258" y="3627040"/>
                <a:ext cx="0" cy="3175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0" name="Line 524">
                <a:extLst>
                  <a:ext uri="{FF2B5EF4-FFF2-40B4-BE49-F238E27FC236}">
                    <a16:creationId xmlns:a16="http://schemas.microsoft.com/office/drawing/2014/main" id="{143F3941-65D1-4673-8EBA-471DC02A93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1315385" y="3627040"/>
                <a:ext cx="0" cy="3175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1" name="Rectangle 525">
                <a:extLst>
                  <a:ext uri="{FF2B5EF4-FFF2-40B4-BE49-F238E27FC236}">
                    <a16:creationId xmlns:a16="http://schemas.microsoft.com/office/drawing/2014/main" id="{024E6FB0-8A0C-41EF-8682-BD4570FE2A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58162" y="3682602"/>
                <a:ext cx="126214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2" name="Rectangle 526">
                <a:extLst>
                  <a:ext uri="{FF2B5EF4-FFF2-40B4-BE49-F238E27FC236}">
                    <a16:creationId xmlns:a16="http://schemas.microsoft.com/office/drawing/2014/main" id="{ACD73AE6-2EFA-46FB-B0E0-879892EF6C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49403" y="3682602"/>
                <a:ext cx="199594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3" name="Rectangle 527">
                <a:extLst>
                  <a:ext uri="{FF2B5EF4-FFF2-40B4-BE49-F238E27FC236}">
                    <a16:creationId xmlns:a16="http://schemas.microsoft.com/office/drawing/2014/main" id="{FE27D1F9-6D42-4949-8BDC-7BF73E33CA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68530" y="3682602"/>
                <a:ext cx="199594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4" name="Rectangle 528">
                <a:extLst>
                  <a:ext uri="{FF2B5EF4-FFF2-40B4-BE49-F238E27FC236}">
                    <a16:creationId xmlns:a16="http://schemas.microsoft.com/office/drawing/2014/main" id="{D08A32C5-1224-4B6A-834F-19411D411E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96461" y="3682602"/>
                <a:ext cx="199594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5" name="Rectangle 529">
                <a:extLst>
                  <a:ext uri="{FF2B5EF4-FFF2-40B4-BE49-F238E27FC236}">
                    <a16:creationId xmlns:a16="http://schemas.microsoft.com/office/drawing/2014/main" id="{604E5317-2B0B-4067-B28B-FB83706D11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81833" y="3682602"/>
                <a:ext cx="267104" cy="1841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0</a:t>
                </a:r>
                <a:endParaRPr kumimoji="0" lang="fr-FR" altLang="fr-FR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grpSp>
            <p:nvGrpSpPr>
              <p:cNvPr id="346" name="Groupe 345">
                <a:extLst>
                  <a:ext uri="{FF2B5EF4-FFF2-40B4-BE49-F238E27FC236}">
                    <a16:creationId xmlns:a16="http://schemas.microsoft.com/office/drawing/2014/main" id="{ECA15FE3-E98F-4447-A87B-9F1E0752737C}"/>
                  </a:ext>
                </a:extLst>
              </p:cNvPr>
              <p:cNvGrpSpPr/>
              <p:nvPr/>
            </p:nvGrpSpPr>
            <p:grpSpPr>
              <a:xfrm>
                <a:off x="7830159" y="3963589"/>
                <a:ext cx="3624971" cy="1207707"/>
                <a:chOff x="8718913" y="3979129"/>
                <a:chExt cx="3921112" cy="979840"/>
              </a:xfrm>
            </p:grpSpPr>
            <p:sp>
              <p:nvSpPr>
                <p:cNvPr id="350" name="Rectangle 548">
                  <a:extLst>
                    <a:ext uri="{FF2B5EF4-FFF2-40B4-BE49-F238E27FC236}">
                      <a16:creationId xmlns:a16="http://schemas.microsoft.com/office/drawing/2014/main" id="{02E7A9AB-B744-4A94-97D9-9DED2F2F78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196737" y="3992833"/>
                  <a:ext cx="3443288" cy="621250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351" name="Rectangle 549">
                  <a:extLst>
                    <a:ext uri="{FF2B5EF4-FFF2-40B4-BE49-F238E27FC236}">
                      <a16:creationId xmlns:a16="http://schemas.microsoft.com/office/drawing/2014/main" id="{DACF7A1A-30EA-4823-A3E2-04F18EBB2F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41187" y="3979129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9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2" name="Rectangle 550">
                  <a:extLst>
                    <a:ext uri="{FF2B5EF4-FFF2-40B4-BE49-F238E27FC236}">
                      <a16:creationId xmlns:a16="http://schemas.microsoft.com/office/drawing/2014/main" id="{A74252BE-2382-4FF2-BFC6-B0CECE08078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28587" y="3979129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6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3" name="Rectangle 551">
                  <a:extLst>
                    <a:ext uri="{FF2B5EF4-FFF2-40B4-BE49-F238E27FC236}">
                      <a16:creationId xmlns:a16="http://schemas.microsoft.com/office/drawing/2014/main" id="{D95180E2-F4A9-44D7-9AB8-3E89246811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06462" y="3979129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6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4" name="Rectangle 552">
                  <a:extLst>
                    <a:ext uri="{FF2B5EF4-FFF2-40B4-BE49-F238E27FC236}">
                      <a16:creationId xmlns:a16="http://schemas.microsoft.com/office/drawing/2014/main" id="{462B075B-C511-4C22-97CC-4E227EDF215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633550" y="3979129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5" name="Rectangle 553">
                  <a:extLst>
                    <a:ext uri="{FF2B5EF4-FFF2-40B4-BE49-F238E27FC236}">
                      <a16:creationId xmlns:a16="http://schemas.microsoft.com/office/drawing/2014/main" id="{18798AE8-4604-47D3-B8E9-1B5E683442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411425" y="3979129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6" name="Rectangle 554">
                  <a:extLst>
                    <a:ext uri="{FF2B5EF4-FFF2-40B4-BE49-F238E27FC236}">
                      <a16:creationId xmlns:a16="http://schemas.microsoft.com/office/drawing/2014/main" id="{57B3C78D-6551-4230-AC90-D725069030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41187" y="4095614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7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7" name="Rectangle 555">
                  <a:extLst>
                    <a:ext uri="{FF2B5EF4-FFF2-40B4-BE49-F238E27FC236}">
                      <a16:creationId xmlns:a16="http://schemas.microsoft.com/office/drawing/2014/main" id="{F7362CE8-AB89-4D92-9378-6D680B8D31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68275" y="409561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8" name="Rectangle 556">
                  <a:extLst>
                    <a:ext uri="{FF2B5EF4-FFF2-40B4-BE49-F238E27FC236}">
                      <a16:creationId xmlns:a16="http://schemas.microsoft.com/office/drawing/2014/main" id="{E7E3B7E6-0260-4F6A-9B67-05FBE4646D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46150" y="409561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9" name="Rectangle 557">
                  <a:extLst>
                    <a:ext uri="{FF2B5EF4-FFF2-40B4-BE49-F238E27FC236}">
                      <a16:creationId xmlns:a16="http://schemas.microsoft.com/office/drawing/2014/main" id="{2988B410-BF34-48B5-9226-FF71A741E9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633550" y="409561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0" name="Rectangle 558">
                  <a:extLst>
                    <a:ext uri="{FF2B5EF4-FFF2-40B4-BE49-F238E27FC236}">
                      <a16:creationId xmlns:a16="http://schemas.microsoft.com/office/drawing/2014/main" id="{94EDE2B0-E5E0-4DE4-9F4C-030FE8E5735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411425" y="409561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1" name="Rectangle 559">
                  <a:extLst>
                    <a:ext uri="{FF2B5EF4-FFF2-40B4-BE49-F238E27FC236}">
                      <a16:creationId xmlns:a16="http://schemas.microsoft.com/office/drawing/2014/main" id="{C9998753-EE17-4D7A-98F9-411FAFAE47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41187" y="4221234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2" name="Rectangle 560">
                  <a:extLst>
                    <a:ext uri="{FF2B5EF4-FFF2-40B4-BE49-F238E27FC236}">
                      <a16:creationId xmlns:a16="http://schemas.microsoft.com/office/drawing/2014/main" id="{2AF5936B-8C1B-4CF1-B8EA-61A402F68E6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68275" y="422123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3" name="Rectangle 561">
                  <a:extLst>
                    <a:ext uri="{FF2B5EF4-FFF2-40B4-BE49-F238E27FC236}">
                      <a16:creationId xmlns:a16="http://schemas.microsoft.com/office/drawing/2014/main" id="{401D80A0-4D4A-4C20-AC38-AB47C36F88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46150" y="422123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4" name="Rectangle 562">
                  <a:extLst>
                    <a:ext uri="{FF2B5EF4-FFF2-40B4-BE49-F238E27FC236}">
                      <a16:creationId xmlns:a16="http://schemas.microsoft.com/office/drawing/2014/main" id="{0E69E380-3482-4397-8012-CB12EA5DBD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633550" y="422123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5" name="Rectangle 563">
                  <a:extLst>
                    <a:ext uri="{FF2B5EF4-FFF2-40B4-BE49-F238E27FC236}">
                      <a16:creationId xmlns:a16="http://schemas.microsoft.com/office/drawing/2014/main" id="{1C12E8A8-9E8D-4BF4-8A93-8BBCEC86EC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411425" y="422123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6" name="Rectangle 564">
                  <a:extLst>
                    <a:ext uri="{FF2B5EF4-FFF2-40B4-BE49-F238E27FC236}">
                      <a16:creationId xmlns:a16="http://schemas.microsoft.com/office/drawing/2014/main" id="{EFD3BB25-BFB0-4C1E-8397-C8031361A5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80875" y="4337719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7" name="Rectangle 565">
                  <a:extLst>
                    <a:ext uri="{FF2B5EF4-FFF2-40B4-BE49-F238E27FC236}">
                      <a16:creationId xmlns:a16="http://schemas.microsoft.com/office/drawing/2014/main" id="{EADEA13A-F003-454E-9EB5-C66246091B9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68275" y="4337719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8" name="Rectangle 566">
                  <a:extLst>
                    <a:ext uri="{FF2B5EF4-FFF2-40B4-BE49-F238E27FC236}">
                      <a16:creationId xmlns:a16="http://schemas.microsoft.com/office/drawing/2014/main" id="{8D2B5A9D-90EC-4F06-B4DA-198E8D8EB00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46150" y="4337719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9" name="Rectangle 567">
                  <a:extLst>
                    <a:ext uri="{FF2B5EF4-FFF2-40B4-BE49-F238E27FC236}">
                      <a16:creationId xmlns:a16="http://schemas.microsoft.com/office/drawing/2014/main" id="{58A050A2-3676-4BBA-96D2-B4210AEC5F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633550" y="4337719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0" name="Rectangle 568">
                  <a:extLst>
                    <a:ext uri="{FF2B5EF4-FFF2-40B4-BE49-F238E27FC236}">
                      <a16:creationId xmlns:a16="http://schemas.microsoft.com/office/drawing/2014/main" id="{A151FFB9-7AE0-4655-928C-8FB4DAAE856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411425" y="4337719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1" name="Rectangle 569">
                  <a:extLst>
                    <a:ext uri="{FF2B5EF4-FFF2-40B4-BE49-F238E27FC236}">
                      <a16:creationId xmlns:a16="http://schemas.microsoft.com/office/drawing/2014/main" id="{E9294447-46FF-49EE-A5B4-099490E244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41187" y="4451920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2" name="Rectangle 570">
                  <a:extLst>
                    <a:ext uri="{FF2B5EF4-FFF2-40B4-BE49-F238E27FC236}">
                      <a16:creationId xmlns:a16="http://schemas.microsoft.com/office/drawing/2014/main" id="{3EF26C49-6127-47B3-81E9-9020C14F072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28587" y="4451920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3" name="Rectangle 571">
                  <a:extLst>
                    <a:ext uri="{FF2B5EF4-FFF2-40B4-BE49-F238E27FC236}">
                      <a16:creationId xmlns:a16="http://schemas.microsoft.com/office/drawing/2014/main" id="{9F8535B5-F4CC-4090-8CF4-A357BA1D2D1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46150" y="4451920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7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4" name="Rectangle 572">
                  <a:extLst>
                    <a:ext uri="{FF2B5EF4-FFF2-40B4-BE49-F238E27FC236}">
                      <a16:creationId xmlns:a16="http://schemas.microsoft.com/office/drawing/2014/main" id="{85EDE29C-F34A-48AB-A7C8-2DF57489F8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633550" y="4451920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5" name="Rectangle 573">
                  <a:extLst>
                    <a:ext uri="{FF2B5EF4-FFF2-40B4-BE49-F238E27FC236}">
                      <a16:creationId xmlns:a16="http://schemas.microsoft.com/office/drawing/2014/main" id="{30A30AB6-8519-4A63-BE96-6EFFD3332D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411425" y="4451920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6" name="Line 574">
                  <a:extLst>
                    <a:ext uri="{FF2B5EF4-FFF2-40B4-BE49-F238E27FC236}">
                      <a16:creationId xmlns:a16="http://schemas.microsoft.com/office/drawing/2014/main" id="{84B87DBD-7A15-4766-B101-76447751F15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196737" y="3992833"/>
                  <a:ext cx="0" cy="62125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77" name="Rectangle 575">
                  <a:extLst>
                    <a:ext uri="{FF2B5EF4-FFF2-40B4-BE49-F238E27FC236}">
                      <a16:creationId xmlns:a16="http://schemas.microsoft.com/office/drawing/2014/main" id="{1A2BA9D9-D0D9-48AA-885B-8241D29A78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938525" y="4463339"/>
                  <a:ext cx="192360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OD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8" name="Rectangle 576">
                  <a:extLst>
                    <a:ext uri="{FF2B5EF4-FFF2-40B4-BE49-F238E27FC236}">
                      <a16:creationId xmlns:a16="http://schemas.microsoft.com/office/drawing/2014/main" id="{C703F441-AE41-4079-9E3A-63D38543C0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768606" y="4349138"/>
                  <a:ext cx="362279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A020F0"/>
                      </a:solidFill>
                      <a:effectLst/>
                      <a:latin typeface="Arial" panose="020B0604020202020204" pitchFamily="34" charset="0"/>
                    </a:rPr>
                    <a:t>MAPK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9" name="Rectangle 577">
                  <a:extLst>
                    <a:ext uri="{FF2B5EF4-FFF2-40B4-BE49-F238E27FC236}">
                      <a16:creationId xmlns:a16="http://schemas.microsoft.com/office/drawing/2014/main" id="{5ADCBAC6-112B-4095-8B6C-C6A1E49483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718913" y="4232655"/>
                  <a:ext cx="411972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FFA500"/>
                      </a:solidFill>
                      <a:effectLst/>
                      <a:latin typeface="Arial" panose="020B0604020202020204" pitchFamily="34" charset="0"/>
                    </a:rPr>
                    <a:t>H3.3mt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0" name="Rectangle 578">
                  <a:extLst>
                    <a:ext uri="{FF2B5EF4-FFF2-40B4-BE49-F238E27FC236}">
                      <a16:creationId xmlns:a16="http://schemas.microsoft.com/office/drawing/2014/main" id="{1840F10C-7A0D-4ECB-901D-5FA1930EBD1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839138" y="4107034"/>
                  <a:ext cx="291747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GBM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1" name="Rectangle 579">
                  <a:extLst>
                    <a:ext uri="{FF2B5EF4-FFF2-40B4-BE49-F238E27FC236}">
                      <a16:creationId xmlns:a16="http://schemas.microsoft.com/office/drawing/2014/main" id="{906722EB-668B-44AF-86D8-0ACD6CE1319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045925" y="3990550"/>
                  <a:ext cx="84960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A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2" name="Line 580">
                  <a:extLst>
                    <a:ext uri="{FF2B5EF4-FFF2-40B4-BE49-F238E27FC236}">
                      <a16:creationId xmlns:a16="http://schemas.microsoft.com/office/drawing/2014/main" id="{5A5D38C0-BD3B-4A35-9C52-0455EDAD0E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164987" y="4545563"/>
                  <a:ext cx="317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3" name="Line 581">
                  <a:extLst>
                    <a:ext uri="{FF2B5EF4-FFF2-40B4-BE49-F238E27FC236}">
                      <a16:creationId xmlns:a16="http://schemas.microsoft.com/office/drawing/2014/main" id="{C47DAF02-E6E6-4853-95F5-F4379033314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164987" y="4431363"/>
                  <a:ext cx="317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4" name="Line 582">
                  <a:extLst>
                    <a:ext uri="{FF2B5EF4-FFF2-40B4-BE49-F238E27FC236}">
                      <a16:creationId xmlns:a16="http://schemas.microsoft.com/office/drawing/2014/main" id="{E5F39018-7E7C-43B3-935E-01F049CF20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164987" y="4303458"/>
                  <a:ext cx="317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5" name="Line 583">
                  <a:extLst>
                    <a:ext uri="{FF2B5EF4-FFF2-40B4-BE49-F238E27FC236}">
                      <a16:creationId xmlns:a16="http://schemas.microsoft.com/office/drawing/2014/main" id="{C2D6F055-07A7-41C9-A9D1-6E9C9B6B59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164987" y="4186975"/>
                  <a:ext cx="317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6" name="Line 584">
                  <a:extLst>
                    <a:ext uri="{FF2B5EF4-FFF2-40B4-BE49-F238E27FC236}">
                      <a16:creationId xmlns:a16="http://schemas.microsoft.com/office/drawing/2014/main" id="{6CA69A23-3545-4EA6-B947-50B55EEF6A3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164987" y="4072774"/>
                  <a:ext cx="31750" cy="0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7" name="Line 585">
                  <a:extLst>
                    <a:ext uri="{FF2B5EF4-FFF2-40B4-BE49-F238E27FC236}">
                      <a16:creationId xmlns:a16="http://schemas.microsoft.com/office/drawing/2014/main" id="{7F851F1C-39C8-4858-AEE4-2FC8EFE9E3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9196737" y="4614083"/>
                  <a:ext cx="3443288" cy="0"/>
                </a:xfrm>
                <a:prstGeom prst="line">
                  <a:avLst/>
                </a:prstGeom>
                <a:noFill/>
                <a:ln w="7938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8" name="Line 586">
                  <a:extLst>
                    <a:ext uri="{FF2B5EF4-FFF2-40B4-BE49-F238E27FC236}">
                      <a16:creationId xmlns:a16="http://schemas.microsoft.com/office/drawing/2014/main" id="{B03B3DA9-CA35-4957-A69A-D5C082C9FCC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349137" y="4614083"/>
                  <a:ext cx="0" cy="47965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89" name="Line 587">
                  <a:extLst>
                    <a:ext uri="{FF2B5EF4-FFF2-40B4-BE49-F238E27FC236}">
                      <a16:creationId xmlns:a16="http://schemas.microsoft.com/office/drawing/2014/main" id="{917FBA2A-674C-43E2-B1D1-0F8CF1A6F7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136537" y="4614083"/>
                  <a:ext cx="0" cy="47965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0" name="Line 588">
                  <a:extLst>
                    <a:ext uri="{FF2B5EF4-FFF2-40B4-BE49-F238E27FC236}">
                      <a16:creationId xmlns:a16="http://schemas.microsoft.com/office/drawing/2014/main" id="{C0F7BC2E-58B0-438A-9592-E9D60E29A2C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0914412" y="4614083"/>
                  <a:ext cx="0" cy="47965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1" name="Line 589">
                  <a:extLst>
                    <a:ext uri="{FF2B5EF4-FFF2-40B4-BE49-F238E27FC236}">
                      <a16:creationId xmlns:a16="http://schemas.microsoft.com/office/drawing/2014/main" id="{1E6AEE55-C52F-47F5-AB6E-435337E713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1701812" y="4614083"/>
                  <a:ext cx="0" cy="47965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2" name="Line 590">
                  <a:extLst>
                    <a:ext uri="{FF2B5EF4-FFF2-40B4-BE49-F238E27FC236}">
                      <a16:creationId xmlns:a16="http://schemas.microsoft.com/office/drawing/2014/main" id="{D3457DA6-C1EF-4B8B-A891-2A8D91049D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2479687" y="4614083"/>
                  <a:ext cx="0" cy="47965"/>
                </a:xfrm>
                <a:prstGeom prst="line">
                  <a:avLst/>
                </a:prstGeom>
                <a:noFill/>
                <a:ln w="7938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3" name="Rectangle 591">
                  <a:extLst>
                    <a:ext uri="{FF2B5EF4-FFF2-40B4-BE49-F238E27FC236}">
                      <a16:creationId xmlns:a16="http://schemas.microsoft.com/office/drawing/2014/main" id="{94402915-EBAC-4340-96E7-224A75AF0F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80875" y="4694024"/>
                  <a:ext cx="1365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4" name="Rectangle 592">
                  <a:extLst>
                    <a:ext uri="{FF2B5EF4-FFF2-40B4-BE49-F238E27FC236}">
                      <a16:creationId xmlns:a16="http://schemas.microsoft.com/office/drawing/2014/main" id="{4B1A51AB-07B6-430D-AEB6-13842BBD7D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028587" y="4694024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5" name="Rectangle 593">
                  <a:extLst>
                    <a:ext uri="{FF2B5EF4-FFF2-40B4-BE49-F238E27FC236}">
                      <a16:creationId xmlns:a16="http://schemas.microsoft.com/office/drawing/2014/main" id="{83B4F258-03A4-4390-8B67-12D85A49A1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806462" y="4694024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6" name="Rectangle 594">
                  <a:extLst>
                    <a:ext uri="{FF2B5EF4-FFF2-40B4-BE49-F238E27FC236}">
                      <a16:creationId xmlns:a16="http://schemas.microsoft.com/office/drawing/2014/main" id="{6C0F1829-45D2-4B95-924D-F55DD039B8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593862" y="4694024"/>
                  <a:ext cx="215900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9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7" name="Rectangle 595">
                  <a:extLst>
                    <a:ext uri="{FF2B5EF4-FFF2-40B4-BE49-F238E27FC236}">
                      <a16:creationId xmlns:a16="http://schemas.microsoft.com/office/drawing/2014/main" id="{B8D7263F-B3BB-43A8-8501-157085005D4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335225" y="4694024"/>
                  <a:ext cx="288925" cy="2649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347" name="Rectangle 596">
                <a:extLst>
                  <a:ext uri="{FF2B5EF4-FFF2-40B4-BE49-F238E27FC236}">
                    <a16:creationId xmlns:a16="http://schemas.microsoft.com/office/drawing/2014/main" id="{33DE9076-E5C5-44A9-863A-249FE8535E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00078" y="5139319"/>
                <a:ext cx="528076" cy="2013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Months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48" name="ZoneTexte 347">
                <a:extLst>
                  <a:ext uri="{FF2B5EF4-FFF2-40B4-BE49-F238E27FC236}">
                    <a16:creationId xmlns:a16="http://schemas.microsoft.com/office/drawing/2014/main" id="{5BDF3718-E44F-4D7F-A960-112DFAFD01E6}"/>
                  </a:ext>
                </a:extLst>
              </p:cNvPr>
              <p:cNvSpPr txBox="1"/>
              <p:nvPr/>
            </p:nvSpPr>
            <p:spPr>
              <a:xfrm>
                <a:off x="10496461" y="1183560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9" name="ZoneTexte 348">
                <a:extLst>
                  <a:ext uri="{FF2B5EF4-FFF2-40B4-BE49-F238E27FC236}">
                    <a16:creationId xmlns:a16="http://schemas.microsoft.com/office/drawing/2014/main" id="{A0437648-264A-45D4-B0A8-4AE47E94E5AC}"/>
                  </a:ext>
                </a:extLst>
              </p:cNvPr>
              <p:cNvSpPr txBox="1"/>
              <p:nvPr/>
            </p:nvSpPr>
            <p:spPr>
              <a:xfrm>
                <a:off x="10511842" y="201211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153FFC15-F4EB-4EAF-BEBE-F8BE9A69E8DB}"/>
                </a:ext>
              </a:extLst>
            </p:cNvPr>
            <p:cNvSpPr txBox="1"/>
            <p:nvPr/>
          </p:nvSpPr>
          <p:spPr>
            <a:xfrm>
              <a:off x="10251637" y="2603486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8.9m</a:t>
              </a: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EF8DCF27-C1A9-41FF-A492-C8B829AAD1BA}"/>
                </a:ext>
              </a:extLst>
            </p:cNvPr>
            <p:cNvSpPr txBox="1"/>
            <p:nvPr/>
          </p:nvSpPr>
          <p:spPr>
            <a:xfrm>
              <a:off x="9276270" y="2877602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.1m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07A58FED-06FA-4CA5-ABA9-E7B4DE305B79}"/>
                </a:ext>
              </a:extLst>
            </p:cNvPr>
            <p:cNvSpPr txBox="1"/>
            <p:nvPr/>
          </p:nvSpPr>
          <p:spPr>
            <a:xfrm>
              <a:off x="8444994" y="2830649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3.9m</a:t>
              </a:r>
            </a:p>
          </p:txBody>
        </p:sp>
        <p:grpSp>
          <p:nvGrpSpPr>
            <p:cNvPr id="9" name="Groupe 8">
              <a:extLst>
                <a:ext uri="{FF2B5EF4-FFF2-40B4-BE49-F238E27FC236}">
                  <a16:creationId xmlns:a16="http://schemas.microsoft.com/office/drawing/2014/main" id="{3A175A4B-30D1-40AD-81A1-28A129750934}"/>
                </a:ext>
              </a:extLst>
            </p:cNvPr>
            <p:cNvGrpSpPr/>
            <p:nvPr/>
          </p:nvGrpSpPr>
          <p:grpSpPr>
            <a:xfrm>
              <a:off x="-313330" y="850299"/>
              <a:ext cx="4003617" cy="4245108"/>
              <a:chOff x="-694330" y="850299"/>
              <a:chExt cx="4003617" cy="4245108"/>
            </a:xfrm>
          </p:grpSpPr>
          <p:grpSp>
            <p:nvGrpSpPr>
              <p:cNvPr id="141" name="Groupe 140">
                <a:extLst>
                  <a:ext uri="{FF2B5EF4-FFF2-40B4-BE49-F238E27FC236}">
                    <a16:creationId xmlns:a16="http://schemas.microsoft.com/office/drawing/2014/main" id="{B7A5F7B9-9F38-4293-8321-E7DAE3037A89}"/>
                  </a:ext>
                </a:extLst>
              </p:cNvPr>
              <p:cNvGrpSpPr/>
              <p:nvPr/>
            </p:nvGrpSpPr>
            <p:grpSpPr>
              <a:xfrm>
                <a:off x="-694330" y="1077913"/>
                <a:ext cx="4003617" cy="4017494"/>
                <a:chOff x="798571" y="1077913"/>
                <a:chExt cx="4003617" cy="4017494"/>
              </a:xfrm>
            </p:grpSpPr>
            <p:sp>
              <p:nvSpPr>
                <p:cNvPr id="147" name="Freeform 153">
                  <a:extLst>
                    <a:ext uri="{FF2B5EF4-FFF2-40B4-BE49-F238E27FC236}">
                      <a16:creationId xmlns:a16="http://schemas.microsoft.com/office/drawing/2014/main" id="{E3633B61-B7D2-44D1-ABAB-1D30E820C34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08163" y="1198563"/>
                  <a:ext cx="1746250" cy="1874837"/>
                </a:xfrm>
                <a:custGeom>
                  <a:avLst/>
                  <a:gdLst>
                    <a:gd name="T0" fmla="*/ 0 w 269"/>
                    <a:gd name="T1" fmla="*/ 0 h 233"/>
                    <a:gd name="T2" fmla="*/ 5 w 269"/>
                    <a:gd name="T3" fmla="*/ 0 h 233"/>
                    <a:gd name="T4" fmla="*/ 5 w 269"/>
                    <a:gd name="T5" fmla="*/ 17 h 233"/>
                    <a:gd name="T6" fmla="*/ 6 w 269"/>
                    <a:gd name="T7" fmla="*/ 17 h 233"/>
                    <a:gd name="T8" fmla="*/ 6 w 269"/>
                    <a:gd name="T9" fmla="*/ 33 h 233"/>
                    <a:gd name="T10" fmla="*/ 7 w 269"/>
                    <a:gd name="T11" fmla="*/ 33 h 233"/>
                    <a:gd name="T12" fmla="*/ 7 w 269"/>
                    <a:gd name="T13" fmla="*/ 50 h 233"/>
                    <a:gd name="T14" fmla="*/ 10 w 269"/>
                    <a:gd name="T15" fmla="*/ 50 h 233"/>
                    <a:gd name="T16" fmla="*/ 10 w 269"/>
                    <a:gd name="T17" fmla="*/ 67 h 233"/>
                    <a:gd name="T18" fmla="*/ 17 w 269"/>
                    <a:gd name="T19" fmla="*/ 67 h 233"/>
                    <a:gd name="T20" fmla="*/ 17 w 269"/>
                    <a:gd name="T21" fmla="*/ 84 h 233"/>
                    <a:gd name="T22" fmla="*/ 30 w 269"/>
                    <a:gd name="T23" fmla="*/ 84 h 233"/>
                    <a:gd name="T24" fmla="*/ 30 w 269"/>
                    <a:gd name="T25" fmla="*/ 101 h 233"/>
                    <a:gd name="T26" fmla="*/ 40 w 269"/>
                    <a:gd name="T27" fmla="*/ 101 h 233"/>
                    <a:gd name="T28" fmla="*/ 40 w 269"/>
                    <a:gd name="T29" fmla="*/ 118 h 233"/>
                    <a:gd name="T30" fmla="*/ 41 w 269"/>
                    <a:gd name="T31" fmla="*/ 118 h 233"/>
                    <a:gd name="T32" fmla="*/ 41 w 269"/>
                    <a:gd name="T33" fmla="*/ 118 h 233"/>
                    <a:gd name="T34" fmla="*/ 42 w 269"/>
                    <a:gd name="T35" fmla="*/ 118 h 233"/>
                    <a:gd name="T36" fmla="*/ 42 w 269"/>
                    <a:gd name="T37" fmla="*/ 136 h 233"/>
                    <a:gd name="T38" fmla="*/ 59 w 269"/>
                    <a:gd name="T39" fmla="*/ 136 h 233"/>
                    <a:gd name="T40" fmla="*/ 59 w 269"/>
                    <a:gd name="T41" fmla="*/ 155 h 233"/>
                    <a:gd name="T42" fmla="*/ 62 w 269"/>
                    <a:gd name="T43" fmla="*/ 155 h 233"/>
                    <a:gd name="T44" fmla="*/ 62 w 269"/>
                    <a:gd name="T45" fmla="*/ 155 h 233"/>
                    <a:gd name="T46" fmla="*/ 67 w 269"/>
                    <a:gd name="T47" fmla="*/ 155 h 233"/>
                    <a:gd name="T48" fmla="*/ 67 w 269"/>
                    <a:gd name="T49" fmla="*/ 155 h 233"/>
                    <a:gd name="T50" fmla="*/ 83 w 269"/>
                    <a:gd name="T51" fmla="*/ 155 h 233"/>
                    <a:gd name="T52" fmla="*/ 83 w 269"/>
                    <a:gd name="T53" fmla="*/ 181 h 233"/>
                    <a:gd name="T54" fmla="*/ 101 w 269"/>
                    <a:gd name="T55" fmla="*/ 181 h 233"/>
                    <a:gd name="T56" fmla="*/ 101 w 269"/>
                    <a:gd name="T57" fmla="*/ 207 h 233"/>
                    <a:gd name="T58" fmla="*/ 156 w 269"/>
                    <a:gd name="T59" fmla="*/ 207 h 233"/>
                    <a:gd name="T60" fmla="*/ 156 w 269"/>
                    <a:gd name="T61" fmla="*/ 233 h 233"/>
                    <a:gd name="T62" fmla="*/ 219 w 269"/>
                    <a:gd name="T63" fmla="*/ 233 h 233"/>
                    <a:gd name="T64" fmla="*/ 219 w 269"/>
                    <a:gd name="T65" fmla="*/ 233 h 233"/>
                    <a:gd name="T66" fmla="*/ 269 w 269"/>
                    <a:gd name="T67" fmla="*/ 233 h 233"/>
                    <a:gd name="T68" fmla="*/ 269 w 269"/>
                    <a:gd name="T69" fmla="*/ 233 h 2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</a:cxnLst>
                  <a:rect l="0" t="0" r="r" b="b"/>
                  <a:pathLst>
                    <a:path w="269" h="233">
                      <a:moveTo>
                        <a:pt x="0" y="0"/>
                      </a:moveTo>
                      <a:lnTo>
                        <a:pt x="5" y="0"/>
                      </a:lnTo>
                      <a:lnTo>
                        <a:pt x="5" y="17"/>
                      </a:lnTo>
                      <a:lnTo>
                        <a:pt x="6" y="17"/>
                      </a:lnTo>
                      <a:lnTo>
                        <a:pt x="6" y="33"/>
                      </a:lnTo>
                      <a:lnTo>
                        <a:pt x="7" y="33"/>
                      </a:lnTo>
                      <a:lnTo>
                        <a:pt x="7" y="50"/>
                      </a:lnTo>
                      <a:lnTo>
                        <a:pt x="10" y="50"/>
                      </a:lnTo>
                      <a:lnTo>
                        <a:pt x="10" y="67"/>
                      </a:lnTo>
                      <a:lnTo>
                        <a:pt x="17" y="67"/>
                      </a:lnTo>
                      <a:lnTo>
                        <a:pt x="17" y="84"/>
                      </a:lnTo>
                      <a:lnTo>
                        <a:pt x="30" y="84"/>
                      </a:lnTo>
                      <a:lnTo>
                        <a:pt x="30" y="101"/>
                      </a:lnTo>
                      <a:lnTo>
                        <a:pt x="40" y="101"/>
                      </a:lnTo>
                      <a:lnTo>
                        <a:pt x="40" y="118"/>
                      </a:lnTo>
                      <a:lnTo>
                        <a:pt x="41" y="118"/>
                      </a:lnTo>
                      <a:lnTo>
                        <a:pt x="41" y="118"/>
                      </a:lnTo>
                      <a:lnTo>
                        <a:pt x="42" y="118"/>
                      </a:lnTo>
                      <a:lnTo>
                        <a:pt x="42" y="136"/>
                      </a:lnTo>
                      <a:lnTo>
                        <a:pt x="59" y="136"/>
                      </a:lnTo>
                      <a:lnTo>
                        <a:pt x="59" y="155"/>
                      </a:lnTo>
                      <a:lnTo>
                        <a:pt x="62" y="155"/>
                      </a:lnTo>
                      <a:lnTo>
                        <a:pt x="62" y="155"/>
                      </a:lnTo>
                      <a:lnTo>
                        <a:pt x="67" y="155"/>
                      </a:lnTo>
                      <a:lnTo>
                        <a:pt x="67" y="155"/>
                      </a:lnTo>
                      <a:lnTo>
                        <a:pt x="83" y="155"/>
                      </a:lnTo>
                      <a:lnTo>
                        <a:pt x="83" y="181"/>
                      </a:lnTo>
                      <a:lnTo>
                        <a:pt x="101" y="181"/>
                      </a:lnTo>
                      <a:lnTo>
                        <a:pt x="101" y="207"/>
                      </a:lnTo>
                      <a:lnTo>
                        <a:pt x="156" y="207"/>
                      </a:lnTo>
                      <a:lnTo>
                        <a:pt x="156" y="233"/>
                      </a:lnTo>
                      <a:lnTo>
                        <a:pt x="219" y="233"/>
                      </a:lnTo>
                      <a:lnTo>
                        <a:pt x="219" y="233"/>
                      </a:lnTo>
                      <a:lnTo>
                        <a:pt x="269" y="233"/>
                      </a:lnTo>
                      <a:lnTo>
                        <a:pt x="269" y="233"/>
                      </a:ln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8" name="Freeform 154">
                  <a:extLst>
                    <a:ext uri="{FF2B5EF4-FFF2-40B4-BE49-F238E27FC236}">
                      <a16:creationId xmlns:a16="http://schemas.microsoft.com/office/drawing/2014/main" id="{D0274F42-E283-41A2-8273-E8D2822D910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08163" y="1198563"/>
                  <a:ext cx="1395413" cy="2301875"/>
                </a:xfrm>
                <a:custGeom>
                  <a:avLst/>
                  <a:gdLst>
                    <a:gd name="T0" fmla="*/ 0 w 215"/>
                    <a:gd name="T1" fmla="*/ 0 h 286"/>
                    <a:gd name="T2" fmla="*/ 10 w 215"/>
                    <a:gd name="T3" fmla="*/ 0 h 286"/>
                    <a:gd name="T4" fmla="*/ 10 w 215"/>
                    <a:gd name="T5" fmla="*/ 13 h 286"/>
                    <a:gd name="T6" fmla="*/ 14 w 215"/>
                    <a:gd name="T7" fmla="*/ 13 h 286"/>
                    <a:gd name="T8" fmla="*/ 14 w 215"/>
                    <a:gd name="T9" fmla="*/ 26 h 286"/>
                    <a:gd name="T10" fmla="*/ 31 w 215"/>
                    <a:gd name="T11" fmla="*/ 26 h 286"/>
                    <a:gd name="T12" fmla="*/ 31 w 215"/>
                    <a:gd name="T13" fmla="*/ 39 h 286"/>
                    <a:gd name="T14" fmla="*/ 35 w 215"/>
                    <a:gd name="T15" fmla="*/ 39 h 286"/>
                    <a:gd name="T16" fmla="*/ 35 w 215"/>
                    <a:gd name="T17" fmla="*/ 52 h 286"/>
                    <a:gd name="T18" fmla="*/ 39 w 215"/>
                    <a:gd name="T19" fmla="*/ 52 h 286"/>
                    <a:gd name="T20" fmla="*/ 39 w 215"/>
                    <a:gd name="T21" fmla="*/ 65 h 286"/>
                    <a:gd name="T22" fmla="*/ 46 w 215"/>
                    <a:gd name="T23" fmla="*/ 65 h 286"/>
                    <a:gd name="T24" fmla="*/ 46 w 215"/>
                    <a:gd name="T25" fmla="*/ 91 h 286"/>
                    <a:gd name="T26" fmla="*/ 51 w 215"/>
                    <a:gd name="T27" fmla="*/ 91 h 286"/>
                    <a:gd name="T28" fmla="*/ 51 w 215"/>
                    <a:gd name="T29" fmla="*/ 104 h 286"/>
                    <a:gd name="T30" fmla="*/ 54 w 215"/>
                    <a:gd name="T31" fmla="*/ 104 h 286"/>
                    <a:gd name="T32" fmla="*/ 54 w 215"/>
                    <a:gd name="T33" fmla="*/ 117 h 286"/>
                    <a:gd name="T34" fmla="*/ 54 w 215"/>
                    <a:gd name="T35" fmla="*/ 117 h 286"/>
                    <a:gd name="T36" fmla="*/ 54 w 215"/>
                    <a:gd name="T37" fmla="*/ 130 h 286"/>
                    <a:gd name="T38" fmla="*/ 61 w 215"/>
                    <a:gd name="T39" fmla="*/ 130 h 286"/>
                    <a:gd name="T40" fmla="*/ 61 w 215"/>
                    <a:gd name="T41" fmla="*/ 143 h 286"/>
                    <a:gd name="T42" fmla="*/ 73 w 215"/>
                    <a:gd name="T43" fmla="*/ 143 h 286"/>
                    <a:gd name="T44" fmla="*/ 73 w 215"/>
                    <a:gd name="T45" fmla="*/ 156 h 286"/>
                    <a:gd name="T46" fmla="*/ 73 w 215"/>
                    <a:gd name="T47" fmla="*/ 156 h 286"/>
                    <a:gd name="T48" fmla="*/ 73 w 215"/>
                    <a:gd name="T49" fmla="*/ 169 h 286"/>
                    <a:gd name="T50" fmla="*/ 91 w 215"/>
                    <a:gd name="T51" fmla="*/ 169 h 286"/>
                    <a:gd name="T52" fmla="*/ 91 w 215"/>
                    <a:gd name="T53" fmla="*/ 182 h 286"/>
                    <a:gd name="T54" fmla="*/ 97 w 215"/>
                    <a:gd name="T55" fmla="*/ 182 h 286"/>
                    <a:gd name="T56" fmla="*/ 97 w 215"/>
                    <a:gd name="T57" fmla="*/ 195 h 286"/>
                    <a:gd name="T58" fmla="*/ 101 w 215"/>
                    <a:gd name="T59" fmla="*/ 195 h 286"/>
                    <a:gd name="T60" fmla="*/ 101 w 215"/>
                    <a:gd name="T61" fmla="*/ 208 h 286"/>
                    <a:gd name="T62" fmla="*/ 107 w 215"/>
                    <a:gd name="T63" fmla="*/ 208 h 286"/>
                    <a:gd name="T64" fmla="*/ 107 w 215"/>
                    <a:gd name="T65" fmla="*/ 221 h 286"/>
                    <a:gd name="T66" fmla="*/ 121 w 215"/>
                    <a:gd name="T67" fmla="*/ 221 h 286"/>
                    <a:gd name="T68" fmla="*/ 121 w 215"/>
                    <a:gd name="T69" fmla="*/ 234 h 286"/>
                    <a:gd name="T70" fmla="*/ 124 w 215"/>
                    <a:gd name="T71" fmla="*/ 234 h 286"/>
                    <a:gd name="T72" fmla="*/ 124 w 215"/>
                    <a:gd name="T73" fmla="*/ 247 h 286"/>
                    <a:gd name="T74" fmla="*/ 135 w 215"/>
                    <a:gd name="T75" fmla="*/ 247 h 286"/>
                    <a:gd name="T76" fmla="*/ 135 w 215"/>
                    <a:gd name="T77" fmla="*/ 260 h 286"/>
                    <a:gd name="T78" fmla="*/ 190 w 215"/>
                    <a:gd name="T79" fmla="*/ 260 h 286"/>
                    <a:gd name="T80" fmla="*/ 190 w 215"/>
                    <a:gd name="T81" fmla="*/ 273 h 286"/>
                    <a:gd name="T82" fmla="*/ 215 w 215"/>
                    <a:gd name="T83" fmla="*/ 273 h 286"/>
                    <a:gd name="T84" fmla="*/ 215 w 215"/>
                    <a:gd name="T85" fmla="*/ 286 h 2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</a:cxnLst>
                  <a:rect l="0" t="0" r="r" b="b"/>
                  <a:pathLst>
                    <a:path w="215" h="286">
                      <a:moveTo>
                        <a:pt x="0" y="0"/>
                      </a:moveTo>
                      <a:lnTo>
                        <a:pt x="10" y="0"/>
                      </a:lnTo>
                      <a:lnTo>
                        <a:pt x="10" y="13"/>
                      </a:lnTo>
                      <a:lnTo>
                        <a:pt x="14" y="13"/>
                      </a:lnTo>
                      <a:lnTo>
                        <a:pt x="14" y="26"/>
                      </a:lnTo>
                      <a:lnTo>
                        <a:pt x="31" y="26"/>
                      </a:lnTo>
                      <a:lnTo>
                        <a:pt x="31" y="39"/>
                      </a:lnTo>
                      <a:lnTo>
                        <a:pt x="35" y="39"/>
                      </a:lnTo>
                      <a:lnTo>
                        <a:pt x="35" y="52"/>
                      </a:lnTo>
                      <a:lnTo>
                        <a:pt x="39" y="52"/>
                      </a:lnTo>
                      <a:lnTo>
                        <a:pt x="39" y="65"/>
                      </a:lnTo>
                      <a:lnTo>
                        <a:pt x="46" y="65"/>
                      </a:lnTo>
                      <a:lnTo>
                        <a:pt x="46" y="91"/>
                      </a:lnTo>
                      <a:lnTo>
                        <a:pt x="51" y="91"/>
                      </a:lnTo>
                      <a:lnTo>
                        <a:pt x="51" y="104"/>
                      </a:lnTo>
                      <a:lnTo>
                        <a:pt x="54" y="104"/>
                      </a:lnTo>
                      <a:lnTo>
                        <a:pt x="54" y="117"/>
                      </a:lnTo>
                      <a:lnTo>
                        <a:pt x="54" y="117"/>
                      </a:lnTo>
                      <a:lnTo>
                        <a:pt x="54" y="130"/>
                      </a:lnTo>
                      <a:lnTo>
                        <a:pt x="61" y="130"/>
                      </a:lnTo>
                      <a:lnTo>
                        <a:pt x="61" y="143"/>
                      </a:lnTo>
                      <a:lnTo>
                        <a:pt x="73" y="143"/>
                      </a:lnTo>
                      <a:lnTo>
                        <a:pt x="73" y="156"/>
                      </a:lnTo>
                      <a:lnTo>
                        <a:pt x="73" y="156"/>
                      </a:lnTo>
                      <a:lnTo>
                        <a:pt x="73" y="169"/>
                      </a:lnTo>
                      <a:lnTo>
                        <a:pt x="91" y="169"/>
                      </a:lnTo>
                      <a:lnTo>
                        <a:pt x="91" y="182"/>
                      </a:lnTo>
                      <a:lnTo>
                        <a:pt x="97" y="182"/>
                      </a:lnTo>
                      <a:lnTo>
                        <a:pt x="97" y="195"/>
                      </a:lnTo>
                      <a:lnTo>
                        <a:pt x="101" y="195"/>
                      </a:lnTo>
                      <a:lnTo>
                        <a:pt x="101" y="208"/>
                      </a:lnTo>
                      <a:lnTo>
                        <a:pt x="107" y="208"/>
                      </a:lnTo>
                      <a:lnTo>
                        <a:pt x="107" y="221"/>
                      </a:lnTo>
                      <a:lnTo>
                        <a:pt x="121" y="221"/>
                      </a:lnTo>
                      <a:lnTo>
                        <a:pt x="121" y="234"/>
                      </a:lnTo>
                      <a:lnTo>
                        <a:pt x="124" y="234"/>
                      </a:lnTo>
                      <a:lnTo>
                        <a:pt x="124" y="247"/>
                      </a:lnTo>
                      <a:lnTo>
                        <a:pt x="135" y="247"/>
                      </a:lnTo>
                      <a:lnTo>
                        <a:pt x="135" y="260"/>
                      </a:lnTo>
                      <a:lnTo>
                        <a:pt x="190" y="260"/>
                      </a:lnTo>
                      <a:lnTo>
                        <a:pt x="190" y="273"/>
                      </a:lnTo>
                      <a:lnTo>
                        <a:pt x="215" y="273"/>
                      </a:lnTo>
                      <a:lnTo>
                        <a:pt x="215" y="286"/>
                      </a:lnTo>
                    </a:path>
                  </a:pathLst>
                </a:custGeom>
                <a:noFill/>
                <a:ln w="12700" cap="flat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49" name="Freeform 155">
                  <a:extLst>
                    <a:ext uri="{FF2B5EF4-FFF2-40B4-BE49-F238E27FC236}">
                      <a16:creationId xmlns:a16="http://schemas.microsoft.com/office/drawing/2014/main" id="{B08FE002-7C0A-4CE0-82E5-83FEDCFC2D5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08163" y="1198563"/>
                  <a:ext cx="2435225" cy="869950"/>
                </a:xfrm>
                <a:custGeom>
                  <a:avLst/>
                  <a:gdLst>
                    <a:gd name="T0" fmla="*/ 4 w 375"/>
                    <a:gd name="T1" fmla="*/ 0 h 108"/>
                    <a:gd name="T2" fmla="*/ 19 w 375"/>
                    <a:gd name="T3" fmla="*/ 5 h 108"/>
                    <a:gd name="T4" fmla="*/ 22 w 375"/>
                    <a:gd name="T5" fmla="*/ 5 h 108"/>
                    <a:gd name="T6" fmla="*/ 26 w 375"/>
                    <a:gd name="T7" fmla="*/ 5 h 108"/>
                    <a:gd name="T8" fmla="*/ 29 w 375"/>
                    <a:gd name="T9" fmla="*/ 11 h 108"/>
                    <a:gd name="T10" fmla="*/ 30 w 375"/>
                    <a:gd name="T11" fmla="*/ 17 h 108"/>
                    <a:gd name="T12" fmla="*/ 44 w 375"/>
                    <a:gd name="T13" fmla="*/ 23 h 108"/>
                    <a:gd name="T14" fmla="*/ 46 w 375"/>
                    <a:gd name="T15" fmla="*/ 29 h 108"/>
                    <a:gd name="T16" fmla="*/ 55 w 375"/>
                    <a:gd name="T17" fmla="*/ 35 h 108"/>
                    <a:gd name="T18" fmla="*/ 57 w 375"/>
                    <a:gd name="T19" fmla="*/ 40 h 108"/>
                    <a:gd name="T20" fmla="*/ 59 w 375"/>
                    <a:gd name="T21" fmla="*/ 40 h 108"/>
                    <a:gd name="T22" fmla="*/ 66 w 375"/>
                    <a:gd name="T23" fmla="*/ 40 h 108"/>
                    <a:gd name="T24" fmla="*/ 69 w 375"/>
                    <a:gd name="T25" fmla="*/ 47 h 108"/>
                    <a:gd name="T26" fmla="*/ 76 w 375"/>
                    <a:gd name="T27" fmla="*/ 53 h 108"/>
                    <a:gd name="T28" fmla="*/ 92 w 375"/>
                    <a:gd name="T29" fmla="*/ 59 h 108"/>
                    <a:gd name="T30" fmla="*/ 105 w 375"/>
                    <a:gd name="T31" fmla="*/ 65 h 108"/>
                    <a:gd name="T32" fmla="*/ 127 w 375"/>
                    <a:gd name="T33" fmla="*/ 71 h 108"/>
                    <a:gd name="T34" fmla="*/ 128 w 375"/>
                    <a:gd name="T35" fmla="*/ 77 h 108"/>
                    <a:gd name="T36" fmla="*/ 131 w 375"/>
                    <a:gd name="T37" fmla="*/ 83 h 108"/>
                    <a:gd name="T38" fmla="*/ 139 w 375"/>
                    <a:gd name="T39" fmla="*/ 89 h 108"/>
                    <a:gd name="T40" fmla="*/ 151 w 375"/>
                    <a:gd name="T41" fmla="*/ 96 h 108"/>
                    <a:gd name="T42" fmla="*/ 153 w 375"/>
                    <a:gd name="T43" fmla="*/ 102 h 108"/>
                    <a:gd name="T44" fmla="*/ 210 w 375"/>
                    <a:gd name="T45" fmla="*/ 108 h 108"/>
                    <a:gd name="T46" fmla="*/ 219 w 375"/>
                    <a:gd name="T47" fmla="*/ 108 h 108"/>
                    <a:gd name="T48" fmla="*/ 220 w 375"/>
                    <a:gd name="T49" fmla="*/ 108 h 108"/>
                    <a:gd name="T50" fmla="*/ 220 w 375"/>
                    <a:gd name="T51" fmla="*/ 108 h 108"/>
                    <a:gd name="T52" fmla="*/ 222 w 375"/>
                    <a:gd name="T53" fmla="*/ 108 h 108"/>
                    <a:gd name="T54" fmla="*/ 223 w 375"/>
                    <a:gd name="T55" fmla="*/ 108 h 108"/>
                    <a:gd name="T56" fmla="*/ 224 w 375"/>
                    <a:gd name="T57" fmla="*/ 108 h 108"/>
                    <a:gd name="T58" fmla="*/ 227 w 375"/>
                    <a:gd name="T59" fmla="*/ 108 h 108"/>
                    <a:gd name="T60" fmla="*/ 233 w 375"/>
                    <a:gd name="T61" fmla="*/ 108 h 108"/>
                    <a:gd name="T62" fmla="*/ 234 w 375"/>
                    <a:gd name="T63" fmla="*/ 108 h 108"/>
                    <a:gd name="T64" fmla="*/ 235 w 375"/>
                    <a:gd name="T65" fmla="*/ 108 h 108"/>
                    <a:gd name="T66" fmla="*/ 241 w 375"/>
                    <a:gd name="T67" fmla="*/ 108 h 108"/>
                    <a:gd name="T68" fmla="*/ 243 w 375"/>
                    <a:gd name="T69" fmla="*/ 108 h 108"/>
                    <a:gd name="T70" fmla="*/ 247 w 375"/>
                    <a:gd name="T71" fmla="*/ 108 h 108"/>
                    <a:gd name="T72" fmla="*/ 253 w 375"/>
                    <a:gd name="T73" fmla="*/ 108 h 108"/>
                    <a:gd name="T74" fmla="*/ 254 w 375"/>
                    <a:gd name="T75" fmla="*/ 108 h 108"/>
                    <a:gd name="T76" fmla="*/ 271 w 375"/>
                    <a:gd name="T77" fmla="*/ 108 h 108"/>
                    <a:gd name="T78" fmla="*/ 275 w 375"/>
                    <a:gd name="T79" fmla="*/ 108 h 108"/>
                    <a:gd name="T80" fmla="*/ 279 w 375"/>
                    <a:gd name="T81" fmla="*/ 108 h 108"/>
                    <a:gd name="T82" fmla="*/ 288 w 375"/>
                    <a:gd name="T83" fmla="*/ 108 h 108"/>
                    <a:gd name="T84" fmla="*/ 308 w 375"/>
                    <a:gd name="T85" fmla="*/ 108 h 108"/>
                    <a:gd name="T86" fmla="*/ 314 w 375"/>
                    <a:gd name="T87" fmla="*/ 108 h 108"/>
                    <a:gd name="T88" fmla="*/ 321 w 375"/>
                    <a:gd name="T89" fmla="*/ 108 h 108"/>
                    <a:gd name="T90" fmla="*/ 321 w 375"/>
                    <a:gd name="T91" fmla="*/ 108 h 108"/>
                    <a:gd name="T92" fmla="*/ 328 w 375"/>
                    <a:gd name="T93" fmla="*/ 108 h 108"/>
                    <a:gd name="T94" fmla="*/ 339 w 375"/>
                    <a:gd name="T95" fmla="*/ 108 h 108"/>
                    <a:gd name="T96" fmla="*/ 358 w 375"/>
                    <a:gd name="T97" fmla="*/ 108 h 108"/>
                    <a:gd name="T98" fmla="*/ 375 w 375"/>
                    <a:gd name="T99" fmla="*/ 108 h 1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</a:cxnLst>
                  <a:rect l="0" t="0" r="r" b="b"/>
                  <a:pathLst>
                    <a:path w="375" h="108">
                      <a:moveTo>
                        <a:pt x="0" y="0"/>
                      </a:moveTo>
                      <a:lnTo>
                        <a:pt x="4" y="0"/>
                      </a:lnTo>
                      <a:lnTo>
                        <a:pt x="4" y="5"/>
                      </a:lnTo>
                      <a:lnTo>
                        <a:pt x="19" y="5"/>
                      </a:lnTo>
                      <a:lnTo>
                        <a:pt x="19" y="5"/>
                      </a:lnTo>
                      <a:lnTo>
                        <a:pt x="22" y="5"/>
                      </a:lnTo>
                      <a:lnTo>
                        <a:pt x="22" y="5"/>
                      </a:lnTo>
                      <a:lnTo>
                        <a:pt x="26" y="5"/>
                      </a:lnTo>
                      <a:lnTo>
                        <a:pt x="26" y="11"/>
                      </a:lnTo>
                      <a:lnTo>
                        <a:pt x="29" y="11"/>
                      </a:lnTo>
                      <a:lnTo>
                        <a:pt x="29" y="17"/>
                      </a:lnTo>
                      <a:lnTo>
                        <a:pt x="30" y="17"/>
                      </a:lnTo>
                      <a:lnTo>
                        <a:pt x="30" y="23"/>
                      </a:lnTo>
                      <a:lnTo>
                        <a:pt x="44" y="23"/>
                      </a:lnTo>
                      <a:lnTo>
                        <a:pt x="44" y="29"/>
                      </a:lnTo>
                      <a:lnTo>
                        <a:pt x="46" y="29"/>
                      </a:lnTo>
                      <a:lnTo>
                        <a:pt x="46" y="35"/>
                      </a:lnTo>
                      <a:lnTo>
                        <a:pt x="55" y="35"/>
                      </a:lnTo>
                      <a:lnTo>
                        <a:pt x="55" y="40"/>
                      </a:lnTo>
                      <a:lnTo>
                        <a:pt x="57" y="40"/>
                      </a:lnTo>
                      <a:lnTo>
                        <a:pt x="57" y="40"/>
                      </a:lnTo>
                      <a:lnTo>
                        <a:pt x="59" y="40"/>
                      </a:lnTo>
                      <a:lnTo>
                        <a:pt x="59" y="40"/>
                      </a:lnTo>
                      <a:lnTo>
                        <a:pt x="66" y="40"/>
                      </a:lnTo>
                      <a:lnTo>
                        <a:pt x="66" y="47"/>
                      </a:lnTo>
                      <a:lnTo>
                        <a:pt x="69" y="47"/>
                      </a:lnTo>
                      <a:lnTo>
                        <a:pt x="69" y="53"/>
                      </a:lnTo>
                      <a:lnTo>
                        <a:pt x="76" y="53"/>
                      </a:lnTo>
                      <a:lnTo>
                        <a:pt x="76" y="59"/>
                      </a:lnTo>
                      <a:lnTo>
                        <a:pt x="92" y="59"/>
                      </a:lnTo>
                      <a:lnTo>
                        <a:pt x="92" y="65"/>
                      </a:lnTo>
                      <a:lnTo>
                        <a:pt x="105" y="65"/>
                      </a:lnTo>
                      <a:lnTo>
                        <a:pt x="105" y="71"/>
                      </a:lnTo>
                      <a:lnTo>
                        <a:pt x="127" y="71"/>
                      </a:lnTo>
                      <a:lnTo>
                        <a:pt x="127" y="77"/>
                      </a:lnTo>
                      <a:lnTo>
                        <a:pt x="128" y="77"/>
                      </a:lnTo>
                      <a:lnTo>
                        <a:pt x="128" y="83"/>
                      </a:lnTo>
                      <a:lnTo>
                        <a:pt x="131" y="83"/>
                      </a:lnTo>
                      <a:lnTo>
                        <a:pt x="131" y="89"/>
                      </a:lnTo>
                      <a:lnTo>
                        <a:pt x="139" y="89"/>
                      </a:lnTo>
                      <a:lnTo>
                        <a:pt x="139" y="96"/>
                      </a:lnTo>
                      <a:lnTo>
                        <a:pt x="151" y="96"/>
                      </a:lnTo>
                      <a:lnTo>
                        <a:pt x="151" y="102"/>
                      </a:lnTo>
                      <a:lnTo>
                        <a:pt x="153" y="102"/>
                      </a:lnTo>
                      <a:lnTo>
                        <a:pt x="153" y="108"/>
                      </a:lnTo>
                      <a:lnTo>
                        <a:pt x="210" y="108"/>
                      </a:lnTo>
                      <a:lnTo>
                        <a:pt x="210" y="108"/>
                      </a:lnTo>
                      <a:lnTo>
                        <a:pt x="219" y="108"/>
                      </a:lnTo>
                      <a:lnTo>
                        <a:pt x="219" y="108"/>
                      </a:lnTo>
                      <a:lnTo>
                        <a:pt x="220" y="108"/>
                      </a:lnTo>
                      <a:lnTo>
                        <a:pt x="220" y="108"/>
                      </a:lnTo>
                      <a:lnTo>
                        <a:pt x="220" y="108"/>
                      </a:lnTo>
                      <a:lnTo>
                        <a:pt x="220" y="108"/>
                      </a:lnTo>
                      <a:lnTo>
                        <a:pt x="222" y="108"/>
                      </a:lnTo>
                      <a:lnTo>
                        <a:pt x="222" y="108"/>
                      </a:lnTo>
                      <a:lnTo>
                        <a:pt x="223" y="108"/>
                      </a:lnTo>
                      <a:lnTo>
                        <a:pt x="223" y="108"/>
                      </a:lnTo>
                      <a:lnTo>
                        <a:pt x="224" y="108"/>
                      </a:lnTo>
                      <a:lnTo>
                        <a:pt x="224" y="108"/>
                      </a:lnTo>
                      <a:lnTo>
                        <a:pt x="227" y="108"/>
                      </a:lnTo>
                      <a:lnTo>
                        <a:pt x="227" y="108"/>
                      </a:lnTo>
                      <a:lnTo>
                        <a:pt x="233" y="108"/>
                      </a:lnTo>
                      <a:lnTo>
                        <a:pt x="233" y="108"/>
                      </a:lnTo>
                      <a:lnTo>
                        <a:pt x="234" y="108"/>
                      </a:lnTo>
                      <a:lnTo>
                        <a:pt x="234" y="108"/>
                      </a:lnTo>
                      <a:lnTo>
                        <a:pt x="235" y="108"/>
                      </a:lnTo>
                      <a:lnTo>
                        <a:pt x="235" y="108"/>
                      </a:lnTo>
                      <a:lnTo>
                        <a:pt x="241" y="108"/>
                      </a:lnTo>
                      <a:lnTo>
                        <a:pt x="241" y="108"/>
                      </a:lnTo>
                      <a:lnTo>
                        <a:pt x="243" y="108"/>
                      </a:lnTo>
                      <a:lnTo>
                        <a:pt x="243" y="108"/>
                      </a:lnTo>
                      <a:lnTo>
                        <a:pt x="247" y="108"/>
                      </a:lnTo>
                      <a:lnTo>
                        <a:pt x="247" y="108"/>
                      </a:lnTo>
                      <a:lnTo>
                        <a:pt x="253" y="108"/>
                      </a:lnTo>
                      <a:lnTo>
                        <a:pt x="253" y="108"/>
                      </a:lnTo>
                      <a:lnTo>
                        <a:pt x="254" y="108"/>
                      </a:lnTo>
                      <a:lnTo>
                        <a:pt x="254" y="108"/>
                      </a:lnTo>
                      <a:lnTo>
                        <a:pt x="271" y="108"/>
                      </a:lnTo>
                      <a:lnTo>
                        <a:pt x="271" y="108"/>
                      </a:lnTo>
                      <a:lnTo>
                        <a:pt x="275" y="108"/>
                      </a:lnTo>
                      <a:lnTo>
                        <a:pt x="275" y="108"/>
                      </a:lnTo>
                      <a:lnTo>
                        <a:pt x="279" y="108"/>
                      </a:lnTo>
                      <a:lnTo>
                        <a:pt x="279" y="108"/>
                      </a:lnTo>
                      <a:lnTo>
                        <a:pt x="288" y="108"/>
                      </a:lnTo>
                      <a:lnTo>
                        <a:pt x="288" y="108"/>
                      </a:lnTo>
                      <a:lnTo>
                        <a:pt x="308" y="108"/>
                      </a:lnTo>
                      <a:lnTo>
                        <a:pt x="308" y="108"/>
                      </a:lnTo>
                      <a:lnTo>
                        <a:pt x="314" y="108"/>
                      </a:lnTo>
                      <a:lnTo>
                        <a:pt x="314" y="108"/>
                      </a:lnTo>
                      <a:lnTo>
                        <a:pt x="321" y="108"/>
                      </a:lnTo>
                      <a:lnTo>
                        <a:pt x="321" y="108"/>
                      </a:lnTo>
                      <a:lnTo>
                        <a:pt x="321" y="108"/>
                      </a:lnTo>
                      <a:lnTo>
                        <a:pt x="321" y="108"/>
                      </a:lnTo>
                      <a:lnTo>
                        <a:pt x="328" y="108"/>
                      </a:lnTo>
                      <a:lnTo>
                        <a:pt x="328" y="108"/>
                      </a:lnTo>
                      <a:lnTo>
                        <a:pt x="339" y="108"/>
                      </a:lnTo>
                      <a:lnTo>
                        <a:pt x="339" y="108"/>
                      </a:lnTo>
                      <a:lnTo>
                        <a:pt x="358" y="108"/>
                      </a:lnTo>
                      <a:lnTo>
                        <a:pt x="358" y="108"/>
                      </a:lnTo>
                      <a:lnTo>
                        <a:pt x="375" y="108"/>
                      </a:lnTo>
                      <a:lnTo>
                        <a:pt x="375" y="108"/>
                      </a:lnTo>
                    </a:path>
                  </a:pathLst>
                </a:custGeom>
                <a:noFill/>
                <a:ln w="12700" cap="flat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0" name="Freeform 156">
                  <a:extLst>
                    <a:ext uri="{FF2B5EF4-FFF2-40B4-BE49-F238E27FC236}">
                      <a16:creationId xmlns:a16="http://schemas.microsoft.com/office/drawing/2014/main" id="{521A5628-9D36-4BE3-9A50-18F672B8C67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808163" y="1198563"/>
                  <a:ext cx="2649538" cy="474662"/>
                </a:xfrm>
                <a:custGeom>
                  <a:avLst/>
                  <a:gdLst>
                    <a:gd name="T0" fmla="*/ 0 w 408"/>
                    <a:gd name="T1" fmla="*/ 0 h 59"/>
                    <a:gd name="T2" fmla="*/ 122 w 408"/>
                    <a:gd name="T3" fmla="*/ 0 h 59"/>
                    <a:gd name="T4" fmla="*/ 122 w 408"/>
                    <a:gd name="T5" fmla="*/ 0 h 59"/>
                    <a:gd name="T6" fmla="*/ 135 w 408"/>
                    <a:gd name="T7" fmla="*/ 0 h 59"/>
                    <a:gd name="T8" fmla="*/ 135 w 408"/>
                    <a:gd name="T9" fmla="*/ 0 h 59"/>
                    <a:gd name="T10" fmla="*/ 146 w 408"/>
                    <a:gd name="T11" fmla="*/ 0 h 59"/>
                    <a:gd name="T12" fmla="*/ 146 w 408"/>
                    <a:gd name="T13" fmla="*/ 22 h 59"/>
                    <a:gd name="T14" fmla="*/ 149 w 408"/>
                    <a:gd name="T15" fmla="*/ 22 h 59"/>
                    <a:gd name="T16" fmla="*/ 149 w 408"/>
                    <a:gd name="T17" fmla="*/ 22 h 59"/>
                    <a:gd name="T18" fmla="*/ 186 w 408"/>
                    <a:gd name="T19" fmla="*/ 22 h 59"/>
                    <a:gd name="T20" fmla="*/ 186 w 408"/>
                    <a:gd name="T21" fmla="*/ 22 h 59"/>
                    <a:gd name="T22" fmla="*/ 197 w 408"/>
                    <a:gd name="T23" fmla="*/ 22 h 59"/>
                    <a:gd name="T24" fmla="*/ 197 w 408"/>
                    <a:gd name="T25" fmla="*/ 22 h 59"/>
                    <a:gd name="T26" fmla="*/ 231 w 408"/>
                    <a:gd name="T27" fmla="*/ 22 h 59"/>
                    <a:gd name="T28" fmla="*/ 231 w 408"/>
                    <a:gd name="T29" fmla="*/ 22 h 59"/>
                    <a:gd name="T30" fmla="*/ 260 w 408"/>
                    <a:gd name="T31" fmla="*/ 22 h 59"/>
                    <a:gd name="T32" fmla="*/ 260 w 408"/>
                    <a:gd name="T33" fmla="*/ 22 h 59"/>
                    <a:gd name="T34" fmla="*/ 285 w 408"/>
                    <a:gd name="T35" fmla="*/ 22 h 59"/>
                    <a:gd name="T36" fmla="*/ 285 w 408"/>
                    <a:gd name="T37" fmla="*/ 59 h 59"/>
                    <a:gd name="T38" fmla="*/ 314 w 408"/>
                    <a:gd name="T39" fmla="*/ 59 h 59"/>
                    <a:gd name="T40" fmla="*/ 314 w 408"/>
                    <a:gd name="T41" fmla="*/ 59 h 59"/>
                    <a:gd name="T42" fmla="*/ 328 w 408"/>
                    <a:gd name="T43" fmla="*/ 59 h 59"/>
                    <a:gd name="T44" fmla="*/ 328 w 408"/>
                    <a:gd name="T45" fmla="*/ 59 h 59"/>
                    <a:gd name="T46" fmla="*/ 334 w 408"/>
                    <a:gd name="T47" fmla="*/ 59 h 59"/>
                    <a:gd name="T48" fmla="*/ 334 w 408"/>
                    <a:gd name="T49" fmla="*/ 59 h 59"/>
                    <a:gd name="T50" fmla="*/ 346 w 408"/>
                    <a:gd name="T51" fmla="*/ 59 h 59"/>
                    <a:gd name="T52" fmla="*/ 346 w 408"/>
                    <a:gd name="T53" fmla="*/ 59 h 59"/>
                    <a:gd name="T54" fmla="*/ 355 w 408"/>
                    <a:gd name="T55" fmla="*/ 59 h 59"/>
                    <a:gd name="T56" fmla="*/ 355 w 408"/>
                    <a:gd name="T57" fmla="*/ 59 h 59"/>
                    <a:gd name="T58" fmla="*/ 408 w 408"/>
                    <a:gd name="T59" fmla="*/ 59 h 59"/>
                    <a:gd name="T60" fmla="*/ 408 w 408"/>
                    <a:gd name="T61" fmla="*/ 59 h 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</a:cxnLst>
                  <a:rect l="0" t="0" r="r" b="b"/>
                  <a:pathLst>
                    <a:path w="408" h="59">
                      <a:moveTo>
                        <a:pt x="0" y="0"/>
                      </a:moveTo>
                      <a:lnTo>
                        <a:pt x="122" y="0"/>
                      </a:lnTo>
                      <a:lnTo>
                        <a:pt x="122" y="0"/>
                      </a:lnTo>
                      <a:lnTo>
                        <a:pt x="135" y="0"/>
                      </a:lnTo>
                      <a:lnTo>
                        <a:pt x="135" y="0"/>
                      </a:lnTo>
                      <a:lnTo>
                        <a:pt x="146" y="0"/>
                      </a:lnTo>
                      <a:lnTo>
                        <a:pt x="146" y="22"/>
                      </a:lnTo>
                      <a:lnTo>
                        <a:pt x="149" y="22"/>
                      </a:lnTo>
                      <a:lnTo>
                        <a:pt x="149" y="22"/>
                      </a:lnTo>
                      <a:lnTo>
                        <a:pt x="186" y="22"/>
                      </a:lnTo>
                      <a:lnTo>
                        <a:pt x="186" y="22"/>
                      </a:lnTo>
                      <a:lnTo>
                        <a:pt x="197" y="22"/>
                      </a:lnTo>
                      <a:lnTo>
                        <a:pt x="197" y="22"/>
                      </a:lnTo>
                      <a:lnTo>
                        <a:pt x="231" y="22"/>
                      </a:lnTo>
                      <a:lnTo>
                        <a:pt x="231" y="22"/>
                      </a:lnTo>
                      <a:lnTo>
                        <a:pt x="260" y="22"/>
                      </a:lnTo>
                      <a:lnTo>
                        <a:pt x="260" y="22"/>
                      </a:lnTo>
                      <a:lnTo>
                        <a:pt x="285" y="22"/>
                      </a:lnTo>
                      <a:lnTo>
                        <a:pt x="285" y="59"/>
                      </a:lnTo>
                      <a:lnTo>
                        <a:pt x="314" y="59"/>
                      </a:lnTo>
                      <a:lnTo>
                        <a:pt x="314" y="59"/>
                      </a:lnTo>
                      <a:lnTo>
                        <a:pt x="328" y="59"/>
                      </a:lnTo>
                      <a:lnTo>
                        <a:pt x="328" y="59"/>
                      </a:lnTo>
                      <a:lnTo>
                        <a:pt x="334" y="59"/>
                      </a:lnTo>
                      <a:lnTo>
                        <a:pt x="334" y="59"/>
                      </a:lnTo>
                      <a:lnTo>
                        <a:pt x="346" y="59"/>
                      </a:lnTo>
                      <a:lnTo>
                        <a:pt x="346" y="59"/>
                      </a:lnTo>
                      <a:lnTo>
                        <a:pt x="355" y="59"/>
                      </a:lnTo>
                      <a:lnTo>
                        <a:pt x="355" y="59"/>
                      </a:lnTo>
                      <a:lnTo>
                        <a:pt x="408" y="59"/>
                      </a:lnTo>
                      <a:lnTo>
                        <a:pt x="408" y="59"/>
                      </a:lnTo>
                    </a:path>
                  </a:pathLst>
                </a:custGeom>
                <a:noFill/>
                <a:ln w="12700" cap="flat">
                  <a:solidFill>
                    <a:srgbClr val="00FF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1" name="Rectangle 157">
                  <a:extLst>
                    <a:ext uri="{FF2B5EF4-FFF2-40B4-BE49-F238E27FC236}">
                      <a16:creationId xmlns:a16="http://schemas.microsoft.com/office/drawing/2014/main" id="{45EC6FC3-AC54-49CE-832C-1D7DC8B410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12950" y="2068513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2" name="Rectangle 158">
                  <a:extLst>
                    <a:ext uri="{FF2B5EF4-FFF2-40B4-BE49-F238E27FC236}">
                      <a16:creationId xmlns:a16="http://schemas.microsoft.com/office/drawing/2014/main" id="{12527A07-BB65-42B3-A5F0-E1F68E9BDA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49475" y="2366963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3" name="Rectangle 159">
                  <a:extLst>
                    <a:ext uri="{FF2B5EF4-FFF2-40B4-BE49-F238E27FC236}">
                      <a16:creationId xmlns:a16="http://schemas.microsoft.com/office/drawing/2014/main" id="{8563FBD5-3A9A-41CD-8AEC-AA578EA484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81225" y="2366963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4" name="Rectangle 160">
                  <a:extLst>
                    <a:ext uri="{FF2B5EF4-FFF2-40B4-BE49-F238E27FC236}">
                      <a16:creationId xmlns:a16="http://schemas.microsoft.com/office/drawing/2014/main" id="{A68E65FB-A19C-4A1C-A16C-36A96FCDE6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68650" y="3001963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5" name="Rectangle 161">
                  <a:extLst>
                    <a:ext uri="{FF2B5EF4-FFF2-40B4-BE49-F238E27FC236}">
                      <a16:creationId xmlns:a16="http://schemas.microsoft.com/office/drawing/2014/main" id="{87D6134F-BA83-453B-BDA7-EC8842FF19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92500" y="3001963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6" name="Rectangle 162">
                  <a:extLst>
                    <a:ext uri="{FF2B5EF4-FFF2-40B4-BE49-F238E27FC236}">
                      <a16:creationId xmlns:a16="http://schemas.microsoft.com/office/drawing/2014/main" id="{374F8D68-FE40-42FD-B3D1-C906205BE1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70075" y="1166813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7" name="Rectangle 163">
                  <a:extLst>
                    <a:ext uri="{FF2B5EF4-FFF2-40B4-BE49-F238E27FC236}">
                      <a16:creationId xmlns:a16="http://schemas.microsoft.com/office/drawing/2014/main" id="{D6BD2EEF-F9B9-4E88-9010-4756BC169B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89125" y="1166813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8" name="Rectangle 164">
                  <a:extLst>
                    <a:ext uri="{FF2B5EF4-FFF2-40B4-BE49-F238E27FC236}">
                      <a16:creationId xmlns:a16="http://schemas.microsoft.com/office/drawing/2014/main" id="{56025B21-79D7-41C7-8E0C-FE448E1D82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16138" y="14493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9" name="Rectangle 165">
                  <a:extLst>
                    <a:ext uri="{FF2B5EF4-FFF2-40B4-BE49-F238E27FC236}">
                      <a16:creationId xmlns:a16="http://schemas.microsoft.com/office/drawing/2014/main" id="{7E6F7E7D-5A6C-4A84-B6A8-8F1745E5D1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128838" y="14493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0" name="Rectangle 166">
                  <a:extLst>
                    <a:ext uri="{FF2B5EF4-FFF2-40B4-BE49-F238E27FC236}">
                      <a16:creationId xmlns:a16="http://schemas.microsoft.com/office/drawing/2014/main" id="{D5BFA976-B891-41AA-84F5-045A79142E2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09913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1" name="Rectangle 167">
                  <a:extLst>
                    <a:ext uri="{FF2B5EF4-FFF2-40B4-BE49-F238E27FC236}">
                      <a16:creationId xmlns:a16="http://schemas.microsoft.com/office/drawing/2014/main" id="{4A6A8242-475D-4810-A622-864454B0D2D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6865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2" name="Rectangle 168">
                  <a:extLst>
                    <a:ext uri="{FF2B5EF4-FFF2-40B4-BE49-F238E27FC236}">
                      <a16:creationId xmlns:a16="http://schemas.microsoft.com/office/drawing/2014/main" id="{1D5E24F1-7A00-491F-AE08-BCC9BA161DA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500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3" name="Rectangle 169">
                  <a:extLst>
                    <a:ext uri="{FF2B5EF4-FFF2-40B4-BE49-F238E27FC236}">
                      <a16:creationId xmlns:a16="http://schemas.microsoft.com/office/drawing/2014/main" id="{560C99C4-949B-443D-A0E5-FE441B47CE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500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4" name="Rectangle 170">
                  <a:extLst>
                    <a:ext uri="{FF2B5EF4-FFF2-40B4-BE49-F238E27FC236}">
                      <a16:creationId xmlns:a16="http://schemas.microsoft.com/office/drawing/2014/main" id="{7AA97076-E5DA-4EA7-9897-7951AAC760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770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5" name="Rectangle 171">
                  <a:extLst>
                    <a:ext uri="{FF2B5EF4-FFF2-40B4-BE49-F238E27FC236}">
                      <a16:creationId xmlns:a16="http://schemas.microsoft.com/office/drawing/2014/main" id="{7A25BDE3-4CC2-4626-ABF3-7FE9CC08FB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9405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6" name="Rectangle 172">
                  <a:extLst>
                    <a:ext uri="{FF2B5EF4-FFF2-40B4-BE49-F238E27FC236}">
                      <a16:creationId xmlns:a16="http://schemas.microsoft.com/office/drawing/2014/main" id="{1391567D-859D-490E-827B-5954E70973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0040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7" name="Rectangle 173">
                  <a:extLst>
                    <a:ext uri="{FF2B5EF4-FFF2-40B4-BE49-F238E27FC236}">
                      <a16:creationId xmlns:a16="http://schemas.microsoft.com/office/drawing/2014/main" id="{854D1DCA-871F-4EB6-8875-1FF53FE417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2103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8" name="Rectangle 174">
                  <a:extLst>
                    <a:ext uri="{FF2B5EF4-FFF2-40B4-BE49-F238E27FC236}">
                      <a16:creationId xmlns:a16="http://schemas.microsoft.com/office/drawing/2014/main" id="{F65D5341-546C-4205-92D6-F98804903B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5913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9" name="Rectangle 175">
                  <a:extLst>
                    <a:ext uri="{FF2B5EF4-FFF2-40B4-BE49-F238E27FC236}">
                      <a16:creationId xmlns:a16="http://schemas.microsoft.com/office/drawing/2014/main" id="{E02C143F-D1DB-43E6-B9A0-FC14071B3BF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6548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0" name="Rectangle 176">
                  <a:extLst>
                    <a:ext uri="{FF2B5EF4-FFF2-40B4-BE49-F238E27FC236}">
                      <a16:creationId xmlns:a16="http://schemas.microsoft.com/office/drawing/2014/main" id="{EB3F4DE7-192B-4293-A108-C94A7135686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7183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1" name="Rectangle 177">
                  <a:extLst>
                    <a:ext uri="{FF2B5EF4-FFF2-40B4-BE49-F238E27FC236}">
                      <a16:creationId xmlns:a16="http://schemas.microsoft.com/office/drawing/2014/main" id="{1E33A1FC-5AE8-4145-905D-02AF71E867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11525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2" name="Rectangle 178">
                  <a:extLst>
                    <a:ext uri="{FF2B5EF4-FFF2-40B4-BE49-F238E27FC236}">
                      <a16:creationId xmlns:a16="http://schemas.microsoft.com/office/drawing/2014/main" id="{CB301470-8F5B-4AF2-95AF-74858A528B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24225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3" name="Rectangle 179">
                  <a:extLst>
                    <a:ext uri="{FF2B5EF4-FFF2-40B4-BE49-F238E27FC236}">
                      <a16:creationId xmlns:a16="http://schemas.microsoft.com/office/drawing/2014/main" id="{1D6E2019-BDAD-44CA-95B8-027741664D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49625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4" name="Rectangle 180">
                  <a:extLst>
                    <a:ext uri="{FF2B5EF4-FFF2-40B4-BE49-F238E27FC236}">
                      <a16:creationId xmlns:a16="http://schemas.microsoft.com/office/drawing/2014/main" id="{07DEB60C-6781-4165-8198-A46F20D82E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89313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5" name="Rectangle 181">
                  <a:extLst>
                    <a:ext uri="{FF2B5EF4-FFF2-40B4-BE49-F238E27FC236}">
                      <a16:creationId xmlns:a16="http://schemas.microsoft.com/office/drawing/2014/main" id="{C3CFF355-4E89-4454-BD2E-B71D5A7245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395663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6" name="Rectangle 182">
                  <a:extLst>
                    <a:ext uri="{FF2B5EF4-FFF2-40B4-BE49-F238E27FC236}">
                      <a16:creationId xmlns:a16="http://schemas.microsoft.com/office/drawing/2014/main" id="{4839A89E-E0A3-46BC-A7CE-D828718E0B8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0678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7" name="Rectangle 183">
                  <a:extLst>
                    <a:ext uri="{FF2B5EF4-FFF2-40B4-BE49-F238E27FC236}">
                      <a16:creationId xmlns:a16="http://schemas.microsoft.com/office/drawing/2014/main" id="{22CD7A44-19D9-4C83-8852-5F5552B5DA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3218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8" name="Rectangle 184">
                  <a:extLst>
                    <a:ext uri="{FF2B5EF4-FFF2-40B4-BE49-F238E27FC236}">
                      <a16:creationId xmlns:a16="http://schemas.microsoft.com/office/drawing/2014/main" id="{BEEC6A54-4744-4582-94EA-0BC6D1F593E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55758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9" name="Rectangle 185">
                  <a:extLst>
                    <a:ext uri="{FF2B5EF4-FFF2-40B4-BE49-F238E27FC236}">
                      <a16:creationId xmlns:a16="http://schemas.microsoft.com/office/drawing/2014/main" id="{04397A0C-D43F-4CA5-8D77-46F5A4A919A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616325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0" name="Rectangle 186">
                  <a:extLst>
                    <a:ext uri="{FF2B5EF4-FFF2-40B4-BE49-F238E27FC236}">
                      <a16:creationId xmlns:a16="http://schemas.microsoft.com/office/drawing/2014/main" id="{6CAD45F4-4487-4D72-A8F6-5129DE5C05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4650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1" name="Rectangle 187">
                  <a:extLst>
                    <a:ext uri="{FF2B5EF4-FFF2-40B4-BE49-F238E27FC236}">
                      <a16:creationId xmlns:a16="http://schemas.microsoft.com/office/drawing/2014/main" id="{A840CC97-EF53-495F-97FE-A50AB4C65D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8460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2" name="Rectangle 188">
                  <a:extLst>
                    <a:ext uri="{FF2B5EF4-FFF2-40B4-BE49-F238E27FC236}">
                      <a16:creationId xmlns:a16="http://schemas.microsoft.com/office/drawing/2014/main" id="{F32B47D7-08B4-45D0-8E1C-07178A41A7C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3063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3" name="Rectangle 189">
                  <a:extLst>
                    <a:ext uri="{FF2B5EF4-FFF2-40B4-BE49-F238E27FC236}">
                      <a16:creationId xmlns:a16="http://schemas.microsoft.com/office/drawing/2014/main" id="{B843A37C-0FCC-4B87-A50B-5B29F18371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30638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4" name="Rectangle 190">
                  <a:extLst>
                    <a:ext uri="{FF2B5EF4-FFF2-40B4-BE49-F238E27FC236}">
                      <a16:creationId xmlns:a16="http://schemas.microsoft.com/office/drawing/2014/main" id="{8E9C0560-9B19-4A94-8EDC-4A3EE606C3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76675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5" name="Rectangle 191">
                  <a:extLst>
                    <a:ext uri="{FF2B5EF4-FFF2-40B4-BE49-F238E27FC236}">
                      <a16:creationId xmlns:a16="http://schemas.microsoft.com/office/drawing/2014/main" id="{464D9557-6317-451C-A511-C3CB3CE149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48113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6" name="Rectangle 192">
                  <a:extLst>
                    <a:ext uri="{FF2B5EF4-FFF2-40B4-BE49-F238E27FC236}">
                      <a16:creationId xmlns:a16="http://schemas.microsoft.com/office/drawing/2014/main" id="{E3E1F158-7F15-4D60-BA27-AB4BB3E84B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70350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7" name="Rectangle 193">
                  <a:extLst>
                    <a:ext uri="{FF2B5EF4-FFF2-40B4-BE49-F238E27FC236}">
                      <a16:creationId xmlns:a16="http://schemas.microsoft.com/office/drawing/2014/main" id="{16B27A31-07D9-4E3D-A961-34CB866972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81475" y="198755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8" name="Rectangle 194">
                  <a:extLst>
                    <a:ext uri="{FF2B5EF4-FFF2-40B4-BE49-F238E27FC236}">
                      <a16:creationId xmlns:a16="http://schemas.microsoft.com/office/drawing/2014/main" id="{9EDB970A-6908-4DAB-A551-65AAAA679BA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538413" y="11191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9" name="Rectangle 195">
                  <a:extLst>
                    <a:ext uri="{FF2B5EF4-FFF2-40B4-BE49-F238E27FC236}">
                      <a16:creationId xmlns:a16="http://schemas.microsoft.com/office/drawing/2014/main" id="{625E9647-9BB9-47F2-A8DA-11268BEF1BB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622550" y="11191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0" name="Rectangle 196">
                  <a:extLst>
                    <a:ext uri="{FF2B5EF4-FFF2-40B4-BE49-F238E27FC236}">
                      <a16:creationId xmlns:a16="http://schemas.microsoft.com/office/drawing/2014/main" id="{CA5B5933-1ABF-4819-A99E-36D57456C2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14625" y="129540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1" name="Rectangle 197">
                  <a:extLst>
                    <a:ext uri="{FF2B5EF4-FFF2-40B4-BE49-F238E27FC236}">
                      <a16:creationId xmlns:a16="http://schemas.microsoft.com/office/drawing/2014/main" id="{53609FA6-8E8C-474B-8D7F-BF75523131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954338" y="129540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2" name="Rectangle 198">
                  <a:extLst>
                    <a:ext uri="{FF2B5EF4-FFF2-40B4-BE49-F238E27FC236}">
                      <a16:creationId xmlns:a16="http://schemas.microsoft.com/office/drawing/2014/main" id="{2243C710-1767-47E3-9FB5-D9C1435C3F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25775" y="129540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3" name="Rectangle 199">
                  <a:extLst>
                    <a:ext uri="{FF2B5EF4-FFF2-40B4-BE49-F238E27FC236}">
                      <a16:creationId xmlns:a16="http://schemas.microsoft.com/office/drawing/2014/main" id="{598024EA-E6C5-4879-BAA8-BCB391CBBE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246438" y="129540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4" name="Rectangle 200">
                  <a:extLst>
                    <a:ext uri="{FF2B5EF4-FFF2-40B4-BE49-F238E27FC236}">
                      <a16:creationId xmlns:a16="http://schemas.microsoft.com/office/drawing/2014/main" id="{B234D30C-F2F2-48FE-B3A9-E6CA74D0A0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435350" y="1295400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5" name="Rectangle 201">
                  <a:extLst>
                    <a:ext uri="{FF2B5EF4-FFF2-40B4-BE49-F238E27FC236}">
                      <a16:creationId xmlns:a16="http://schemas.microsoft.com/office/drawing/2014/main" id="{988BB52D-3101-40F5-B075-F4D8A4CA5F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84600" y="16017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6" name="Rectangle 202">
                  <a:extLst>
                    <a:ext uri="{FF2B5EF4-FFF2-40B4-BE49-F238E27FC236}">
                      <a16:creationId xmlns:a16="http://schemas.microsoft.com/office/drawing/2014/main" id="{8B854402-AE42-483F-9272-DDCC7DCBD5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76675" y="16017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7" name="Rectangle 203">
                  <a:extLst>
                    <a:ext uri="{FF2B5EF4-FFF2-40B4-BE49-F238E27FC236}">
                      <a16:creationId xmlns:a16="http://schemas.microsoft.com/office/drawing/2014/main" id="{D62D212B-D1DB-4A06-9D50-B670CF219C2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14775" y="16017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8" name="Rectangle 204">
                  <a:extLst>
                    <a:ext uri="{FF2B5EF4-FFF2-40B4-BE49-F238E27FC236}">
                      <a16:creationId xmlns:a16="http://schemas.microsoft.com/office/drawing/2014/main" id="{A4643261-4B86-4A18-8E58-C4A2E08981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92563" y="16017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9" name="Rectangle 205">
                  <a:extLst>
                    <a:ext uri="{FF2B5EF4-FFF2-40B4-BE49-F238E27FC236}">
                      <a16:creationId xmlns:a16="http://schemas.microsoft.com/office/drawing/2014/main" id="{595EDD15-F50C-43F2-A4BB-11B86AF8F3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51300" y="16017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0" name="Rectangle 206">
                  <a:extLst>
                    <a:ext uri="{FF2B5EF4-FFF2-40B4-BE49-F238E27FC236}">
                      <a16:creationId xmlns:a16="http://schemas.microsoft.com/office/drawing/2014/main" id="{7F1C8700-EBE0-4E65-871E-43FD0D101D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395788" y="1601788"/>
                  <a:ext cx="123825" cy="2016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1" name="Rectangle 207">
                  <a:extLst>
                    <a:ext uri="{FF2B5EF4-FFF2-40B4-BE49-F238E27FC236}">
                      <a16:creationId xmlns:a16="http://schemas.microsoft.com/office/drawing/2014/main" id="{6AE33F0C-B5F5-43CB-80B6-952269986D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96149" y="3407858"/>
                  <a:ext cx="699159" cy="1761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 &lt; 0.0001</a:t>
                  </a:r>
                  <a:endParaRPr kumimoji="0" lang="fr-FR" altLang="fr-FR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2" name="Line 208">
                  <a:extLst>
                    <a:ext uri="{FF2B5EF4-FFF2-40B4-BE49-F238E27FC236}">
                      <a16:creationId xmlns:a16="http://schemas.microsoft.com/office/drawing/2014/main" id="{98EC478D-4A71-4330-85C5-8294197C9CC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665288" y="1077913"/>
                  <a:ext cx="0" cy="2535237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3" name="Rectangle 209">
                  <a:extLst>
                    <a:ext uri="{FF2B5EF4-FFF2-40B4-BE49-F238E27FC236}">
                      <a16:creationId xmlns:a16="http://schemas.microsoft.com/office/drawing/2014/main" id="{028F4C19-AE62-4AE3-9DF0-8CECA9B71BD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52550" y="3444875"/>
                  <a:ext cx="260350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0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4" name="Rectangle 210">
                  <a:extLst>
                    <a:ext uri="{FF2B5EF4-FFF2-40B4-BE49-F238E27FC236}">
                      <a16:creationId xmlns:a16="http://schemas.microsoft.com/office/drawing/2014/main" id="{4592BA3F-ABAC-447C-B7E3-12B440322A7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52550" y="2873375"/>
                  <a:ext cx="260350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25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5" name="Rectangle 211">
                  <a:extLst>
                    <a:ext uri="{FF2B5EF4-FFF2-40B4-BE49-F238E27FC236}">
                      <a16:creationId xmlns:a16="http://schemas.microsoft.com/office/drawing/2014/main" id="{DB88E40D-1FA5-4B55-970A-C2E0A5E518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52550" y="2293938"/>
                  <a:ext cx="260350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5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6" name="Rectangle 212">
                  <a:extLst>
                    <a:ext uri="{FF2B5EF4-FFF2-40B4-BE49-F238E27FC236}">
                      <a16:creationId xmlns:a16="http://schemas.microsoft.com/office/drawing/2014/main" id="{79B53624-98F6-4516-AE3A-4A7D54A932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52550" y="1722438"/>
                  <a:ext cx="260350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75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7" name="Rectangle 213">
                  <a:extLst>
                    <a:ext uri="{FF2B5EF4-FFF2-40B4-BE49-F238E27FC236}">
                      <a16:creationId xmlns:a16="http://schemas.microsoft.com/office/drawing/2014/main" id="{29CD6D36-1066-4067-A4D3-EC89D4BBDD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52550" y="1143000"/>
                  <a:ext cx="260350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.0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8" name="Line 214">
                  <a:extLst>
                    <a:ext uri="{FF2B5EF4-FFF2-40B4-BE49-F238E27FC236}">
                      <a16:creationId xmlns:a16="http://schemas.microsoft.com/office/drawing/2014/main" id="{ED61F94A-4C83-4F9B-8F10-F6B561E0D1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39888" y="3500438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9" name="Line 215">
                  <a:extLst>
                    <a:ext uri="{FF2B5EF4-FFF2-40B4-BE49-F238E27FC236}">
                      <a16:creationId xmlns:a16="http://schemas.microsoft.com/office/drawing/2014/main" id="{D6AE9227-564B-4877-9FBB-D97BAA3A1F9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39888" y="2921000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0" name="Line 216">
                  <a:extLst>
                    <a:ext uri="{FF2B5EF4-FFF2-40B4-BE49-F238E27FC236}">
                      <a16:creationId xmlns:a16="http://schemas.microsoft.com/office/drawing/2014/main" id="{6CAC5CE3-82E3-4004-B5F3-8D41667BD7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39888" y="2349500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1" name="Line 217">
                  <a:extLst>
                    <a:ext uri="{FF2B5EF4-FFF2-40B4-BE49-F238E27FC236}">
                      <a16:creationId xmlns:a16="http://schemas.microsoft.com/office/drawing/2014/main" id="{8A07176B-3A3A-4B35-8CE6-CAAD02BE9EF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39888" y="1770063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2" name="Line 218">
                  <a:extLst>
                    <a:ext uri="{FF2B5EF4-FFF2-40B4-BE49-F238E27FC236}">
                      <a16:creationId xmlns:a16="http://schemas.microsoft.com/office/drawing/2014/main" id="{89FE0E87-1B40-45CF-B68C-65C45C0481C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39888" y="1198563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3" name="Line 219">
                  <a:extLst>
                    <a:ext uri="{FF2B5EF4-FFF2-40B4-BE49-F238E27FC236}">
                      <a16:creationId xmlns:a16="http://schemas.microsoft.com/office/drawing/2014/main" id="{8D40DBB9-DB57-4DEF-9751-55F3477FCE1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65288" y="3613150"/>
                  <a:ext cx="3136900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4" name="Line 220">
                  <a:extLst>
                    <a:ext uri="{FF2B5EF4-FFF2-40B4-BE49-F238E27FC236}">
                      <a16:creationId xmlns:a16="http://schemas.microsoft.com/office/drawing/2014/main" id="{3DB5433D-4C51-4407-B860-766E4867C11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808163" y="3613150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5" name="Line 221">
                  <a:extLst>
                    <a:ext uri="{FF2B5EF4-FFF2-40B4-BE49-F238E27FC236}">
                      <a16:creationId xmlns:a16="http://schemas.microsoft.com/office/drawing/2014/main" id="{BE356CA0-2C7B-462C-AE3F-7C7083F94B9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516188" y="3613150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6" name="Line 222">
                  <a:extLst>
                    <a:ext uri="{FF2B5EF4-FFF2-40B4-BE49-F238E27FC236}">
                      <a16:creationId xmlns:a16="http://schemas.microsoft.com/office/drawing/2014/main" id="{480B3D0C-B242-4F30-8A06-68A91A2F59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230563" y="3613150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7" name="Line 223">
                  <a:extLst>
                    <a:ext uri="{FF2B5EF4-FFF2-40B4-BE49-F238E27FC236}">
                      <a16:creationId xmlns:a16="http://schemas.microsoft.com/office/drawing/2014/main" id="{915A1D3D-5DFC-4CAF-9C32-B82005549B2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44938" y="3613150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8" name="Line 224">
                  <a:extLst>
                    <a:ext uri="{FF2B5EF4-FFF2-40B4-BE49-F238E27FC236}">
                      <a16:creationId xmlns:a16="http://schemas.microsoft.com/office/drawing/2014/main" id="{C4FE7025-DCFD-456E-9457-0E719E59CDE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659313" y="3613150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9" name="Rectangle 225">
                  <a:extLst>
                    <a:ext uri="{FF2B5EF4-FFF2-40B4-BE49-F238E27FC236}">
                      <a16:creationId xmlns:a16="http://schemas.microsoft.com/office/drawing/2014/main" id="{87030781-50EC-4A0B-B3AA-019C3FBD10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52600" y="3670300"/>
                  <a:ext cx="111125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0" name="Rectangle 226">
                  <a:extLst>
                    <a:ext uri="{FF2B5EF4-FFF2-40B4-BE49-F238E27FC236}">
                      <a16:creationId xmlns:a16="http://schemas.microsoft.com/office/drawing/2014/main" id="{CE620EE2-4162-49D9-BCC6-75522160C3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32050" y="3670300"/>
                  <a:ext cx="168275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1" name="Rectangle 227">
                  <a:extLst>
                    <a:ext uri="{FF2B5EF4-FFF2-40B4-BE49-F238E27FC236}">
                      <a16:creationId xmlns:a16="http://schemas.microsoft.com/office/drawing/2014/main" id="{6063381A-CC93-457C-9346-1A2DCA6BCC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46425" y="3670300"/>
                  <a:ext cx="168275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2" name="Rectangle 228">
                  <a:extLst>
                    <a:ext uri="{FF2B5EF4-FFF2-40B4-BE49-F238E27FC236}">
                      <a16:creationId xmlns:a16="http://schemas.microsoft.com/office/drawing/2014/main" id="{727F73B6-25C3-427D-9B31-43A030FDE9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60800" y="3670300"/>
                  <a:ext cx="168275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9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3" name="Rectangle 229">
                  <a:extLst>
                    <a:ext uri="{FF2B5EF4-FFF2-40B4-BE49-F238E27FC236}">
                      <a16:creationId xmlns:a16="http://schemas.microsoft.com/office/drawing/2014/main" id="{37CCC91A-4873-4CA5-9245-6DBEEFF768A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43425" y="3670300"/>
                  <a:ext cx="231775" cy="1857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4" name="Rectangle 231">
                  <a:extLst>
                    <a:ext uri="{FF2B5EF4-FFF2-40B4-BE49-F238E27FC236}">
                      <a16:creationId xmlns:a16="http://schemas.microsoft.com/office/drawing/2014/main" id="{2BAE83FA-6D2D-43D7-AB60-8855122C859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104716" y="2247900"/>
                  <a:ext cx="225425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OS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5" name="Rectangle 248">
                  <a:extLst>
                    <a:ext uri="{FF2B5EF4-FFF2-40B4-BE49-F238E27FC236}">
                      <a16:creationId xmlns:a16="http://schemas.microsoft.com/office/drawing/2014/main" id="{FC5D5066-95D6-49EB-A71E-81A321A38B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65288" y="3951012"/>
                  <a:ext cx="3136900" cy="650078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600"/>
                </a:p>
              </p:txBody>
            </p:sp>
            <p:sp>
              <p:nvSpPr>
                <p:cNvPr id="226" name="Rectangle 249">
                  <a:extLst>
                    <a:ext uri="{FF2B5EF4-FFF2-40B4-BE49-F238E27FC236}">
                      <a16:creationId xmlns:a16="http://schemas.microsoft.com/office/drawing/2014/main" id="{E2CE707A-221A-4B4A-93C9-AB4488486A8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24025" y="3962875"/>
                  <a:ext cx="15068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7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7" name="Rectangle 250">
                  <a:extLst>
                    <a:ext uri="{FF2B5EF4-FFF2-40B4-BE49-F238E27FC236}">
                      <a16:creationId xmlns:a16="http://schemas.microsoft.com/office/drawing/2014/main" id="{36DFF94F-F861-4BA8-9804-3890F32B3B3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60625" y="3962875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8" name="Rectangle 251">
                  <a:extLst>
                    <a:ext uri="{FF2B5EF4-FFF2-40B4-BE49-F238E27FC236}">
                      <a16:creationId xmlns:a16="http://schemas.microsoft.com/office/drawing/2014/main" id="{C904181B-617F-415A-818A-E1B5B4E564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5000" y="3962875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</a:t>
                  </a:r>
                  <a:endParaRPr kumimoji="0" lang="fr-FR" altLang="fr-FR" sz="16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29" name="Rectangle 252">
                  <a:extLst>
                    <a:ext uri="{FF2B5EF4-FFF2-40B4-BE49-F238E27FC236}">
                      <a16:creationId xmlns:a16="http://schemas.microsoft.com/office/drawing/2014/main" id="{1929BE38-2A92-4B98-8142-89855DAD99B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89375" y="3962875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0" name="Rectangle 253">
                  <a:extLst>
                    <a:ext uri="{FF2B5EF4-FFF2-40B4-BE49-F238E27FC236}">
                      <a16:creationId xmlns:a16="http://schemas.microsoft.com/office/drawing/2014/main" id="{822B0E7F-5ADF-4534-BE30-56CC91988B1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03750" y="3962875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1" name="Rectangle 254">
                  <a:extLst>
                    <a:ext uri="{FF2B5EF4-FFF2-40B4-BE49-F238E27FC236}">
                      <a16:creationId xmlns:a16="http://schemas.microsoft.com/office/drawing/2014/main" id="{D94CEB87-3DDC-4AC1-A351-E69D36A761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24025" y="4107600"/>
                  <a:ext cx="15068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2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2" name="Rectangle 255">
                  <a:extLst>
                    <a:ext uri="{FF2B5EF4-FFF2-40B4-BE49-F238E27FC236}">
                      <a16:creationId xmlns:a16="http://schemas.microsoft.com/office/drawing/2014/main" id="{F0024E99-471A-4B50-BE5D-6F7F1A689A0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60625" y="4107600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3" name="Rectangle 256">
                  <a:extLst>
                    <a:ext uri="{FF2B5EF4-FFF2-40B4-BE49-F238E27FC236}">
                      <a16:creationId xmlns:a16="http://schemas.microsoft.com/office/drawing/2014/main" id="{BAF4DFE6-DA7A-44D5-A9D6-8AE9A2A046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5000" y="4107600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4" name="Rectangle 257">
                  <a:extLst>
                    <a:ext uri="{FF2B5EF4-FFF2-40B4-BE49-F238E27FC236}">
                      <a16:creationId xmlns:a16="http://schemas.microsoft.com/office/drawing/2014/main" id="{BDA116B7-DCA9-4343-8319-A22185A1C7C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89375" y="4107600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5" name="Rectangle 258">
                  <a:extLst>
                    <a:ext uri="{FF2B5EF4-FFF2-40B4-BE49-F238E27FC236}">
                      <a16:creationId xmlns:a16="http://schemas.microsoft.com/office/drawing/2014/main" id="{FAA91536-AF6A-4A8C-B018-1D2E55878A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03750" y="4107600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6" name="Rectangle 259">
                  <a:extLst>
                    <a:ext uri="{FF2B5EF4-FFF2-40B4-BE49-F238E27FC236}">
                      <a16:creationId xmlns:a16="http://schemas.microsoft.com/office/drawing/2014/main" id="{C421EF21-10CB-415C-9361-219DAFC2808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24025" y="4264188"/>
                  <a:ext cx="15068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51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7" name="Rectangle 260">
                  <a:extLst>
                    <a:ext uri="{FF2B5EF4-FFF2-40B4-BE49-F238E27FC236}">
                      <a16:creationId xmlns:a16="http://schemas.microsoft.com/office/drawing/2014/main" id="{212EE018-C82E-426D-BD95-7F2357A000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32050" y="4264188"/>
                  <a:ext cx="15068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5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8" name="Rectangle 261">
                  <a:extLst>
                    <a:ext uri="{FF2B5EF4-FFF2-40B4-BE49-F238E27FC236}">
                      <a16:creationId xmlns:a16="http://schemas.microsoft.com/office/drawing/2014/main" id="{018C3DBE-486F-419E-BD58-60A41F13F3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46425" y="4264188"/>
                  <a:ext cx="15068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6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39" name="Rectangle 262">
                  <a:extLst>
                    <a:ext uri="{FF2B5EF4-FFF2-40B4-BE49-F238E27FC236}">
                      <a16:creationId xmlns:a16="http://schemas.microsoft.com/office/drawing/2014/main" id="{EA7D74C5-D7AE-43B6-8BB2-62B3741EF7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89375" y="4264188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0" name="Rectangle 263">
                  <a:extLst>
                    <a:ext uri="{FF2B5EF4-FFF2-40B4-BE49-F238E27FC236}">
                      <a16:creationId xmlns:a16="http://schemas.microsoft.com/office/drawing/2014/main" id="{1007ECAE-71C7-4BC1-AAF3-272C0FB3E8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03750" y="4264188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1" name="Rectangle 264">
                  <a:extLst>
                    <a:ext uri="{FF2B5EF4-FFF2-40B4-BE49-F238E27FC236}">
                      <a16:creationId xmlns:a16="http://schemas.microsoft.com/office/drawing/2014/main" id="{3E63DC0E-078E-4CB4-8F66-0BCB5543295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24025" y="4420777"/>
                  <a:ext cx="15068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2" name="Rectangle 265">
                  <a:extLst>
                    <a:ext uri="{FF2B5EF4-FFF2-40B4-BE49-F238E27FC236}">
                      <a16:creationId xmlns:a16="http://schemas.microsoft.com/office/drawing/2014/main" id="{14D88346-56F7-4411-9489-F26893A455A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32050" y="4420777"/>
                  <a:ext cx="15068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5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3" name="Rectangle 266">
                  <a:extLst>
                    <a:ext uri="{FF2B5EF4-FFF2-40B4-BE49-F238E27FC236}">
                      <a16:creationId xmlns:a16="http://schemas.microsoft.com/office/drawing/2014/main" id="{99FD47FC-DC18-4AF9-835F-ACD3FCD1AC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75000" y="4420777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9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4" name="Rectangle 267">
                  <a:extLst>
                    <a:ext uri="{FF2B5EF4-FFF2-40B4-BE49-F238E27FC236}">
                      <a16:creationId xmlns:a16="http://schemas.microsoft.com/office/drawing/2014/main" id="{08323DE2-411A-46C1-8096-2195DB37B0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89375" y="4420777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5" name="Rectangle 268">
                  <a:extLst>
                    <a:ext uri="{FF2B5EF4-FFF2-40B4-BE49-F238E27FC236}">
                      <a16:creationId xmlns:a16="http://schemas.microsoft.com/office/drawing/2014/main" id="{B5C31A72-8949-4A2B-82CC-B13301E5AD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03750" y="4420777"/>
                  <a:ext cx="75342" cy="161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6" name="Line 269">
                  <a:extLst>
                    <a:ext uri="{FF2B5EF4-FFF2-40B4-BE49-F238E27FC236}">
                      <a16:creationId xmlns:a16="http://schemas.microsoft.com/office/drawing/2014/main" id="{7A6D104D-3C19-4781-8700-AA280E40D6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611498" y="3951012"/>
                  <a:ext cx="0" cy="650078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/>
                </a:p>
              </p:txBody>
            </p:sp>
            <p:sp>
              <p:nvSpPr>
                <p:cNvPr id="247" name="Rectangle 270">
                  <a:extLst>
                    <a:ext uri="{FF2B5EF4-FFF2-40B4-BE49-F238E27FC236}">
                      <a16:creationId xmlns:a16="http://schemas.microsoft.com/office/drawing/2014/main" id="{D135EEBF-8D48-4026-A44F-318F0CA333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97957" y="4432640"/>
                  <a:ext cx="649217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Low 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g_TA</a:t>
                  </a: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48" name="Rectangle 271">
                  <a:extLst>
                    <a:ext uri="{FF2B5EF4-FFF2-40B4-BE49-F238E27FC236}">
                      <a16:creationId xmlns:a16="http://schemas.microsoft.com/office/drawing/2014/main" id="{4B76E2C2-D4F2-4A9D-AF34-3F24AB8D76F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27425" y="4276052"/>
                  <a:ext cx="719749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fr-FR" altLang="fr-FR" sz="1000" dirty="0">
                      <a:solidFill>
                        <a:srgbClr val="0000FF"/>
                      </a:solidFill>
                    </a:rPr>
                    <a:t>Lo</a:t>
                  </a: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</a:rPr>
                    <a:t>w 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FF"/>
                      </a:solidFill>
                      <a:effectLst/>
                    </a:rPr>
                    <a:t>g_ALT</a:t>
                  </a: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</a:rPr>
                    <a:t>+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249" name="Rectangle 272">
                  <a:extLst>
                    <a:ext uri="{FF2B5EF4-FFF2-40B4-BE49-F238E27FC236}">
                      <a16:creationId xmlns:a16="http://schemas.microsoft.com/office/drawing/2014/main" id="{AE535047-9023-4953-8709-DBD43D1F11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9103" y="4119464"/>
                  <a:ext cx="678071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High 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g_TA</a:t>
                  </a: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0" name="Rectangle 273">
                  <a:extLst>
                    <a:ext uri="{FF2B5EF4-FFF2-40B4-BE49-F238E27FC236}">
                      <a16:creationId xmlns:a16="http://schemas.microsoft.com/office/drawing/2014/main" id="{781F5E3D-556C-42C4-9CDF-27F49B7D82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98571" y="3974737"/>
                  <a:ext cx="748603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High 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g_ALT</a:t>
                  </a: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51" name="Line 274">
                  <a:extLst>
                    <a:ext uri="{FF2B5EF4-FFF2-40B4-BE49-F238E27FC236}">
                      <a16:creationId xmlns:a16="http://schemas.microsoft.com/office/drawing/2014/main" id="{079D077E-2D2B-4F34-9477-F2523C61A42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86098" y="4506188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/>
                </a:p>
              </p:txBody>
            </p:sp>
            <p:sp>
              <p:nvSpPr>
                <p:cNvPr id="252" name="Line 275">
                  <a:extLst>
                    <a:ext uri="{FF2B5EF4-FFF2-40B4-BE49-F238E27FC236}">
                      <a16:creationId xmlns:a16="http://schemas.microsoft.com/office/drawing/2014/main" id="{C74EDDEF-855F-496D-BCDE-B1175E3EDC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86098" y="4361464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/>
                </a:p>
              </p:txBody>
            </p:sp>
            <p:sp>
              <p:nvSpPr>
                <p:cNvPr id="253" name="Line 276">
                  <a:extLst>
                    <a:ext uri="{FF2B5EF4-FFF2-40B4-BE49-F238E27FC236}">
                      <a16:creationId xmlns:a16="http://schemas.microsoft.com/office/drawing/2014/main" id="{4E988564-36C5-4D4A-98CC-7257690CFD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86098" y="4204875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/>
                </a:p>
              </p:txBody>
            </p:sp>
            <p:sp>
              <p:nvSpPr>
                <p:cNvPr id="254" name="Line 277">
                  <a:extLst>
                    <a:ext uri="{FF2B5EF4-FFF2-40B4-BE49-F238E27FC236}">
                      <a16:creationId xmlns:a16="http://schemas.microsoft.com/office/drawing/2014/main" id="{969A37EE-E7CE-4CDB-ACB7-867CCDF98A0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586098" y="4048287"/>
                  <a:ext cx="25400" cy="0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/>
                </a:p>
              </p:txBody>
            </p:sp>
            <p:sp>
              <p:nvSpPr>
                <p:cNvPr id="255" name="Line 278">
                  <a:extLst>
                    <a:ext uri="{FF2B5EF4-FFF2-40B4-BE49-F238E27FC236}">
                      <a16:creationId xmlns:a16="http://schemas.microsoft.com/office/drawing/2014/main" id="{50D26055-D8EE-4CE0-8528-989EBF96CA2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65288" y="4601090"/>
                  <a:ext cx="3136900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600"/>
                </a:p>
              </p:txBody>
            </p:sp>
            <p:sp>
              <p:nvSpPr>
                <p:cNvPr id="256" name="Line 279">
                  <a:extLst>
                    <a:ext uri="{FF2B5EF4-FFF2-40B4-BE49-F238E27FC236}">
                      <a16:creationId xmlns:a16="http://schemas.microsoft.com/office/drawing/2014/main" id="{8C0CE02D-E361-42EA-AE0D-A53B5FAEDA0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808163" y="4601090"/>
                  <a:ext cx="0" cy="47451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600"/>
                </a:p>
              </p:txBody>
            </p:sp>
            <p:sp>
              <p:nvSpPr>
                <p:cNvPr id="257" name="Line 280">
                  <a:extLst>
                    <a:ext uri="{FF2B5EF4-FFF2-40B4-BE49-F238E27FC236}">
                      <a16:creationId xmlns:a16="http://schemas.microsoft.com/office/drawing/2014/main" id="{6A186A6E-D70F-4486-8172-D7EA381BD4A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516188" y="4601090"/>
                  <a:ext cx="0" cy="47451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600"/>
                </a:p>
              </p:txBody>
            </p:sp>
            <p:sp>
              <p:nvSpPr>
                <p:cNvPr id="258" name="Line 281">
                  <a:extLst>
                    <a:ext uri="{FF2B5EF4-FFF2-40B4-BE49-F238E27FC236}">
                      <a16:creationId xmlns:a16="http://schemas.microsoft.com/office/drawing/2014/main" id="{E46B6794-9BCE-46FB-AB42-F7B61739EB8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230563" y="4601090"/>
                  <a:ext cx="0" cy="47451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600"/>
                </a:p>
              </p:txBody>
            </p:sp>
            <p:sp>
              <p:nvSpPr>
                <p:cNvPr id="259" name="Line 282">
                  <a:extLst>
                    <a:ext uri="{FF2B5EF4-FFF2-40B4-BE49-F238E27FC236}">
                      <a16:creationId xmlns:a16="http://schemas.microsoft.com/office/drawing/2014/main" id="{03F8E6E9-5F24-40EC-9BA8-05A1C76EED5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944938" y="4601090"/>
                  <a:ext cx="0" cy="47451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600"/>
                </a:p>
              </p:txBody>
            </p:sp>
            <p:sp>
              <p:nvSpPr>
                <p:cNvPr id="260" name="Line 283">
                  <a:extLst>
                    <a:ext uri="{FF2B5EF4-FFF2-40B4-BE49-F238E27FC236}">
                      <a16:creationId xmlns:a16="http://schemas.microsoft.com/office/drawing/2014/main" id="{76F49C28-F0E8-4A87-935E-CA039DC4B5F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659313" y="4601090"/>
                  <a:ext cx="0" cy="47451"/>
                </a:xfrm>
                <a:prstGeom prst="line">
                  <a:avLst/>
                </a:prstGeom>
                <a:noFill/>
                <a:ln w="6350" cap="flat">
                  <a:solidFill>
                    <a:srgbClr val="333333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600"/>
                </a:p>
              </p:txBody>
            </p:sp>
            <p:sp>
              <p:nvSpPr>
                <p:cNvPr id="261" name="Rectangle 284">
                  <a:extLst>
                    <a:ext uri="{FF2B5EF4-FFF2-40B4-BE49-F238E27FC236}">
                      <a16:creationId xmlns:a16="http://schemas.microsoft.com/office/drawing/2014/main" id="{08558CE6-1545-4F43-9A5A-22B904D8D3A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52600" y="4686502"/>
                  <a:ext cx="64120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2" name="Rectangle 285">
                  <a:extLst>
                    <a:ext uri="{FF2B5EF4-FFF2-40B4-BE49-F238E27FC236}">
                      <a16:creationId xmlns:a16="http://schemas.microsoft.com/office/drawing/2014/main" id="{6A2B228D-E57F-4608-9A95-D66FAE523D1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432050" y="4686502"/>
                  <a:ext cx="128240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3" name="Rectangle 286">
                  <a:extLst>
                    <a:ext uri="{FF2B5EF4-FFF2-40B4-BE49-F238E27FC236}">
                      <a16:creationId xmlns:a16="http://schemas.microsoft.com/office/drawing/2014/main" id="{2861C8F9-24C9-40A8-B174-2DDCB061446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46425" y="4686502"/>
                  <a:ext cx="128240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4" name="Rectangle 287">
                  <a:extLst>
                    <a:ext uri="{FF2B5EF4-FFF2-40B4-BE49-F238E27FC236}">
                      <a16:creationId xmlns:a16="http://schemas.microsoft.com/office/drawing/2014/main" id="{F5830FF8-E922-4775-BF98-B319398D0A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860800" y="4686502"/>
                  <a:ext cx="128240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9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5" name="Rectangle 288">
                  <a:extLst>
                    <a:ext uri="{FF2B5EF4-FFF2-40B4-BE49-F238E27FC236}">
                      <a16:creationId xmlns:a16="http://schemas.microsoft.com/office/drawing/2014/main" id="{C0A32774-4530-4E16-9C5D-928AB35B47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43425" y="4686502"/>
                  <a:ext cx="192360" cy="1384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9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0</a:t>
                  </a:r>
                  <a:endParaRPr kumimoji="0" lang="fr-FR" altLang="fr-FR" sz="16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6" name="Rectangle 289">
                  <a:extLst>
                    <a:ext uri="{FF2B5EF4-FFF2-40B4-BE49-F238E27FC236}">
                      <a16:creationId xmlns:a16="http://schemas.microsoft.com/office/drawing/2014/main" id="{7EB4DEC2-E4C6-4EDE-B423-3B965588F7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003550" y="4926130"/>
                  <a:ext cx="461665" cy="1692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1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Months</a:t>
                  </a:r>
                  <a:endParaRPr kumimoji="0" lang="fr-FR" altLang="fr-FR" sz="16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142" name="ZoneTexte 141">
                <a:extLst>
                  <a:ext uri="{FF2B5EF4-FFF2-40B4-BE49-F238E27FC236}">
                    <a16:creationId xmlns:a16="http://schemas.microsoft.com/office/drawing/2014/main" id="{F76A471B-9DBA-49BA-96BD-03293FB947C0}"/>
                  </a:ext>
                </a:extLst>
              </p:cNvPr>
              <p:cNvSpPr txBox="1"/>
              <p:nvPr/>
            </p:nvSpPr>
            <p:spPr>
              <a:xfrm>
                <a:off x="1357918" y="850299"/>
                <a:ext cx="69121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TMM</a:t>
                </a:r>
              </a:p>
            </p:txBody>
          </p:sp>
          <p:sp>
            <p:nvSpPr>
              <p:cNvPr id="143" name="ZoneTexte 142">
                <a:extLst>
                  <a:ext uri="{FF2B5EF4-FFF2-40B4-BE49-F238E27FC236}">
                    <a16:creationId xmlns:a16="http://schemas.microsoft.com/office/drawing/2014/main" id="{DAD8F85C-C175-4714-8632-F41BC7E74816}"/>
                  </a:ext>
                </a:extLst>
              </p:cNvPr>
              <p:cNvSpPr txBox="1"/>
              <p:nvPr/>
            </p:nvSpPr>
            <p:spPr>
              <a:xfrm>
                <a:off x="2327707" y="168466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ZoneTexte 143">
                <a:extLst>
                  <a:ext uri="{FF2B5EF4-FFF2-40B4-BE49-F238E27FC236}">
                    <a16:creationId xmlns:a16="http://schemas.microsoft.com/office/drawing/2014/main" id="{02BB1983-9E49-49A2-97E2-39C232C9B26E}"/>
                  </a:ext>
                </a:extLst>
              </p:cNvPr>
              <p:cNvSpPr txBox="1"/>
              <p:nvPr/>
            </p:nvSpPr>
            <p:spPr>
              <a:xfrm>
                <a:off x="2343088" y="210174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ZoneTexte 144">
                <a:extLst>
                  <a:ext uri="{FF2B5EF4-FFF2-40B4-BE49-F238E27FC236}">
                    <a16:creationId xmlns:a16="http://schemas.microsoft.com/office/drawing/2014/main" id="{29032E3D-0AB3-4B62-9744-4D6E0C2F4301}"/>
                  </a:ext>
                </a:extLst>
              </p:cNvPr>
              <p:cNvSpPr txBox="1"/>
              <p:nvPr/>
            </p:nvSpPr>
            <p:spPr>
              <a:xfrm>
                <a:off x="1518955" y="2802766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6.3m</a:t>
                </a:r>
              </a:p>
            </p:txBody>
          </p:sp>
          <p:sp>
            <p:nvSpPr>
              <p:cNvPr id="146" name="ZoneTexte 145">
                <a:extLst>
                  <a:ext uri="{FF2B5EF4-FFF2-40B4-BE49-F238E27FC236}">
                    <a16:creationId xmlns:a16="http://schemas.microsoft.com/office/drawing/2014/main" id="{3915B921-0C04-4F1B-9BA6-FD76990690E6}"/>
                  </a:ext>
                </a:extLst>
              </p:cNvPr>
              <p:cNvSpPr txBox="1"/>
              <p:nvPr/>
            </p:nvSpPr>
            <p:spPr>
              <a:xfrm>
                <a:off x="1711350" y="3290116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0.1m</a:t>
                </a:r>
              </a:p>
            </p:txBody>
          </p:sp>
        </p:grpSp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0F00C476-DEEF-4C6D-92EE-488790B8811B}"/>
                </a:ext>
              </a:extLst>
            </p:cNvPr>
            <p:cNvGrpSpPr/>
            <p:nvPr/>
          </p:nvGrpSpPr>
          <p:grpSpPr>
            <a:xfrm>
              <a:off x="2904378" y="592649"/>
              <a:ext cx="4854402" cy="4629151"/>
              <a:chOff x="5284786" y="574719"/>
              <a:chExt cx="4854402" cy="4629151"/>
            </a:xfrm>
          </p:grpSpPr>
          <p:grpSp>
            <p:nvGrpSpPr>
              <p:cNvPr id="17" name="Groupe 16">
                <a:extLst>
                  <a:ext uri="{FF2B5EF4-FFF2-40B4-BE49-F238E27FC236}">
                    <a16:creationId xmlns:a16="http://schemas.microsoft.com/office/drawing/2014/main" id="{BAEE505A-39A1-4784-BC15-277B1BF63B5F}"/>
                  </a:ext>
                </a:extLst>
              </p:cNvPr>
              <p:cNvGrpSpPr/>
              <p:nvPr/>
            </p:nvGrpSpPr>
            <p:grpSpPr>
              <a:xfrm>
                <a:off x="5284786" y="574719"/>
                <a:ext cx="4854402" cy="4629151"/>
                <a:chOff x="5284786" y="574719"/>
                <a:chExt cx="4854402" cy="4629151"/>
              </a:xfrm>
            </p:grpSpPr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67625936-CE32-4B27-9B9B-37787B5817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84786" y="574719"/>
                  <a:ext cx="4854402" cy="3468688"/>
                </a:xfrm>
                <a:prstGeom prst="rect">
                  <a:avLst/>
                </a:prstGeom>
                <a:noFill/>
                <a:ln w="6350" cap="rnd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208C402A-F54A-4AAE-B020-E6AA870E9C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951954" y="1073194"/>
                  <a:ext cx="3133127" cy="2536825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" name="Freeform 8">
                  <a:extLst>
                    <a:ext uri="{FF2B5EF4-FFF2-40B4-BE49-F238E27FC236}">
                      <a16:creationId xmlns:a16="http://schemas.microsoft.com/office/drawing/2014/main" id="{A4FB991C-29F8-467B-BA7C-EA5438FBCB6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090603" y="1193844"/>
                  <a:ext cx="1748329" cy="1957388"/>
                </a:xfrm>
                <a:custGeom>
                  <a:avLst/>
                  <a:gdLst>
                    <a:gd name="T0" fmla="*/ 0 w 253"/>
                    <a:gd name="T1" fmla="*/ 0 h 243"/>
                    <a:gd name="T2" fmla="*/ 5 w 253"/>
                    <a:gd name="T3" fmla="*/ 0 h 243"/>
                    <a:gd name="T4" fmla="*/ 5 w 253"/>
                    <a:gd name="T5" fmla="*/ 28 h 243"/>
                    <a:gd name="T6" fmla="*/ 7 w 253"/>
                    <a:gd name="T7" fmla="*/ 28 h 243"/>
                    <a:gd name="T8" fmla="*/ 7 w 253"/>
                    <a:gd name="T9" fmla="*/ 57 h 243"/>
                    <a:gd name="T10" fmla="*/ 17 w 253"/>
                    <a:gd name="T11" fmla="*/ 57 h 243"/>
                    <a:gd name="T12" fmla="*/ 17 w 253"/>
                    <a:gd name="T13" fmla="*/ 86 h 243"/>
                    <a:gd name="T14" fmla="*/ 29 w 253"/>
                    <a:gd name="T15" fmla="*/ 86 h 243"/>
                    <a:gd name="T16" fmla="*/ 29 w 253"/>
                    <a:gd name="T17" fmla="*/ 114 h 243"/>
                    <a:gd name="T18" fmla="*/ 38 w 253"/>
                    <a:gd name="T19" fmla="*/ 114 h 243"/>
                    <a:gd name="T20" fmla="*/ 38 w 253"/>
                    <a:gd name="T21" fmla="*/ 143 h 243"/>
                    <a:gd name="T22" fmla="*/ 52 w 253"/>
                    <a:gd name="T23" fmla="*/ 143 h 243"/>
                    <a:gd name="T24" fmla="*/ 52 w 253"/>
                    <a:gd name="T25" fmla="*/ 171 h 243"/>
                    <a:gd name="T26" fmla="*/ 56 w 253"/>
                    <a:gd name="T27" fmla="*/ 171 h 243"/>
                    <a:gd name="T28" fmla="*/ 56 w 253"/>
                    <a:gd name="T29" fmla="*/ 200 h 243"/>
                    <a:gd name="T30" fmla="*/ 63 w 253"/>
                    <a:gd name="T31" fmla="*/ 200 h 243"/>
                    <a:gd name="T32" fmla="*/ 63 w 253"/>
                    <a:gd name="T33" fmla="*/ 200 h 243"/>
                    <a:gd name="T34" fmla="*/ 114 w 253"/>
                    <a:gd name="T35" fmla="*/ 200 h 243"/>
                    <a:gd name="T36" fmla="*/ 114 w 253"/>
                    <a:gd name="T37" fmla="*/ 243 h 243"/>
                    <a:gd name="T38" fmla="*/ 253 w 253"/>
                    <a:gd name="T39" fmla="*/ 243 h 243"/>
                    <a:gd name="T40" fmla="*/ 253 w 253"/>
                    <a:gd name="T41" fmla="*/ 243 h 2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</a:cxnLst>
                  <a:rect l="0" t="0" r="r" b="b"/>
                  <a:pathLst>
                    <a:path w="253" h="243">
                      <a:moveTo>
                        <a:pt x="0" y="0"/>
                      </a:moveTo>
                      <a:lnTo>
                        <a:pt x="5" y="0"/>
                      </a:lnTo>
                      <a:lnTo>
                        <a:pt x="5" y="28"/>
                      </a:lnTo>
                      <a:lnTo>
                        <a:pt x="7" y="28"/>
                      </a:lnTo>
                      <a:lnTo>
                        <a:pt x="7" y="57"/>
                      </a:lnTo>
                      <a:lnTo>
                        <a:pt x="17" y="57"/>
                      </a:lnTo>
                      <a:lnTo>
                        <a:pt x="17" y="86"/>
                      </a:lnTo>
                      <a:lnTo>
                        <a:pt x="29" y="86"/>
                      </a:lnTo>
                      <a:lnTo>
                        <a:pt x="29" y="114"/>
                      </a:lnTo>
                      <a:lnTo>
                        <a:pt x="38" y="114"/>
                      </a:lnTo>
                      <a:lnTo>
                        <a:pt x="38" y="143"/>
                      </a:lnTo>
                      <a:lnTo>
                        <a:pt x="52" y="143"/>
                      </a:lnTo>
                      <a:lnTo>
                        <a:pt x="52" y="171"/>
                      </a:lnTo>
                      <a:lnTo>
                        <a:pt x="56" y="171"/>
                      </a:lnTo>
                      <a:lnTo>
                        <a:pt x="56" y="200"/>
                      </a:lnTo>
                      <a:lnTo>
                        <a:pt x="63" y="200"/>
                      </a:lnTo>
                      <a:lnTo>
                        <a:pt x="63" y="200"/>
                      </a:lnTo>
                      <a:lnTo>
                        <a:pt x="114" y="200"/>
                      </a:lnTo>
                      <a:lnTo>
                        <a:pt x="114" y="243"/>
                      </a:lnTo>
                      <a:lnTo>
                        <a:pt x="253" y="243"/>
                      </a:lnTo>
                      <a:lnTo>
                        <a:pt x="253" y="243"/>
                      </a:ln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2" name="Freeform 9">
                  <a:extLst>
                    <a:ext uri="{FF2B5EF4-FFF2-40B4-BE49-F238E27FC236}">
                      <a16:creationId xmlns:a16="http://schemas.microsoft.com/office/drawing/2014/main" id="{41396E80-5542-4CC3-9B82-39BF786FCAF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090603" y="1193844"/>
                  <a:ext cx="1423687" cy="2214563"/>
                </a:xfrm>
                <a:custGeom>
                  <a:avLst/>
                  <a:gdLst>
                    <a:gd name="T0" fmla="*/ 0 w 206"/>
                    <a:gd name="T1" fmla="*/ 0 h 275"/>
                    <a:gd name="T2" fmla="*/ 6 w 206"/>
                    <a:gd name="T3" fmla="*/ 0 h 275"/>
                    <a:gd name="T4" fmla="*/ 6 w 206"/>
                    <a:gd name="T5" fmla="*/ 10 h 275"/>
                    <a:gd name="T6" fmla="*/ 10 w 206"/>
                    <a:gd name="T7" fmla="*/ 10 h 275"/>
                    <a:gd name="T8" fmla="*/ 10 w 206"/>
                    <a:gd name="T9" fmla="*/ 19 h 275"/>
                    <a:gd name="T10" fmla="*/ 10 w 206"/>
                    <a:gd name="T11" fmla="*/ 19 h 275"/>
                    <a:gd name="T12" fmla="*/ 10 w 206"/>
                    <a:gd name="T13" fmla="*/ 29 h 275"/>
                    <a:gd name="T14" fmla="*/ 14 w 206"/>
                    <a:gd name="T15" fmla="*/ 29 h 275"/>
                    <a:gd name="T16" fmla="*/ 14 w 206"/>
                    <a:gd name="T17" fmla="*/ 39 h 275"/>
                    <a:gd name="T18" fmla="*/ 29 w 206"/>
                    <a:gd name="T19" fmla="*/ 39 h 275"/>
                    <a:gd name="T20" fmla="*/ 29 w 206"/>
                    <a:gd name="T21" fmla="*/ 49 h 275"/>
                    <a:gd name="T22" fmla="*/ 34 w 206"/>
                    <a:gd name="T23" fmla="*/ 49 h 275"/>
                    <a:gd name="T24" fmla="*/ 34 w 206"/>
                    <a:gd name="T25" fmla="*/ 59 h 275"/>
                    <a:gd name="T26" fmla="*/ 37 w 206"/>
                    <a:gd name="T27" fmla="*/ 59 h 275"/>
                    <a:gd name="T28" fmla="*/ 37 w 206"/>
                    <a:gd name="T29" fmla="*/ 69 h 275"/>
                    <a:gd name="T30" fmla="*/ 39 w 206"/>
                    <a:gd name="T31" fmla="*/ 69 h 275"/>
                    <a:gd name="T32" fmla="*/ 39 w 206"/>
                    <a:gd name="T33" fmla="*/ 69 h 275"/>
                    <a:gd name="T34" fmla="*/ 40 w 206"/>
                    <a:gd name="T35" fmla="*/ 69 h 275"/>
                    <a:gd name="T36" fmla="*/ 40 w 206"/>
                    <a:gd name="T37" fmla="*/ 79 h 275"/>
                    <a:gd name="T38" fmla="*/ 44 w 206"/>
                    <a:gd name="T39" fmla="*/ 79 h 275"/>
                    <a:gd name="T40" fmla="*/ 44 w 206"/>
                    <a:gd name="T41" fmla="*/ 100 h 275"/>
                    <a:gd name="T42" fmla="*/ 48 w 206"/>
                    <a:gd name="T43" fmla="*/ 100 h 275"/>
                    <a:gd name="T44" fmla="*/ 48 w 206"/>
                    <a:gd name="T45" fmla="*/ 110 h 275"/>
                    <a:gd name="T46" fmla="*/ 51 w 206"/>
                    <a:gd name="T47" fmla="*/ 110 h 275"/>
                    <a:gd name="T48" fmla="*/ 51 w 206"/>
                    <a:gd name="T49" fmla="*/ 120 h 275"/>
                    <a:gd name="T50" fmla="*/ 58 w 206"/>
                    <a:gd name="T51" fmla="*/ 120 h 275"/>
                    <a:gd name="T52" fmla="*/ 58 w 206"/>
                    <a:gd name="T53" fmla="*/ 131 h 275"/>
                    <a:gd name="T54" fmla="*/ 58 w 206"/>
                    <a:gd name="T55" fmla="*/ 131 h 275"/>
                    <a:gd name="T56" fmla="*/ 58 w 206"/>
                    <a:gd name="T57" fmla="*/ 131 h 275"/>
                    <a:gd name="T58" fmla="*/ 69 w 206"/>
                    <a:gd name="T59" fmla="*/ 131 h 275"/>
                    <a:gd name="T60" fmla="*/ 69 w 206"/>
                    <a:gd name="T61" fmla="*/ 142 h 275"/>
                    <a:gd name="T62" fmla="*/ 69 w 206"/>
                    <a:gd name="T63" fmla="*/ 142 h 275"/>
                    <a:gd name="T64" fmla="*/ 69 w 206"/>
                    <a:gd name="T65" fmla="*/ 153 h 275"/>
                    <a:gd name="T66" fmla="*/ 78 w 206"/>
                    <a:gd name="T67" fmla="*/ 153 h 275"/>
                    <a:gd name="T68" fmla="*/ 78 w 206"/>
                    <a:gd name="T69" fmla="*/ 164 h 275"/>
                    <a:gd name="T70" fmla="*/ 86 w 206"/>
                    <a:gd name="T71" fmla="*/ 164 h 275"/>
                    <a:gd name="T72" fmla="*/ 86 w 206"/>
                    <a:gd name="T73" fmla="*/ 175 h 275"/>
                    <a:gd name="T74" fmla="*/ 92 w 206"/>
                    <a:gd name="T75" fmla="*/ 175 h 275"/>
                    <a:gd name="T76" fmla="*/ 92 w 206"/>
                    <a:gd name="T77" fmla="*/ 186 h 275"/>
                    <a:gd name="T78" fmla="*/ 95 w 206"/>
                    <a:gd name="T79" fmla="*/ 186 h 275"/>
                    <a:gd name="T80" fmla="*/ 95 w 206"/>
                    <a:gd name="T81" fmla="*/ 197 h 275"/>
                    <a:gd name="T82" fmla="*/ 95 w 206"/>
                    <a:gd name="T83" fmla="*/ 197 h 275"/>
                    <a:gd name="T84" fmla="*/ 95 w 206"/>
                    <a:gd name="T85" fmla="*/ 208 h 275"/>
                    <a:gd name="T86" fmla="*/ 101 w 206"/>
                    <a:gd name="T87" fmla="*/ 208 h 275"/>
                    <a:gd name="T88" fmla="*/ 101 w 206"/>
                    <a:gd name="T89" fmla="*/ 219 h 275"/>
                    <a:gd name="T90" fmla="*/ 117 w 206"/>
                    <a:gd name="T91" fmla="*/ 219 h 275"/>
                    <a:gd name="T92" fmla="*/ 117 w 206"/>
                    <a:gd name="T93" fmla="*/ 230 h 275"/>
                    <a:gd name="T94" fmla="*/ 127 w 206"/>
                    <a:gd name="T95" fmla="*/ 230 h 275"/>
                    <a:gd name="T96" fmla="*/ 127 w 206"/>
                    <a:gd name="T97" fmla="*/ 242 h 275"/>
                    <a:gd name="T98" fmla="*/ 147 w 206"/>
                    <a:gd name="T99" fmla="*/ 242 h 275"/>
                    <a:gd name="T100" fmla="*/ 147 w 206"/>
                    <a:gd name="T101" fmla="*/ 253 h 275"/>
                    <a:gd name="T102" fmla="*/ 179 w 206"/>
                    <a:gd name="T103" fmla="*/ 253 h 275"/>
                    <a:gd name="T104" fmla="*/ 179 w 206"/>
                    <a:gd name="T105" fmla="*/ 264 h 275"/>
                    <a:gd name="T106" fmla="*/ 202 w 206"/>
                    <a:gd name="T107" fmla="*/ 264 h 275"/>
                    <a:gd name="T108" fmla="*/ 202 w 206"/>
                    <a:gd name="T109" fmla="*/ 275 h 275"/>
                    <a:gd name="T110" fmla="*/ 206 w 206"/>
                    <a:gd name="T111" fmla="*/ 275 h 275"/>
                    <a:gd name="T112" fmla="*/ 206 w 206"/>
                    <a:gd name="T113" fmla="*/ 275 h 2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</a:cxnLst>
                  <a:rect l="0" t="0" r="r" b="b"/>
                  <a:pathLst>
                    <a:path w="206" h="275">
                      <a:moveTo>
                        <a:pt x="0" y="0"/>
                      </a:moveTo>
                      <a:lnTo>
                        <a:pt x="6" y="0"/>
                      </a:lnTo>
                      <a:lnTo>
                        <a:pt x="6" y="10"/>
                      </a:lnTo>
                      <a:lnTo>
                        <a:pt x="10" y="10"/>
                      </a:lnTo>
                      <a:lnTo>
                        <a:pt x="10" y="19"/>
                      </a:lnTo>
                      <a:lnTo>
                        <a:pt x="10" y="19"/>
                      </a:lnTo>
                      <a:lnTo>
                        <a:pt x="10" y="29"/>
                      </a:lnTo>
                      <a:lnTo>
                        <a:pt x="14" y="29"/>
                      </a:lnTo>
                      <a:lnTo>
                        <a:pt x="14" y="39"/>
                      </a:lnTo>
                      <a:lnTo>
                        <a:pt x="29" y="39"/>
                      </a:lnTo>
                      <a:lnTo>
                        <a:pt x="29" y="49"/>
                      </a:lnTo>
                      <a:lnTo>
                        <a:pt x="34" y="49"/>
                      </a:lnTo>
                      <a:lnTo>
                        <a:pt x="34" y="59"/>
                      </a:lnTo>
                      <a:lnTo>
                        <a:pt x="37" y="59"/>
                      </a:lnTo>
                      <a:lnTo>
                        <a:pt x="37" y="69"/>
                      </a:lnTo>
                      <a:lnTo>
                        <a:pt x="39" y="69"/>
                      </a:lnTo>
                      <a:lnTo>
                        <a:pt x="39" y="69"/>
                      </a:lnTo>
                      <a:lnTo>
                        <a:pt x="40" y="69"/>
                      </a:lnTo>
                      <a:lnTo>
                        <a:pt x="40" y="79"/>
                      </a:lnTo>
                      <a:lnTo>
                        <a:pt x="44" y="79"/>
                      </a:lnTo>
                      <a:lnTo>
                        <a:pt x="44" y="100"/>
                      </a:lnTo>
                      <a:lnTo>
                        <a:pt x="48" y="100"/>
                      </a:lnTo>
                      <a:lnTo>
                        <a:pt x="48" y="110"/>
                      </a:lnTo>
                      <a:lnTo>
                        <a:pt x="51" y="110"/>
                      </a:lnTo>
                      <a:lnTo>
                        <a:pt x="51" y="120"/>
                      </a:lnTo>
                      <a:lnTo>
                        <a:pt x="58" y="120"/>
                      </a:lnTo>
                      <a:lnTo>
                        <a:pt x="58" y="131"/>
                      </a:lnTo>
                      <a:lnTo>
                        <a:pt x="58" y="131"/>
                      </a:lnTo>
                      <a:lnTo>
                        <a:pt x="58" y="131"/>
                      </a:lnTo>
                      <a:lnTo>
                        <a:pt x="69" y="131"/>
                      </a:lnTo>
                      <a:lnTo>
                        <a:pt x="69" y="142"/>
                      </a:lnTo>
                      <a:lnTo>
                        <a:pt x="69" y="142"/>
                      </a:lnTo>
                      <a:lnTo>
                        <a:pt x="69" y="153"/>
                      </a:lnTo>
                      <a:lnTo>
                        <a:pt x="78" y="153"/>
                      </a:lnTo>
                      <a:lnTo>
                        <a:pt x="78" y="164"/>
                      </a:lnTo>
                      <a:lnTo>
                        <a:pt x="86" y="164"/>
                      </a:lnTo>
                      <a:lnTo>
                        <a:pt x="86" y="175"/>
                      </a:lnTo>
                      <a:lnTo>
                        <a:pt x="92" y="175"/>
                      </a:lnTo>
                      <a:lnTo>
                        <a:pt x="92" y="186"/>
                      </a:lnTo>
                      <a:lnTo>
                        <a:pt x="95" y="186"/>
                      </a:lnTo>
                      <a:lnTo>
                        <a:pt x="95" y="197"/>
                      </a:lnTo>
                      <a:lnTo>
                        <a:pt x="95" y="197"/>
                      </a:lnTo>
                      <a:lnTo>
                        <a:pt x="95" y="208"/>
                      </a:lnTo>
                      <a:lnTo>
                        <a:pt x="101" y="208"/>
                      </a:lnTo>
                      <a:lnTo>
                        <a:pt x="101" y="219"/>
                      </a:lnTo>
                      <a:lnTo>
                        <a:pt x="117" y="219"/>
                      </a:lnTo>
                      <a:lnTo>
                        <a:pt x="117" y="230"/>
                      </a:lnTo>
                      <a:lnTo>
                        <a:pt x="127" y="230"/>
                      </a:lnTo>
                      <a:lnTo>
                        <a:pt x="127" y="242"/>
                      </a:lnTo>
                      <a:lnTo>
                        <a:pt x="147" y="242"/>
                      </a:lnTo>
                      <a:lnTo>
                        <a:pt x="147" y="253"/>
                      </a:lnTo>
                      <a:lnTo>
                        <a:pt x="179" y="253"/>
                      </a:lnTo>
                      <a:lnTo>
                        <a:pt x="179" y="264"/>
                      </a:lnTo>
                      <a:lnTo>
                        <a:pt x="202" y="264"/>
                      </a:lnTo>
                      <a:lnTo>
                        <a:pt x="202" y="275"/>
                      </a:lnTo>
                      <a:lnTo>
                        <a:pt x="206" y="275"/>
                      </a:lnTo>
                      <a:lnTo>
                        <a:pt x="206" y="275"/>
                      </a:lnTo>
                    </a:path>
                  </a:pathLst>
                </a:custGeom>
                <a:noFill/>
                <a:ln w="12700" cap="flat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3" name="Freeform 10">
                  <a:extLst>
                    <a:ext uri="{FF2B5EF4-FFF2-40B4-BE49-F238E27FC236}">
                      <a16:creationId xmlns:a16="http://schemas.microsoft.com/office/drawing/2014/main" id="{09917A91-FACA-4858-9483-B1B0B672684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090603" y="1193844"/>
                  <a:ext cx="2433119" cy="1111250"/>
                </a:xfrm>
                <a:custGeom>
                  <a:avLst/>
                  <a:gdLst>
                    <a:gd name="T0" fmla="*/ 19 w 352"/>
                    <a:gd name="T1" fmla="*/ 0 h 138"/>
                    <a:gd name="T2" fmla="*/ 22 w 352"/>
                    <a:gd name="T3" fmla="*/ 0 h 138"/>
                    <a:gd name="T4" fmla="*/ 25 w 352"/>
                    <a:gd name="T5" fmla="*/ 0 h 138"/>
                    <a:gd name="T6" fmla="*/ 28 w 352"/>
                    <a:gd name="T7" fmla="*/ 7 h 138"/>
                    <a:gd name="T8" fmla="*/ 42 w 352"/>
                    <a:gd name="T9" fmla="*/ 14 h 138"/>
                    <a:gd name="T10" fmla="*/ 44 w 352"/>
                    <a:gd name="T11" fmla="*/ 21 h 138"/>
                    <a:gd name="T12" fmla="*/ 53 w 352"/>
                    <a:gd name="T13" fmla="*/ 28 h 138"/>
                    <a:gd name="T14" fmla="*/ 55 w 352"/>
                    <a:gd name="T15" fmla="*/ 35 h 138"/>
                    <a:gd name="T16" fmla="*/ 62 w 352"/>
                    <a:gd name="T17" fmla="*/ 35 h 138"/>
                    <a:gd name="T18" fmla="*/ 65 w 352"/>
                    <a:gd name="T19" fmla="*/ 42 h 138"/>
                    <a:gd name="T20" fmla="*/ 72 w 352"/>
                    <a:gd name="T21" fmla="*/ 49 h 138"/>
                    <a:gd name="T22" fmla="*/ 87 w 352"/>
                    <a:gd name="T23" fmla="*/ 56 h 138"/>
                    <a:gd name="T24" fmla="*/ 99 w 352"/>
                    <a:gd name="T25" fmla="*/ 63 h 138"/>
                    <a:gd name="T26" fmla="*/ 120 w 352"/>
                    <a:gd name="T27" fmla="*/ 70 h 138"/>
                    <a:gd name="T28" fmla="*/ 121 w 352"/>
                    <a:gd name="T29" fmla="*/ 78 h 138"/>
                    <a:gd name="T30" fmla="*/ 123 w 352"/>
                    <a:gd name="T31" fmla="*/ 85 h 138"/>
                    <a:gd name="T32" fmla="*/ 131 w 352"/>
                    <a:gd name="T33" fmla="*/ 92 h 138"/>
                    <a:gd name="T34" fmla="*/ 142 w 352"/>
                    <a:gd name="T35" fmla="*/ 99 h 138"/>
                    <a:gd name="T36" fmla="*/ 144 w 352"/>
                    <a:gd name="T37" fmla="*/ 106 h 138"/>
                    <a:gd name="T38" fmla="*/ 197 w 352"/>
                    <a:gd name="T39" fmla="*/ 114 h 138"/>
                    <a:gd name="T40" fmla="*/ 207 w 352"/>
                    <a:gd name="T41" fmla="*/ 114 h 138"/>
                    <a:gd name="T42" fmla="*/ 207 w 352"/>
                    <a:gd name="T43" fmla="*/ 114 h 138"/>
                    <a:gd name="T44" fmla="*/ 209 w 352"/>
                    <a:gd name="T45" fmla="*/ 114 h 138"/>
                    <a:gd name="T46" fmla="*/ 209 w 352"/>
                    <a:gd name="T47" fmla="*/ 114 h 138"/>
                    <a:gd name="T48" fmla="*/ 211 w 352"/>
                    <a:gd name="T49" fmla="*/ 114 h 138"/>
                    <a:gd name="T50" fmla="*/ 213 w 352"/>
                    <a:gd name="T51" fmla="*/ 114 h 138"/>
                    <a:gd name="T52" fmla="*/ 219 w 352"/>
                    <a:gd name="T53" fmla="*/ 114 h 138"/>
                    <a:gd name="T54" fmla="*/ 220 w 352"/>
                    <a:gd name="T55" fmla="*/ 114 h 138"/>
                    <a:gd name="T56" fmla="*/ 221 w 352"/>
                    <a:gd name="T57" fmla="*/ 114 h 138"/>
                    <a:gd name="T58" fmla="*/ 227 w 352"/>
                    <a:gd name="T59" fmla="*/ 114 h 138"/>
                    <a:gd name="T60" fmla="*/ 229 w 352"/>
                    <a:gd name="T61" fmla="*/ 114 h 138"/>
                    <a:gd name="T62" fmla="*/ 232 w 352"/>
                    <a:gd name="T63" fmla="*/ 114 h 138"/>
                    <a:gd name="T64" fmla="*/ 239 w 352"/>
                    <a:gd name="T65" fmla="*/ 114 h 138"/>
                    <a:gd name="T66" fmla="*/ 258 w 352"/>
                    <a:gd name="T67" fmla="*/ 114 h 138"/>
                    <a:gd name="T68" fmla="*/ 262 w 352"/>
                    <a:gd name="T69" fmla="*/ 114 h 138"/>
                    <a:gd name="T70" fmla="*/ 267 w 352"/>
                    <a:gd name="T71" fmla="*/ 114 h 138"/>
                    <a:gd name="T72" fmla="*/ 271 w 352"/>
                    <a:gd name="T73" fmla="*/ 138 h 138"/>
                    <a:gd name="T74" fmla="*/ 296 w 352"/>
                    <a:gd name="T75" fmla="*/ 138 h 138"/>
                    <a:gd name="T76" fmla="*/ 302 w 352"/>
                    <a:gd name="T77" fmla="*/ 138 h 138"/>
                    <a:gd name="T78" fmla="*/ 319 w 352"/>
                    <a:gd name="T79" fmla="*/ 138 h 138"/>
                    <a:gd name="T80" fmla="*/ 336 w 352"/>
                    <a:gd name="T81" fmla="*/ 138 h 138"/>
                    <a:gd name="T82" fmla="*/ 352 w 352"/>
                    <a:gd name="T83" fmla="*/ 138 h 1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</a:cxnLst>
                  <a:rect l="0" t="0" r="r" b="b"/>
                  <a:pathLst>
                    <a:path w="352" h="138">
                      <a:moveTo>
                        <a:pt x="0" y="0"/>
                      </a:moveTo>
                      <a:lnTo>
                        <a:pt x="19" y="0"/>
                      </a:lnTo>
                      <a:lnTo>
                        <a:pt x="19" y="0"/>
                      </a:lnTo>
                      <a:lnTo>
                        <a:pt x="22" y="0"/>
                      </a:lnTo>
                      <a:lnTo>
                        <a:pt x="22" y="0"/>
                      </a:lnTo>
                      <a:lnTo>
                        <a:pt x="25" y="0"/>
                      </a:lnTo>
                      <a:lnTo>
                        <a:pt x="25" y="7"/>
                      </a:lnTo>
                      <a:lnTo>
                        <a:pt x="28" y="7"/>
                      </a:lnTo>
                      <a:lnTo>
                        <a:pt x="28" y="14"/>
                      </a:lnTo>
                      <a:lnTo>
                        <a:pt x="42" y="14"/>
                      </a:lnTo>
                      <a:lnTo>
                        <a:pt x="42" y="21"/>
                      </a:lnTo>
                      <a:lnTo>
                        <a:pt x="44" y="21"/>
                      </a:lnTo>
                      <a:lnTo>
                        <a:pt x="44" y="28"/>
                      </a:lnTo>
                      <a:lnTo>
                        <a:pt x="53" y="28"/>
                      </a:lnTo>
                      <a:lnTo>
                        <a:pt x="53" y="35"/>
                      </a:lnTo>
                      <a:lnTo>
                        <a:pt x="55" y="35"/>
                      </a:lnTo>
                      <a:lnTo>
                        <a:pt x="55" y="35"/>
                      </a:lnTo>
                      <a:lnTo>
                        <a:pt x="62" y="35"/>
                      </a:lnTo>
                      <a:lnTo>
                        <a:pt x="62" y="42"/>
                      </a:lnTo>
                      <a:lnTo>
                        <a:pt x="65" y="42"/>
                      </a:lnTo>
                      <a:lnTo>
                        <a:pt x="65" y="49"/>
                      </a:lnTo>
                      <a:lnTo>
                        <a:pt x="72" y="49"/>
                      </a:lnTo>
                      <a:lnTo>
                        <a:pt x="72" y="56"/>
                      </a:lnTo>
                      <a:lnTo>
                        <a:pt x="87" y="56"/>
                      </a:lnTo>
                      <a:lnTo>
                        <a:pt x="87" y="63"/>
                      </a:lnTo>
                      <a:lnTo>
                        <a:pt x="99" y="63"/>
                      </a:lnTo>
                      <a:lnTo>
                        <a:pt x="99" y="70"/>
                      </a:lnTo>
                      <a:lnTo>
                        <a:pt x="120" y="70"/>
                      </a:lnTo>
                      <a:lnTo>
                        <a:pt x="120" y="78"/>
                      </a:lnTo>
                      <a:lnTo>
                        <a:pt x="121" y="78"/>
                      </a:lnTo>
                      <a:lnTo>
                        <a:pt x="121" y="85"/>
                      </a:lnTo>
                      <a:lnTo>
                        <a:pt x="123" y="85"/>
                      </a:lnTo>
                      <a:lnTo>
                        <a:pt x="123" y="92"/>
                      </a:lnTo>
                      <a:lnTo>
                        <a:pt x="131" y="92"/>
                      </a:lnTo>
                      <a:lnTo>
                        <a:pt x="131" y="99"/>
                      </a:lnTo>
                      <a:lnTo>
                        <a:pt x="142" y="99"/>
                      </a:lnTo>
                      <a:lnTo>
                        <a:pt x="142" y="106"/>
                      </a:lnTo>
                      <a:lnTo>
                        <a:pt x="144" y="106"/>
                      </a:lnTo>
                      <a:lnTo>
                        <a:pt x="144" y="114"/>
                      </a:lnTo>
                      <a:lnTo>
                        <a:pt x="197" y="114"/>
                      </a:lnTo>
                      <a:lnTo>
                        <a:pt x="197" y="114"/>
                      </a:lnTo>
                      <a:lnTo>
                        <a:pt x="207" y="114"/>
                      </a:lnTo>
                      <a:lnTo>
                        <a:pt x="207" y="114"/>
                      </a:lnTo>
                      <a:lnTo>
                        <a:pt x="207" y="114"/>
                      </a:lnTo>
                      <a:lnTo>
                        <a:pt x="207" y="114"/>
                      </a:lnTo>
                      <a:lnTo>
                        <a:pt x="209" y="114"/>
                      </a:lnTo>
                      <a:lnTo>
                        <a:pt x="209" y="114"/>
                      </a:lnTo>
                      <a:lnTo>
                        <a:pt x="209" y="114"/>
                      </a:lnTo>
                      <a:lnTo>
                        <a:pt x="209" y="114"/>
                      </a:lnTo>
                      <a:lnTo>
                        <a:pt x="211" y="114"/>
                      </a:lnTo>
                      <a:lnTo>
                        <a:pt x="211" y="114"/>
                      </a:lnTo>
                      <a:lnTo>
                        <a:pt x="213" y="114"/>
                      </a:lnTo>
                      <a:lnTo>
                        <a:pt x="213" y="114"/>
                      </a:lnTo>
                      <a:lnTo>
                        <a:pt x="219" y="114"/>
                      </a:lnTo>
                      <a:lnTo>
                        <a:pt x="219" y="114"/>
                      </a:lnTo>
                      <a:lnTo>
                        <a:pt x="220" y="114"/>
                      </a:lnTo>
                      <a:lnTo>
                        <a:pt x="220" y="114"/>
                      </a:lnTo>
                      <a:lnTo>
                        <a:pt x="221" y="114"/>
                      </a:lnTo>
                      <a:lnTo>
                        <a:pt x="221" y="114"/>
                      </a:lnTo>
                      <a:lnTo>
                        <a:pt x="227" y="114"/>
                      </a:lnTo>
                      <a:lnTo>
                        <a:pt x="227" y="114"/>
                      </a:lnTo>
                      <a:lnTo>
                        <a:pt x="229" y="114"/>
                      </a:lnTo>
                      <a:lnTo>
                        <a:pt x="229" y="114"/>
                      </a:lnTo>
                      <a:lnTo>
                        <a:pt x="232" y="114"/>
                      </a:lnTo>
                      <a:lnTo>
                        <a:pt x="232" y="114"/>
                      </a:lnTo>
                      <a:lnTo>
                        <a:pt x="239" y="114"/>
                      </a:lnTo>
                      <a:lnTo>
                        <a:pt x="239" y="114"/>
                      </a:lnTo>
                      <a:lnTo>
                        <a:pt x="258" y="114"/>
                      </a:lnTo>
                      <a:lnTo>
                        <a:pt x="258" y="114"/>
                      </a:lnTo>
                      <a:lnTo>
                        <a:pt x="262" y="114"/>
                      </a:lnTo>
                      <a:lnTo>
                        <a:pt x="262" y="114"/>
                      </a:lnTo>
                      <a:lnTo>
                        <a:pt x="267" y="114"/>
                      </a:lnTo>
                      <a:lnTo>
                        <a:pt x="267" y="138"/>
                      </a:lnTo>
                      <a:lnTo>
                        <a:pt x="271" y="138"/>
                      </a:lnTo>
                      <a:lnTo>
                        <a:pt x="271" y="138"/>
                      </a:lnTo>
                      <a:lnTo>
                        <a:pt x="296" y="138"/>
                      </a:lnTo>
                      <a:lnTo>
                        <a:pt x="296" y="138"/>
                      </a:lnTo>
                      <a:lnTo>
                        <a:pt x="302" y="138"/>
                      </a:lnTo>
                      <a:lnTo>
                        <a:pt x="302" y="138"/>
                      </a:lnTo>
                      <a:lnTo>
                        <a:pt x="319" y="138"/>
                      </a:lnTo>
                      <a:lnTo>
                        <a:pt x="319" y="138"/>
                      </a:lnTo>
                      <a:lnTo>
                        <a:pt x="336" y="138"/>
                      </a:lnTo>
                      <a:lnTo>
                        <a:pt x="336" y="138"/>
                      </a:lnTo>
                      <a:lnTo>
                        <a:pt x="352" y="138"/>
                      </a:lnTo>
                      <a:lnTo>
                        <a:pt x="352" y="138"/>
                      </a:lnTo>
                    </a:path>
                  </a:pathLst>
                </a:custGeom>
                <a:noFill/>
                <a:ln w="12700" cap="flat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" name="Freeform 11">
                  <a:extLst>
                    <a:ext uri="{FF2B5EF4-FFF2-40B4-BE49-F238E27FC236}">
                      <a16:creationId xmlns:a16="http://schemas.microsoft.com/office/drawing/2014/main" id="{1DC0ACE2-D4F9-4536-98FB-32F97310A41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090603" y="1193844"/>
                  <a:ext cx="2654619" cy="314325"/>
                </a:xfrm>
                <a:custGeom>
                  <a:avLst/>
                  <a:gdLst>
                    <a:gd name="T0" fmla="*/ 0 w 384"/>
                    <a:gd name="T1" fmla="*/ 0 h 39"/>
                    <a:gd name="T2" fmla="*/ 4 w 384"/>
                    <a:gd name="T3" fmla="*/ 0 h 39"/>
                    <a:gd name="T4" fmla="*/ 4 w 384"/>
                    <a:gd name="T5" fmla="*/ 12 h 39"/>
                    <a:gd name="T6" fmla="*/ 29 w 384"/>
                    <a:gd name="T7" fmla="*/ 12 h 39"/>
                    <a:gd name="T8" fmla="*/ 29 w 384"/>
                    <a:gd name="T9" fmla="*/ 25 h 39"/>
                    <a:gd name="T10" fmla="*/ 54 w 384"/>
                    <a:gd name="T11" fmla="*/ 25 h 39"/>
                    <a:gd name="T12" fmla="*/ 54 w 384"/>
                    <a:gd name="T13" fmla="*/ 25 h 39"/>
                    <a:gd name="T14" fmla="*/ 115 w 384"/>
                    <a:gd name="T15" fmla="*/ 25 h 39"/>
                    <a:gd name="T16" fmla="*/ 115 w 384"/>
                    <a:gd name="T17" fmla="*/ 25 h 39"/>
                    <a:gd name="T18" fmla="*/ 127 w 384"/>
                    <a:gd name="T19" fmla="*/ 25 h 39"/>
                    <a:gd name="T20" fmla="*/ 127 w 384"/>
                    <a:gd name="T21" fmla="*/ 25 h 39"/>
                    <a:gd name="T22" fmla="*/ 137 w 384"/>
                    <a:gd name="T23" fmla="*/ 25 h 39"/>
                    <a:gd name="T24" fmla="*/ 137 w 384"/>
                    <a:gd name="T25" fmla="*/ 39 h 39"/>
                    <a:gd name="T26" fmla="*/ 141 w 384"/>
                    <a:gd name="T27" fmla="*/ 39 h 39"/>
                    <a:gd name="T28" fmla="*/ 141 w 384"/>
                    <a:gd name="T29" fmla="*/ 39 h 39"/>
                    <a:gd name="T30" fmla="*/ 175 w 384"/>
                    <a:gd name="T31" fmla="*/ 39 h 39"/>
                    <a:gd name="T32" fmla="*/ 175 w 384"/>
                    <a:gd name="T33" fmla="*/ 39 h 39"/>
                    <a:gd name="T34" fmla="*/ 186 w 384"/>
                    <a:gd name="T35" fmla="*/ 39 h 39"/>
                    <a:gd name="T36" fmla="*/ 186 w 384"/>
                    <a:gd name="T37" fmla="*/ 39 h 39"/>
                    <a:gd name="T38" fmla="*/ 206 w 384"/>
                    <a:gd name="T39" fmla="*/ 39 h 39"/>
                    <a:gd name="T40" fmla="*/ 206 w 384"/>
                    <a:gd name="T41" fmla="*/ 39 h 39"/>
                    <a:gd name="T42" fmla="*/ 217 w 384"/>
                    <a:gd name="T43" fmla="*/ 39 h 39"/>
                    <a:gd name="T44" fmla="*/ 217 w 384"/>
                    <a:gd name="T45" fmla="*/ 39 h 39"/>
                    <a:gd name="T46" fmla="*/ 238 w 384"/>
                    <a:gd name="T47" fmla="*/ 39 h 39"/>
                    <a:gd name="T48" fmla="*/ 238 w 384"/>
                    <a:gd name="T49" fmla="*/ 39 h 39"/>
                    <a:gd name="T50" fmla="*/ 244 w 384"/>
                    <a:gd name="T51" fmla="*/ 39 h 39"/>
                    <a:gd name="T52" fmla="*/ 244 w 384"/>
                    <a:gd name="T53" fmla="*/ 39 h 39"/>
                    <a:gd name="T54" fmla="*/ 255 w 384"/>
                    <a:gd name="T55" fmla="*/ 39 h 39"/>
                    <a:gd name="T56" fmla="*/ 255 w 384"/>
                    <a:gd name="T57" fmla="*/ 39 h 39"/>
                    <a:gd name="T58" fmla="*/ 290 w 384"/>
                    <a:gd name="T59" fmla="*/ 39 h 39"/>
                    <a:gd name="T60" fmla="*/ 290 w 384"/>
                    <a:gd name="T61" fmla="*/ 39 h 39"/>
                    <a:gd name="T62" fmla="*/ 296 w 384"/>
                    <a:gd name="T63" fmla="*/ 39 h 39"/>
                    <a:gd name="T64" fmla="*/ 296 w 384"/>
                    <a:gd name="T65" fmla="*/ 39 h 39"/>
                    <a:gd name="T66" fmla="*/ 302 w 384"/>
                    <a:gd name="T67" fmla="*/ 39 h 39"/>
                    <a:gd name="T68" fmla="*/ 302 w 384"/>
                    <a:gd name="T69" fmla="*/ 39 h 39"/>
                    <a:gd name="T70" fmla="*/ 308 w 384"/>
                    <a:gd name="T71" fmla="*/ 39 h 39"/>
                    <a:gd name="T72" fmla="*/ 308 w 384"/>
                    <a:gd name="T73" fmla="*/ 39 h 39"/>
                    <a:gd name="T74" fmla="*/ 308 w 384"/>
                    <a:gd name="T75" fmla="*/ 39 h 39"/>
                    <a:gd name="T76" fmla="*/ 308 w 384"/>
                    <a:gd name="T77" fmla="*/ 39 h 39"/>
                    <a:gd name="T78" fmla="*/ 314 w 384"/>
                    <a:gd name="T79" fmla="*/ 39 h 39"/>
                    <a:gd name="T80" fmla="*/ 314 w 384"/>
                    <a:gd name="T81" fmla="*/ 39 h 39"/>
                    <a:gd name="T82" fmla="*/ 325 w 384"/>
                    <a:gd name="T83" fmla="*/ 39 h 39"/>
                    <a:gd name="T84" fmla="*/ 325 w 384"/>
                    <a:gd name="T85" fmla="*/ 39 h 39"/>
                    <a:gd name="T86" fmla="*/ 333 w 384"/>
                    <a:gd name="T87" fmla="*/ 39 h 39"/>
                    <a:gd name="T88" fmla="*/ 333 w 384"/>
                    <a:gd name="T89" fmla="*/ 39 h 39"/>
                    <a:gd name="T90" fmla="*/ 384 w 384"/>
                    <a:gd name="T91" fmla="*/ 39 h 39"/>
                    <a:gd name="T92" fmla="*/ 384 w 384"/>
                    <a:gd name="T93" fmla="*/ 39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</a:cxnLst>
                  <a:rect l="0" t="0" r="r" b="b"/>
                  <a:pathLst>
                    <a:path w="384" h="39">
                      <a:moveTo>
                        <a:pt x="0" y="0"/>
                      </a:moveTo>
                      <a:lnTo>
                        <a:pt x="4" y="0"/>
                      </a:lnTo>
                      <a:lnTo>
                        <a:pt x="4" y="12"/>
                      </a:lnTo>
                      <a:lnTo>
                        <a:pt x="29" y="12"/>
                      </a:lnTo>
                      <a:lnTo>
                        <a:pt x="29" y="25"/>
                      </a:lnTo>
                      <a:lnTo>
                        <a:pt x="54" y="25"/>
                      </a:lnTo>
                      <a:lnTo>
                        <a:pt x="54" y="25"/>
                      </a:lnTo>
                      <a:lnTo>
                        <a:pt x="115" y="25"/>
                      </a:lnTo>
                      <a:lnTo>
                        <a:pt x="115" y="25"/>
                      </a:lnTo>
                      <a:lnTo>
                        <a:pt x="127" y="25"/>
                      </a:lnTo>
                      <a:lnTo>
                        <a:pt x="127" y="25"/>
                      </a:lnTo>
                      <a:lnTo>
                        <a:pt x="137" y="25"/>
                      </a:lnTo>
                      <a:lnTo>
                        <a:pt x="137" y="39"/>
                      </a:lnTo>
                      <a:lnTo>
                        <a:pt x="141" y="39"/>
                      </a:lnTo>
                      <a:lnTo>
                        <a:pt x="141" y="39"/>
                      </a:lnTo>
                      <a:lnTo>
                        <a:pt x="175" y="39"/>
                      </a:lnTo>
                      <a:lnTo>
                        <a:pt x="175" y="39"/>
                      </a:lnTo>
                      <a:lnTo>
                        <a:pt x="186" y="39"/>
                      </a:lnTo>
                      <a:lnTo>
                        <a:pt x="186" y="39"/>
                      </a:lnTo>
                      <a:lnTo>
                        <a:pt x="206" y="39"/>
                      </a:lnTo>
                      <a:lnTo>
                        <a:pt x="206" y="39"/>
                      </a:lnTo>
                      <a:lnTo>
                        <a:pt x="217" y="39"/>
                      </a:lnTo>
                      <a:lnTo>
                        <a:pt x="217" y="39"/>
                      </a:lnTo>
                      <a:lnTo>
                        <a:pt x="238" y="39"/>
                      </a:lnTo>
                      <a:lnTo>
                        <a:pt x="238" y="39"/>
                      </a:lnTo>
                      <a:lnTo>
                        <a:pt x="244" y="39"/>
                      </a:lnTo>
                      <a:lnTo>
                        <a:pt x="244" y="39"/>
                      </a:lnTo>
                      <a:lnTo>
                        <a:pt x="255" y="39"/>
                      </a:lnTo>
                      <a:lnTo>
                        <a:pt x="255" y="39"/>
                      </a:lnTo>
                      <a:lnTo>
                        <a:pt x="290" y="39"/>
                      </a:lnTo>
                      <a:lnTo>
                        <a:pt x="290" y="39"/>
                      </a:lnTo>
                      <a:lnTo>
                        <a:pt x="296" y="39"/>
                      </a:lnTo>
                      <a:lnTo>
                        <a:pt x="296" y="39"/>
                      </a:lnTo>
                      <a:lnTo>
                        <a:pt x="302" y="39"/>
                      </a:lnTo>
                      <a:lnTo>
                        <a:pt x="302" y="39"/>
                      </a:lnTo>
                      <a:lnTo>
                        <a:pt x="308" y="39"/>
                      </a:lnTo>
                      <a:lnTo>
                        <a:pt x="308" y="39"/>
                      </a:lnTo>
                      <a:lnTo>
                        <a:pt x="308" y="39"/>
                      </a:lnTo>
                      <a:lnTo>
                        <a:pt x="308" y="39"/>
                      </a:lnTo>
                      <a:lnTo>
                        <a:pt x="314" y="39"/>
                      </a:lnTo>
                      <a:lnTo>
                        <a:pt x="314" y="39"/>
                      </a:lnTo>
                      <a:lnTo>
                        <a:pt x="325" y="39"/>
                      </a:lnTo>
                      <a:lnTo>
                        <a:pt x="325" y="39"/>
                      </a:lnTo>
                      <a:lnTo>
                        <a:pt x="333" y="39"/>
                      </a:lnTo>
                      <a:lnTo>
                        <a:pt x="333" y="39"/>
                      </a:lnTo>
                      <a:lnTo>
                        <a:pt x="384" y="39"/>
                      </a:lnTo>
                      <a:lnTo>
                        <a:pt x="384" y="39"/>
                      </a:lnTo>
                    </a:path>
                  </a:pathLst>
                </a:custGeom>
                <a:noFill/>
                <a:ln w="12700" cap="flat">
                  <a:solidFill>
                    <a:srgbClr val="00FF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" name="Rectangle 24">
                  <a:extLst>
                    <a:ext uri="{FF2B5EF4-FFF2-40B4-BE49-F238E27FC236}">
                      <a16:creationId xmlns:a16="http://schemas.microsoft.com/office/drawing/2014/main" id="{4DE39B03-AC63-4D58-A9C4-7E289F0267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459206" y="27321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6" name="Rectangle 25">
                  <a:extLst>
                    <a:ext uri="{FF2B5EF4-FFF2-40B4-BE49-F238E27FC236}">
                      <a16:creationId xmlns:a16="http://schemas.microsoft.com/office/drawing/2014/main" id="{F351FAE7-EC6E-4E9E-B19A-F386961EE0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772989" y="3070269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7" name="Rectangle 26">
                  <a:extLst>
                    <a:ext uri="{FF2B5EF4-FFF2-40B4-BE49-F238E27FC236}">
                      <a16:creationId xmlns:a16="http://schemas.microsoft.com/office/drawing/2014/main" id="{E107F32F-06D6-44E4-BEB8-3789E61F31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93504" y="167009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210D327E-771B-4EFD-883A-13EA3DA9D96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425390" y="2168569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EEAAF54E-BF6B-4D7D-9533-D14ABB55FC9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48348" y="33274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51737CC4-5426-4E73-969D-D9624FC8CF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54855" y="1114469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D61C39BB-69BE-4C66-BE12-45D86E667C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176836" y="1114469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59EAF0B0-42D9-4A69-9202-E25807AAE27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405100" y="1395457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3" name="Rectangle 32">
                  <a:extLst>
                    <a:ext uri="{FF2B5EF4-FFF2-40B4-BE49-F238E27FC236}">
                      <a16:creationId xmlns:a16="http://schemas.microsoft.com/office/drawing/2014/main" id="{9FCB0879-1170-4018-9D29-905ADE7D86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385787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C71C078C-577F-47EA-9571-9666C41DE1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55111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66398129-A050-4152-BB27-3FB882F8F58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55111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6A6FB892-E382-41A5-B87F-AD8C7617F6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68638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3D3B7B28-21C3-405A-8350-543814A6C36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68638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A98995E0-AC0C-4E86-BC30-A10CD6C5A9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83856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9" name="Rectangle 38">
                  <a:extLst>
                    <a:ext uri="{FF2B5EF4-FFF2-40B4-BE49-F238E27FC236}">
                      <a16:creationId xmlns:a16="http://schemas.microsoft.com/office/drawing/2014/main" id="{983B91BA-459C-4DDB-AA2A-9EC061F198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97382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0" name="Rectangle 39">
                  <a:extLst>
                    <a:ext uri="{FF2B5EF4-FFF2-40B4-BE49-F238E27FC236}">
                      <a16:creationId xmlns:a16="http://schemas.microsoft.com/office/drawing/2014/main" id="{F430E155-DA1B-45DB-8974-0E59D2C65D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537963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1" name="Rectangle 40">
                  <a:extLst>
                    <a:ext uri="{FF2B5EF4-FFF2-40B4-BE49-F238E27FC236}">
                      <a16:creationId xmlns:a16="http://schemas.microsoft.com/office/drawing/2014/main" id="{002A725D-D165-46FD-A904-C12C7A42B6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544726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2" name="Rectangle 41">
                  <a:extLst>
                    <a:ext uri="{FF2B5EF4-FFF2-40B4-BE49-F238E27FC236}">
                      <a16:creationId xmlns:a16="http://schemas.microsoft.com/office/drawing/2014/main" id="{234A9631-2AFC-48DB-9CE7-55C0209296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553180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id="{0BBC29D1-23B7-4371-BA7E-4C7C9CD4EA9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593760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4" name="Rectangle 43">
                  <a:extLst>
                    <a:ext uri="{FF2B5EF4-FFF2-40B4-BE49-F238E27FC236}">
                      <a16:creationId xmlns:a16="http://schemas.microsoft.com/office/drawing/2014/main" id="{67D5888C-7161-4AC0-92A1-806B56149E9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07287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2C6E37D0-8A91-4B1D-83A5-C5C80DF121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29268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6" name="Rectangle 45">
                  <a:extLst>
                    <a:ext uri="{FF2B5EF4-FFF2-40B4-BE49-F238E27FC236}">
                      <a16:creationId xmlns:a16="http://schemas.microsoft.com/office/drawing/2014/main" id="{5D963F45-6FA3-407B-9242-20EDA5D72B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76611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2FE7A591-5601-442D-805A-01CBA71080A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808497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E300C012-7FC1-4E93-A331-4C39B0603D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835550" y="2032044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EF588407-C3F1-48B2-9F33-C63AF3EC02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898112" y="2233657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0" name="Rectangle 49">
                  <a:extLst>
                    <a:ext uri="{FF2B5EF4-FFF2-40B4-BE49-F238E27FC236}">
                      <a16:creationId xmlns:a16="http://schemas.microsoft.com/office/drawing/2014/main" id="{9600F886-CEC6-4021-85ED-E227B97BF9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070577" y="2233657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id="{FED65FF9-38AB-43C6-B89C-54438182DF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112848" y="2233657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2" name="Rectangle 51">
                  <a:extLst>
                    <a:ext uri="{FF2B5EF4-FFF2-40B4-BE49-F238E27FC236}">
                      <a16:creationId xmlns:a16="http://schemas.microsoft.com/office/drawing/2014/main" id="{84B38561-4F17-4254-8C62-663F84F3649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29516" y="2233657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3" name="Rectangle 52">
                  <a:extLst>
                    <a:ext uri="{FF2B5EF4-FFF2-40B4-BE49-F238E27FC236}">
                      <a16:creationId xmlns:a16="http://schemas.microsoft.com/office/drawing/2014/main" id="{68601874-4865-48BD-A751-64A48C6538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347875" y="2233657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4" name="Rectangle 53">
                  <a:extLst>
                    <a:ext uri="{FF2B5EF4-FFF2-40B4-BE49-F238E27FC236}">
                      <a16:creationId xmlns:a16="http://schemas.microsoft.com/office/drawing/2014/main" id="{94DF4EA5-B2C5-4E3C-B361-6CF3ED18DC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457780" y="2233657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5" name="Rectangle 54">
                  <a:extLst>
                    <a:ext uri="{FF2B5EF4-FFF2-40B4-BE49-F238E27FC236}">
                      <a16:creationId xmlns:a16="http://schemas.microsoft.com/office/drawing/2014/main" id="{E41520F7-3EF4-4E46-9BDC-F922A30230E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396645" y="131608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6" name="Rectangle 55">
                  <a:extLst>
                    <a:ext uri="{FF2B5EF4-FFF2-40B4-BE49-F238E27FC236}">
                      <a16:creationId xmlns:a16="http://schemas.microsoft.com/office/drawing/2014/main" id="{2657ECDF-8792-482F-BDE8-AA243B52B39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819355" y="131608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7" name="Rectangle 56">
                  <a:extLst>
                    <a:ext uri="{FF2B5EF4-FFF2-40B4-BE49-F238E27FC236}">
                      <a16:creationId xmlns:a16="http://schemas.microsoft.com/office/drawing/2014/main" id="{2D22C3E9-6868-4ADC-ABAE-071AFF0754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902207" y="131608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8" name="Rectangle 57">
                  <a:extLst>
                    <a:ext uri="{FF2B5EF4-FFF2-40B4-BE49-F238E27FC236}">
                      <a16:creationId xmlns:a16="http://schemas.microsoft.com/office/drawing/2014/main" id="{5415F7DC-CBBB-4CCF-8840-1C308B4A6F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998585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59" name="Rectangle 58">
                  <a:extLst>
                    <a:ext uri="{FF2B5EF4-FFF2-40B4-BE49-F238E27FC236}">
                      <a16:creationId xmlns:a16="http://schemas.microsoft.com/office/drawing/2014/main" id="{C52A69F4-F937-4EB1-9C5B-B639144827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233611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0" name="Rectangle 59">
                  <a:extLst>
                    <a:ext uri="{FF2B5EF4-FFF2-40B4-BE49-F238E27FC236}">
                      <a16:creationId xmlns:a16="http://schemas.microsoft.com/office/drawing/2014/main" id="{899CF6A9-2ADB-49D7-9F8A-5603BF232B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309699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1" name="Rectangle 60">
                  <a:extLst>
                    <a:ext uri="{FF2B5EF4-FFF2-40B4-BE49-F238E27FC236}">
                      <a16:creationId xmlns:a16="http://schemas.microsoft.com/office/drawing/2014/main" id="{FA7F82BA-347E-4B6D-8B38-C0A9FDB36C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48348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2" name="Rectangle 61">
                  <a:extLst>
                    <a:ext uri="{FF2B5EF4-FFF2-40B4-BE49-F238E27FC236}">
                      <a16:creationId xmlns:a16="http://schemas.microsoft.com/office/drawing/2014/main" id="{3C11BD59-4B8E-4B4E-8FE4-56422767D67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524436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3" name="Rectangle 62">
                  <a:extLst>
                    <a:ext uri="{FF2B5EF4-FFF2-40B4-BE49-F238E27FC236}">
                      <a16:creationId xmlns:a16="http://schemas.microsoft.com/office/drawing/2014/main" id="{439CC605-1028-4F9B-A17B-E7F6CAC2B48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69848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4" name="Rectangle 63">
                  <a:extLst>
                    <a:ext uri="{FF2B5EF4-FFF2-40B4-BE49-F238E27FC236}">
                      <a16:creationId xmlns:a16="http://schemas.microsoft.com/office/drawing/2014/main" id="{F8730AD3-6BC0-401E-9F69-67D099B0B4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712119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5" name="Rectangle 64">
                  <a:extLst>
                    <a:ext uri="{FF2B5EF4-FFF2-40B4-BE49-F238E27FC236}">
                      <a16:creationId xmlns:a16="http://schemas.microsoft.com/office/drawing/2014/main" id="{C43E5DFF-A32B-4530-B65A-6308DB6ABDE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788207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6" name="Rectangle 65">
                  <a:extLst>
                    <a:ext uri="{FF2B5EF4-FFF2-40B4-BE49-F238E27FC236}">
                      <a16:creationId xmlns:a16="http://schemas.microsoft.com/office/drawing/2014/main" id="{1C515044-69B8-4A30-B9EA-2D2A1E26B5D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029997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7" name="Rectangle 66">
                  <a:extLst>
                    <a:ext uri="{FF2B5EF4-FFF2-40B4-BE49-F238E27FC236}">
                      <a16:creationId xmlns:a16="http://schemas.microsoft.com/office/drawing/2014/main" id="{21CB7BBA-1A37-4D67-88E4-E78F5C0907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070577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8" name="Rectangle 67">
                  <a:extLst>
                    <a:ext uri="{FF2B5EF4-FFF2-40B4-BE49-F238E27FC236}">
                      <a16:creationId xmlns:a16="http://schemas.microsoft.com/office/drawing/2014/main" id="{2B0532EC-1910-4CBF-A869-0E207582FA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112848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69" name="Rectangle 68">
                  <a:extLst>
                    <a:ext uri="{FF2B5EF4-FFF2-40B4-BE49-F238E27FC236}">
                      <a16:creationId xmlns:a16="http://schemas.microsoft.com/office/drawing/2014/main" id="{1AF49876-8535-4FDD-8D3E-89F27E9B79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153428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0" name="Rectangle 69">
                  <a:extLst>
                    <a:ext uri="{FF2B5EF4-FFF2-40B4-BE49-F238E27FC236}">
                      <a16:creationId xmlns:a16="http://schemas.microsoft.com/office/drawing/2014/main" id="{CB82052E-8B0A-4AA3-9D7D-1DD7CF59E5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153428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1" name="Rectangle 70">
                  <a:extLst>
                    <a:ext uri="{FF2B5EF4-FFF2-40B4-BE49-F238E27FC236}">
                      <a16:creationId xmlns:a16="http://schemas.microsoft.com/office/drawing/2014/main" id="{1683F6E1-CA97-4CAC-A250-887B297546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195699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2" name="Rectangle 71">
                  <a:extLst>
                    <a:ext uri="{FF2B5EF4-FFF2-40B4-BE49-F238E27FC236}">
                      <a16:creationId xmlns:a16="http://schemas.microsoft.com/office/drawing/2014/main" id="{7110F265-357C-4DBF-8821-B3731AB050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271787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3" name="Rectangle 72">
                  <a:extLst>
                    <a:ext uri="{FF2B5EF4-FFF2-40B4-BE49-F238E27FC236}">
                      <a16:creationId xmlns:a16="http://schemas.microsoft.com/office/drawing/2014/main" id="{DAAF8F4E-EEC7-4B15-939E-FC25BF1A092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327585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4" name="Rectangle 73">
                  <a:extLst>
                    <a:ext uri="{FF2B5EF4-FFF2-40B4-BE49-F238E27FC236}">
                      <a16:creationId xmlns:a16="http://schemas.microsoft.com/office/drawing/2014/main" id="{934D1CAB-6FAE-45C1-A793-B4F7A110E3A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679280" y="1436732"/>
                  <a:ext cx="131886" cy="2016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+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5" name="Rectangle 74">
                  <a:extLst>
                    <a:ext uri="{FF2B5EF4-FFF2-40B4-BE49-F238E27FC236}">
                      <a16:creationId xmlns:a16="http://schemas.microsoft.com/office/drawing/2014/main" id="{35412A19-3592-4B18-86E2-02FA0EF9BB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19485" y="3412436"/>
                  <a:ext cx="699159" cy="1761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5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p &lt; 0.0001</a:t>
                  </a:r>
                  <a:endParaRPr kumimoji="0" lang="fr-FR" altLang="fr-FR" sz="1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6" name="Line 63">
                  <a:extLst>
                    <a:ext uri="{FF2B5EF4-FFF2-40B4-BE49-F238E27FC236}">
                      <a16:creationId xmlns:a16="http://schemas.microsoft.com/office/drawing/2014/main" id="{E4045E87-B35F-4593-8969-DA9BFAB8C6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951954" y="1073194"/>
                  <a:ext cx="0" cy="2536825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7" name="Rectangle 76">
                  <a:extLst>
                    <a:ext uri="{FF2B5EF4-FFF2-40B4-BE49-F238E27FC236}">
                      <a16:creationId xmlns:a16="http://schemas.microsoft.com/office/drawing/2014/main" id="{E21E8888-187C-4ACF-8A78-2DD07586A78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18859" y="3440157"/>
                  <a:ext cx="277298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0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8" name="Rectangle 77">
                  <a:extLst>
                    <a:ext uri="{FF2B5EF4-FFF2-40B4-BE49-F238E27FC236}">
                      <a16:creationId xmlns:a16="http://schemas.microsoft.com/office/drawing/2014/main" id="{2DE7913E-18D6-4F8E-81D9-A570CB02FF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18859" y="2868657"/>
                  <a:ext cx="277298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25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79" name="Rectangle 78">
                  <a:extLst>
                    <a:ext uri="{FF2B5EF4-FFF2-40B4-BE49-F238E27FC236}">
                      <a16:creationId xmlns:a16="http://schemas.microsoft.com/office/drawing/2014/main" id="{33B093CA-8FDD-4F3E-84BB-B318C7FECF5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18859" y="2289219"/>
                  <a:ext cx="277298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5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0" name="Rectangle 79">
                  <a:extLst>
                    <a:ext uri="{FF2B5EF4-FFF2-40B4-BE49-F238E27FC236}">
                      <a16:creationId xmlns:a16="http://schemas.microsoft.com/office/drawing/2014/main" id="{4EF1DF24-6978-4AEF-AD50-E5FABBB9FF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18859" y="1717719"/>
                  <a:ext cx="277298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.75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1" name="Rectangle 80">
                  <a:extLst>
                    <a:ext uri="{FF2B5EF4-FFF2-40B4-BE49-F238E27FC236}">
                      <a16:creationId xmlns:a16="http://schemas.microsoft.com/office/drawing/2014/main" id="{8989651A-C2A0-4604-9C87-F3393BA090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18859" y="1138282"/>
                  <a:ext cx="277298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.0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82" name="Line 69">
                  <a:extLst>
                    <a:ext uri="{FF2B5EF4-FFF2-40B4-BE49-F238E27FC236}">
                      <a16:creationId xmlns:a16="http://schemas.microsoft.com/office/drawing/2014/main" id="{267F29BC-346F-46FB-A16D-D5D8B087D7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23210" y="3497307"/>
                  <a:ext cx="28744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3" name="Line 70">
                  <a:extLst>
                    <a:ext uri="{FF2B5EF4-FFF2-40B4-BE49-F238E27FC236}">
                      <a16:creationId xmlns:a16="http://schemas.microsoft.com/office/drawing/2014/main" id="{FABCD264-7295-4AE8-BCBD-0C14648243B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23210" y="2917869"/>
                  <a:ext cx="28744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4" name="Line 71">
                  <a:extLst>
                    <a:ext uri="{FF2B5EF4-FFF2-40B4-BE49-F238E27FC236}">
                      <a16:creationId xmlns:a16="http://schemas.microsoft.com/office/drawing/2014/main" id="{7EA2CEED-DBB6-432B-9712-61B2DCD662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23210" y="2346369"/>
                  <a:ext cx="28744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" name="Line 72">
                  <a:extLst>
                    <a:ext uri="{FF2B5EF4-FFF2-40B4-BE49-F238E27FC236}">
                      <a16:creationId xmlns:a16="http://schemas.microsoft.com/office/drawing/2014/main" id="{D2A461B0-CC31-457D-8175-0EB012D7673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23210" y="1765344"/>
                  <a:ext cx="28744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6" name="Line 73">
                  <a:extLst>
                    <a:ext uri="{FF2B5EF4-FFF2-40B4-BE49-F238E27FC236}">
                      <a16:creationId xmlns:a16="http://schemas.microsoft.com/office/drawing/2014/main" id="{F881A071-B478-46F1-A7EC-5E0F4B8E5B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23210" y="1193844"/>
                  <a:ext cx="28744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7" name="Line 74">
                  <a:extLst>
                    <a:ext uri="{FF2B5EF4-FFF2-40B4-BE49-F238E27FC236}">
                      <a16:creationId xmlns:a16="http://schemas.microsoft.com/office/drawing/2014/main" id="{FDB0D6D8-95D0-42DF-95D7-AB96C8A00F3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51954" y="3610019"/>
                  <a:ext cx="3133127" cy="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8" name="Line 75">
                  <a:extLst>
                    <a:ext uri="{FF2B5EF4-FFF2-40B4-BE49-F238E27FC236}">
                      <a16:creationId xmlns:a16="http://schemas.microsoft.com/office/drawing/2014/main" id="{96D57A6D-0C28-4EC7-99C6-CA52B3A4D83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090603" y="3610019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" name="Line 76">
                  <a:extLst>
                    <a:ext uri="{FF2B5EF4-FFF2-40B4-BE49-F238E27FC236}">
                      <a16:creationId xmlns:a16="http://schemas.microsoft.com/office/drawing/2014/main" id="{050953BE-34BC-4E1C-8768-AFFC7CFA735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802447" y="3610019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" name="Line 77">
                  <a:extLst>
                    <a:ext uri="{FF2B5EF4-FFF2-40B4-BE49-F238E27FC236}">
                      <a16:creationId xmlns:a16="http://schemas.microsoft.com/office/drawing/2014/main" id="{7E3E4F04-18B2-4508-A3B2-33835800D02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8514291" y="3610019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1" name="Line 78">
                  <a:extLst>
                    <a:ext uri="{FF2B5EF4-FFF2-40B4-BE49-F238E27FC236}">
                      <a16:creationId xmlns:a16="http://schemas.microsoft.com/office/drawing/2014/main" id="{A2589DB5-EC9F-42F0-9462-2F771904BDD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227825" y="3610019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2" name="Line 79">
                  <a:extLst>
                    <a:ext uri="{FF2B5EF4-FFF2-40B4-BE49-F238E27FC236}">
                      <a16:creationId xmlns:a16="http://schemas.microsoft.com/office/drawing/2014/main" id="{DB589857-E25B-4F3C-A1F5-7A2874D9B4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9939669" y="3610019"/>
                  <a:ext cx="0" cy="31750"/>
                </a:xfrm>
                <a:prstGeom prst="line">
                  <a:avLst/>
                </a:prstGeom>
                <a:noFill/>
                <a:ln w="63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3" name="Rectangle 92">
                  <a:extLst>
                    <a:ext uri="{FF2B5EF4-FFF2-40B4-BE49-F238E27FC236}">
                      <a16:creationId xmlns:a16="http://schemas.microsoft.com/office/drawing/2014/main" id="{87DC46D9-8DF2-4E08-84ED-99EF0639C4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31424" y="3665582"/>
                  <a:ext cx="118359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4" name="Rectangle 93">
                  <a:extLst>
                    <a:ext uri="{FF2B5EF4-FFF2-40B4-BE49-F238E27FC236}">
                      <a16:creationId xmlns:a16="http://schemas.microsoft.com/office/drawing/2014/main" id="{85987BAE-6ADC-424B-9EE3-BC500E515F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12833" y="3665582"/>
                  <a:ext cx="179229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3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5" name="Rectangle 94">
                  <a:extLst>
                    <a:ext uri="{FF2B5EF4-FFF2-40B4-BE49-F238E27FC236}">
                      <a16:creationId xmlns:a16="http://schemas.microsoft.com/office/drawing/2014/main" id="{C9959793-7566-419F-860B-03BD80E6650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424676" y="3665582"/>
                  <a:ext cx="179229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6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6" name="Rectangle 95">
                  <a:extLst>
                    <a:ext uri="{FF2B5EF4-FFF2-40B4-BE49-F238E27FC236}">
                      <a16:creationId xmlns:a16="http://schemas.microsoft.com/office/drawing/2014/main" id="{F3BD76C8-8888-48C9-9E64-E4EAA04BCBB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138211" y="3665582"/>
                  <a:ext cx="179229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9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7" name="Rectangle 96">
                  <a:extLst>
                    <a:ext uri="{FF2B5EF4-FFF2-40B4-BE49-F238E27FC236}">
                      <a16:creationId xmlns:a16="http://schemas.microsoft.com/office/drawing/2014/main" id="{F406A533-7A2B-4F96-982F-0F6DB6810A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9816238" y="3665582"/>
                  <a:ext cx="246863" cy="1857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2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8" name="Rectangle 97">
                  <a:extLst>
                    <a:ext uri="{FF2B5EF4-FFF2-40B4-BE49-F238E27FC236}">
                      <a16:creationId xmlns:a16="http://schemas.microsoft.com/office/drawing/2014/main" id="{59EF743D-7A37-41C8-A699-6283258277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284786" y="4043407"/>
                  <a:ext cx="4854402" cy="1160463"/>
                </a:xfrm>
                <a:prstGeom prst="rect">
                  <a:avLst/>
                </a:prstGeom>
                <a:noFill/>
                <a:ln w="6350" cap="rnd">
                  <a:solidFill>
                    <a:srgbClr val="FFFF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grpSp>
              <p:nvGrpSpPr>
                <p:cNvPr id="99" name="Groupe 98">
                  <a:extLst>
                    <a:ext uri="{FF2B5EF4-FFF2-40B4-BE49-F238E27FC236}">
                      <a16:creationId xmlns:a16="http://schemas.microsoft.com/office/drawing/2014/main" id="{DC8FEF60-9B10-4C51-89E9-78937F0DFD6E}"/>
                    </a:ext>
                  </a:extLst>
                </p:cNvPr>
                <p:cNvGrpSpPr/>
                <p:nvPr/>
              </p:nvGrpSpPr>
              <p:grpSpPr>
                <a:xfrm>
                  <a:off x="6948351" y="3944472"/>
                  <a:ext cx="3161871" cy="1179895"/>
                  <a:chOff x="6923210" y="4333919"/>
                  <a:chExt cx="3161871" cy="783015"/>
                </a:xfrm>
              </p:grpSpPr>
              <p:sp>
                <p:nvSpPr>
                  <p:cNvPr id="104" name="Rectangle 103">
                    <a:extLst>
                      <a:ext uri="{FF2B5EF4-FFF2-40B4-BE49-F238E27FC236}">
                        <a16:creationId xmlns:a16="http://schemas.microsoft.com/office/drawing/2014/main" id="{5F6F1C22-97ED-49F7-BDB4-6B2D2200B13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0989" y="4341857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1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05" name="Rectangle 104">
                    <a:extLst>
                      <a:ext uri="{FF2B5EF4-FFF2-40B4-BE49-F238E27FC236}">
                        <a16:creationId xmlns:a16="http://schemas.microsoft.com/office/drawing/2014/main" id="{2B406CBD-676C-4FE3-B704-EE6079BE952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743268" y="4341857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2</a:t>
                    </a:r>
                    <a:endPara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06" name="Rectangle 105">
                    <a:extLst>
                      <a:ext uri="{FF2B5EF4-FFF2-40B4-BE49-F238E27FC236}">
                        <a16:creationId xmlns:a16="http://schemas.microsoft.com/office/drawing/2014/main" id="{F8C19101-032C-4B24-AD27-03D68D7A1BC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455111" y="4341857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1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07" name="Rectangle 106">
                    <a:extLst>
                      <a:ext uri="{FF2B5EF4-FFF2-40B4-BE49-F238E27FC236}">
                        <a16:creationId xmlns:a16="http://schemas.microsoft.com/office/drawing/2014/main" id="{C6376E94-D6A6-4692-B725-1E001644CB7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168646" y="4341857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08" name="Rectangle 107">
                    <a:extLst>
                      <a:ext uri="{FF2B5EF4-FFF2-40B4-BE49-F238E27FC236}">
                        <a16:creationId xmlns:a16="http://schemas.microsoft.com/office/drawing/2014/main" id="{7E387EDE-E416-42A8-A7B4-7A9E7E4F104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880490" y="4341857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09" name="Rectangle 108">
                    <a:extLst>
                      <a:ext uri="{FF2B5EF4-FFF2-40B4-BE49-F238E27FC236}">
                        <a16:creationId xmlns:a16="http://schemas.microsoft.com/office/drawing/2014/main" id="{3CFE11C7-23AD-4EF2-98B7-BF89248AA6E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0989" y="4438694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29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0" name="Rectangle 109">
                    <a:extLst>
                      <a:ext uri="{FF2B5EF4-FFF2-40B4-BE49-F238E27FC236}">
                        <a16:creationId xmlns:a16="http://schemas.microsoft.com/office/drawing/2014/main" id="{1FB9DE5A-0491-4155-BF35-C5890458A35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743268" y="4438694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6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1" name="Rectangle 110">
                    <a:extLst>
                      <a:ext uri="{FF2B5EF4-FFF2-40B4-BE49-F238E27FC236}">
                        <a16:creationId xmlns:a16="http://schemas.microsoft.com/office/drawing/2014/main" id="{863EEDE8-B323-4822-AB24-BF8B6367C7B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455111" y="4438694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1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2" name="Rectangle 111">
                    <a:extLst>
                      <a:ext uri="{FF2B5EF4-FFF2-40B4-BE49-F238E27FC236}">
                        <a16:creationId xmlns:a16="http://schemas.microsoft.com/office/drawing/2014/main" id="{91E22AE8-FADE-463C-BA01-553822B95F8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168646" y="4438694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3" name="Rectangle 112">
                    <a:extLst>
                      <a:ext uri="{FF2B5EF4-FFF2-40B4-BE49-F238E27FC236}">
                        <a16:creationId xmlns:a16="http://schemas.microsoft.com/office/drawing/2014/main" id="{4955F1B9-989A-444C-9F5D-0E9BC5DD94B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880490" y="4438694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4" name="Rectangle 113">
                    <a:extLst>
                      <a:ext uri="{FF2B5EF4-FFF2-40B4-BE49-F238E27FC236}">
                        <a16:creationId xmlns:a16="http://schemas.microsoft.com/office/drawing/2014/main" id="{7A0418B8-1EB2-4EF8-B1B2-663D44E1021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0989" y="4543469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43</a:t>
                    </a:r>
                    <a:endPara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5" name="Rectangle 114">
                    <a:extLst>
                      <a:ext uri="{FF2B5EF4-FFF2-40B4-BE49-F238E27FC236}">
                        <a16:creationId xmlns:a16="http://schemas.microsoft.com/office/drawing/2014/main" id="{8A5C8DF6-966A-40A7-9C65-54E643E2616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712833" y="4543469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30</a:t>
                    </a:r>
                    <a:endPara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6" name="Rectangle 115">
                    <a:extLst>
                      <a:ext uri="{FF2B5EF4-FFF2-40B4-BE49-F238E27FC236}">
                        <a16:creationId xmlns:a16="http://schemas.microsoft.com/office/drawing/2014/main" id="{697F130F-BF81-46CD-AE87-BE388421DA8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424676" y="4543469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22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7" name="Rectangle 116">
                    <a:extLst>
                      <a:ext uri="{FF2B5EF4-FFF2-40B4-BE49-F238E27FC236}">
                        <a16:creationId xmlns:a16="http://schemas.microsoft.com/office/drawing/2014/main" id="{FF980F89-DB3C-4398-BDCF-43ADC255A6F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168646" y="4543469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3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8" name="Rectangle 117">
                    <a:extLst>
                      <a:ext uri="{FF2B5EF4-FFF2-40B4-BE49-F238E27FC236}">
                        <a16:creationId xmlns:a16="http://schemas.microsoft.com/office/drawing/2014/main" id="{A154BBF0-EA7B-4402-BB32-98CA2B99014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880490" y="4543469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19" name="Rectangle 118">
                    <a:extLst>
                      <a:ext uri="{FF2B5EF4-FFF2-40B4-BE49-F238E27FC236}">
                        <a16:creationId xmlns:a16="http://schemas.microsoft.com/office/drawing/2014/main" id="{407964DF-04EF-4D7C-8709-2CF70E00CC4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00989" y="4648244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23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20" name="Rectangle 119">
                    <a:extLst>
                      <a:ext uri="{FF2B5EF4-FFF2-40B4-BE49-F238E27FC236}">
                        <a16:creationId xmlns:a16="http://schemas.microsoft.com/office/drawing/2014/main" id="{54B61CAC-AB0E-4817-92C3-1A78B89F642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712833" y="4648244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2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21" name="Rectangle 120">
                    <a:extLst>
                      <a:ext uri="{FF2B5EF4-FFF2-40B4-BE49-F238E27FC236}">
                        <a16:creationId xmlns:a16="http://schemas.microsoft.com/office/drawing/2014/main" id="{3238820E-2A52-4B22-A650-8485A3EEC83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424676" y="4648244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13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22" name="Rectangle 121">
                    <a:extLst>
                      <a:ext uri="{FF2B5EF4-FFF2-40B4-BE49-F238E27FC236}">
                        <a16:creationId xmlns:a16="http://schemas.microsoft.com/office/drawing/2014/main" id="{B798E904-C7CA-4EE9-92E1-08787CE86C2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168646" y="4648244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4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23" name="Rectangle 122">
                    <a:extLst>
                      <a:ext uri="{FF2B5EF4-FFF2-40B4-BE49-F238E27FC236}">
                        <a16:creationId xmlns:a16="http://schemas.microsoft.com/office/drawing/2014/main" id="{BF57180B-A67D-4E79-8DF9-53DE89A9CF5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880490" y="4648244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24" name="Line 124">
                    <a:extLst>
                      <a:ext uri="{FF2B5EF4-FFF2-40B4-BE49-F238E27FC236}">
                        <a16:creationId xmlns:a16="http://schemas.microsoft.com/office/drawing/2014/main" id="{DEE63FB2-6F89-4D0D-B096-92159707CEA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951954" y="4333919"/>
                    <a:ext cx="0" cy="434975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25" name="Line 129">
                    <a:extLst>
                      <a:ext uri="{FF2B5EF4-FFF2-40B4-BE49-F238E27FC236}">
                        <a16:creationId xmlns:a16="http://schemas.microsoft.com/office/drawing/2014/main" id="{83C5D184-0549-4C5B-BD18-2E2BA1DE8159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923210" y="4703807"/>
                    <a:ext cx="2874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26" name="Line 130">
                    <a:extLst>
                      <a:ext uri="{FF2B5EF4-FFF2-40B4-BE49-F238E27FC236}">
                        <a16:creationId xmlns:a16="http://schemas.microsoft.com/office/drawing/2014/main" id="{D8DF53AB-BBE2-419A-A43E-7D803A7B1184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923210" y="4606969"/>
                    <a:ext cx="2874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27" name="Line 131">
                    <a:extLst>
                      <a:ext uri="{FF2B5EF4-FFF2-40B4-BE49-F238E27FC236}">
                        <a16:creationId xmlns:a16="http://schemas.microsoft.com/office/drawing/2014/main" id="{8E16E57B-1A00-4898-87F5-825245D9A18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923210" y="4502194"/>
                    <a:ext cx="2874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28" name="Line 132">
                    <a:extLst>
                      <a:ext uri="{FF2B5EF4-FFF2-40B4-BE49-F238E27FC236}">
                        <a16:creationId xmlns:a16="http://schemas.microsoft.com/office/drawing/2014/main" id="{6440F6E0-500F-48B0-A3C2-313DFB155DB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923210" y="4399007"/>
                    <a:ext cx="28744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29" name="Line 133">
                    <a:extLst>
                      <a:ext uri="{FF2B5EF4-FFF2-40B4-BE49-F238E27FC236}">
                        <a16:creationId xmlns:a16="http://schemas.microsoft.com/office/drawing/2014/main" id="{2F395B66-7895-4CBC-8C71-1F6F1AFD62C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6951954" y="4768894"/>
                    <a:ext cx="3133127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30" name="Line 134">
                    <a:extLst>
                      <a:ext uri="{FF2B5EF4-FFF2-40B4-BE49-F238E27FC236}">
                        <a16:creationId xmlns:a16="http://schemas.microsoft.com/office/drawing/2014/main" id="{8AE16656-35BE-4799-80CD-3C5C607DB21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090603" y="4768894"/>
                    <a:ext cx="0" cy="3175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31" name="Line 135">
                    <a:extLst>
                      <a:ext uri="{FF2B5EF4-FFF2-40B4-BE49-F238E27FC236}">
                        <a16:creationId xmlns:a16="http://schemas.microsoft.com/office/drawing/2014/main" id="{46BEB5D9-3B4B-42EB-B3BE-706BE9F23FEB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02447" y="4768894"/>
                    <a:ext cx="0" cy="3175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32" name="Line 136">
                    <a:extLst>
                      <a:ext uri="{FF2B5EF4-FFF2-40B4-BE49-F238E27FC236}">
                        <a16:creationId xmlns:a16="http://schemas.microsoft.com/office/drawing/2014/main" id="{74CD1BDE-63B0-44F7-AEF1-A7B27B7428E3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514291" y="4768894"/>
                    <a:ext cx="0" cy="3175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33" name="Line 137">
                    <a:extLst>
                      <a:ext uri="{FF2B5EF4-FFF2-40B4-BE49-F238E27FC236}">
                        <a16:creationId xmlns:a16="http://schemas.microsoft.com/office/drawing/2014/main" id="{17458385-22EC-4804-A99C-1CC7042F83E5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227825" y="4768894"/>
                    <a:ext cx="0" cy="3175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34" name="Line 138">
                    <a:extLst>
                      <a:ext uri="{FF2B5EF4-FFF2-40B4-BE49-F238E27FC236}">
                        <a16:creationId xmlns:a16="http://schemas.microsoft.com/office/drawing/2014/main" id="{C52744EC-64BA-41EE-8E03-EBA01DF6691F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939669" y="4768894"/>
                    <a:ext cx="0" cy="31750"/>
                  </a:xfrm>
                  <a:prstGeom prst="line">
                    <a:avLst/>
                  </a:prstGeom>
                  <a:noFill/>
                  <a:ln w="6350" cap="flat">
                    <a:solidFill>
                      <a:srgbClr val="333333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1200"/>
                  </a:p>
                </p:txBody>
              </p:sp>
              <p:sp>
                <p:nvSpPr>
                  <p:cNvPr id="135" name="Rectangle 134">
                    <a:extLst>
                      <a:ext uri="{FF2B5EF4-FFF2-40B4-BE49-F238E27FC236}">
                        <a16:creationId xmlns:a16="http://schemas.microsoft.com/office/drawing/2014/main" id="{91301421-8F09-49E4-9EE6-3171E03F918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031424" y="4824457"/>
                    <a:ext cx="78548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36" name="Rectangle 135">
                    <a:extLst>
                      <a:ext uri="{FF2B5EF4-FFF2-40B4-BE49-F238E27FC236}">
                        <a16:creationId xmlns:a16="http://schemas.microsoft.com/office/drawing/2014/main" id="{1CAFF056-9961-4AA9-A6C8-2C8AA7C2148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712833" y="4824457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3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37" name="Rectangle 136">
                    <a:extLst>
                      <a:ext uri="{FF2B5EF4-FFF2-40B4-BE49-F238E27FC236}">
                        <a16:creationId xmlns:a16="http://schemas.microsoft.com/office/drawing/2014/main" id="{0FF66D58-31AF-4D47-A3AD-AF29249E78D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424676" y="4824457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6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38" name="Rectangle 137">
                    <a:extLst>
                      <a:ext uri="{FF2B5EF4-FFF2-40B4-BE49-F238E27FC236}">
                        <a16:creationId xmlns:a16="http://schemas.microsoft.com/office/drawing/2014/main" id="{3F078550-8DF1-4A95-8B97-0A1B1D26669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138211" y="4824457"/>
                    <a:ext cx="157094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9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39" name="Rectangle 138">
                    <a:extLst>
                      <a:ext uri="{FF2B5EF4-FFF2-40B4-BE49-F238E27FC236}">
                        <a16:creationId xmlns:a16="http://schemas.microsoft.com/office/drawing/2014/main" id="{F7467CF5-3761-4B5E-9328-103059A683A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9816238" y="4824457"/>
                    <a:ext cx="235642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120</a:t>
                    </a:r>
                    <a:endPara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  <p:sp>
                <p:nvSpPr>
                  <p:cNvPr id="140" name="Rectangle 139">
                    <a:extLst>
                      <a:ext uri="{FF2B5EF4-FFF2-40B4-BE49-F238E27FC236}">
                        <a16:creationId xmlns:a16="http://schemas.microsoft.com/office/drawing/2014/main" id="{2B054096-94EC-4F94-8CB6-F5CB6D4B2A5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272501" y="4986382"/>
                    <a:ext cx="484300" cy="13055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 dirty="0" err="1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+mn-lt"/>
                      </a:rPr>
                      <a:t>Months</a:t>
                    </a:r>
                    <a:endPara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+mn-lt"/>
                    </a:endParaRPr>
                  </a:p>
                </p:txBody>
              </p:sp>
            </p:grpSp>
            <p:sp>
              <p:nvSpPr>
                <p:cNvPr id="100" name="Rectangle 270">
                  <a:extLst>
                    <a:ext uri="{FF2B5EF4-FFF2-40B4-BE49-F238E27FC236}">
                      <a16:creationId xmlns:a16="http://schemas.microsoft.com/office/drawing/2014/main" id="{1851FAD0-A156-4C38-BCE6-CF8463CEACF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53231" y="4432641"/>
                  <a:ext cx="758221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Low 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g_Maint</a:t>
                  </a: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FF00"/>
                      </a:solidFill>
                      <a:effectLst/>
                      <a:latin typeface="Arial" panose="020B0604020202020204" pitchFamily="34" charset="0"/>
                    </a:rPr>
                    <a:t>.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1" name="Rectangle 271">
                  <a:extLst>
                    <a:ext uri="{FF2B5EF4-FFF2-40B4-BE49-F238E27FC236}">
                      <a16:creationId xmlns:a16="http://schemas.microsoft.com/office/drawing/2014/main" id="{F6BE5A50-5311-4D90-95E3-99A062EEFBC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96513" y="4276053"/>
                  <a:ext cx="714939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fr-FR" altLang="fr-FR" sz="1000" dirty="0">
                      <a:solidFill>
                        <a:srgbClr val="0000FF"/>
                      </a:solidFill>
                    </a:rPr>
                    <a:t>Lo</a:t>
                  </a: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FF"/>
                      </a:solidFill>
                      <a:effectLst/>
                    </a:rPr>
                    <a:t>w g._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0000FF"/>
                      </a:solidFill>
                      <a:effectLst/>
                    </a:rPr>
                    <a:t>Loss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102" name="Rectangle 272">
                  <a:extLst>
                    <a:ext uri="{FF2B5EF4-FFF2-40B4-BE49-F238E27FC236}">
                      <a16:creationId xmlns:a16="http://schemas.microsoft.com/office/drawing/2014/main" id="{EE4C93D6-4F83-4DE8-9F1B-B72C8C76345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59643" y="4119465"/>
                  <a:ext cx="751809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High </a:t>
                  </a:r>
                  <a:r>
                    <a:rPr kumimoji="0" lang="fr-FR" altLang="fr-FR" sz="1000" b="0" i="0" u="none" strike="noStrike" cap="none" normalizeH="0" baseline="0" dirty="0" err="1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g.</a:t>
                  </a:r>
                  <a:r>
                    <a:rPr lang="fr-FR" altLang="fr-FR" sz="1000" dirty="0" err="1">
                      <a:solidFill>
                        <a:srgbClr val="FF0000"/>
                      </a:solidFill>
                    </a:rPr>
                    <a:t>Maint</a:t>
                  </a:r>
                  <a:r>
                    <a:rPr lang="fr-FR" altLang="fr-FR" sz="1000" dirty="0">
                      <a:solidFill>
                        <a:srgbClr val="FF0000"/>
                      </a:solidFill>
                    </a:rPr>
                    <a:t>.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03" name="Rectangle 273">
                  <a:extLst>
                    <a:ext uri="{FF2B5EF4-FFF2-40B4-BE49-F238E27FC236}">
                      <a16:creationId xmlns:a16="http://schemas.microsoft.com/office/drawing/2014/main" id="{97C17F0A-E796-47DE-B9A0-BD13CD6EFC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67659" y="3974738"/>
                  <a:ext cx="743793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High g._</a:t>
                  </a:r>
                  <a:r>
                    <a:rPr lang="fr-FR" altLang="fr-FR" sz="1000" dirty="0" err="1">
                      <a:solidFill>
                        <a:srgbClr val="000000"/>
                      </a:solidFill>
                    </a:rPr>
                    <a:t>Loss</a:t>
                  </a:r>
                  <a:endParaRPr kumimoji="0" lang="fr-FR" altLang="fr-FR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18" name="Rectangle 231">
                <a:extLst>
                  <a:ext uri="{FF2B5EF4-FFF2-40B4-BE49-F238E27FC236}">
                    <a16:creationId xmlns:a16="http://schemas.microsoft.com/office/drawing/2014/main" id="{D21974DC-576D-451D-A1ED-8144362624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6367004" y="2247896"/>
                <a:ext cx="225425" cy="201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OS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60A5B6C3-9E0F-41C7-A7F0-F3EDF66023FB}"/>
                </a:ext>
              </a:extLst>
            </p:cNvPr>
            <p:cNvSpPr txBox="1"/>
            <p:nvPr/>
          </p:nvSpPr>
          <p:spPr>
            <a:xfrm>
              <a:off x="5750624" y="850302"/>
              <a:ext cx="5100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HC</a:t>
              </a: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714C619A-A5A1-4265-86EB-ABD89D157751}"/>
                </a:ext>
              </a:extLst>
            </p:cNvPr>
            <p:cNvSpPr txBox="1"/>
            <p:nvPr/>
          </p:nvSpPr>
          <p:spPr>
            <a:xfrm>
              <a:off x="6769606" y="152480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171D96CD-A7D8-43C2-8295-1AF5EC81287A}"/>
                </a:ext>
              </a:extLst>
            </p:cNvPr>
            <p:cNvSpPr txBox="1"/>
            <p:nvPr/>
          </p:nvSpPr>
          <p:spPr>
            <a:xfrm>
              <a:off x="6784987" y="235336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C5612668-E415-4235-8BBE-9394FFCA596E}"/>
                </a:ext>
              </a:extLst>
            </p:cNvPr>
            <p:cNvSpPr txBox="1"/>
            <p:nvPr/>
          </p:nvSpPr>
          <p:spPr>
            <a:xfrm>
              <a:off x="5999515" y="2917066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3m</a:t>
              </a: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D8E81453-11B3-47EE-8301-9A711C145E94}"/>
                </a:ext>
              </a:extLst>
            </p:cNvPr>
            <p:cNvSpPr txBox="1"/>
            <p:nvPr/>
          </p:nvSpPr>
          <p:spPr>
            <a:xfrm>
              <a:off x="6108090" y="3282496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20.1m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172E5B9C-BA31-4F55-BA55-38D7BDBDB2B9}"/>
                </a:ext>
              </a:extLst>
            </p:cNvPr>
            <p:cNvSpPr txBox="1"/>
            <p:nvPr/>
          </p:nvSpPr>
          <p:spPr>
            <a:xfrm>
              <a:off x="9354619" y="850299"/>
              <a:ext cx="10759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iagnosis</a:t>
              </a:r>
            </a:p>
          </p:txBody>
        </p:sp>
      </p:grpSp>
      <p:sp>
        <p:nvSpPr>
          <p:cNvPr id="398" name="ZoneTexte 397">
            <a:extLst>
              <a:ext uri="{FF2B5EF4-FFF2-40B4-BE49-F238E27FC236}">
                <a16:creationId xmlns:a16="http://schemas.microsoft.com/office/drawing/2014/main" id="{9EEAEE7A-9D42-49F5-91A0-B9E09E9C088A}"/>
              </a:ext>
            </a:extLst>
          </p:cNvPr>
          <p:cNvSpPr txBox="1"/>
          <p:nvPr/>
        </p:nvSpPr>
        <p:spPr>
          <a:xfrm>
            <a:off x="9165797" y="4742420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sp>
        <p:nvSpPr>
          <p:cNvPr id="399" name="ZoneTexte 398">
            <a:extLst>
              <a:ext uri="{FF2B5EF4-FFF2-40B4-BE49-F238E27FC236}">
                <a16:creationId xmlns:a16="http://schemas.microsoft.com/office/drawing/2014/main" id="{EA27253D-3DB1-4862-B41C-6C68B03616BE}"/>
              </a:ext>
            </a:extLst>
          </p:cNvPr>
          <p:cNvSpPr txBox="1"/>
          <p:nvPr/>
        </p:nvSpPr>
        <p:spPr>
          <a:xfrm>
            <a:off x="768592" y="5369604"/>
            <a:ext cx="1100938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l Figure 1 : </a:t>
            </a:r>
            <a:r>
              <a:rPr lang="en-US" sz="1400" dirty="0"/>
              <a:t>Patients (N=105) were classified in two groups as a function of tumors grade : High (GBM and H3.3mt), low (OD, A, MAPK), and sub-classified in regard to the IHC or TMM testing results. The median survival is indicated.</a:t>
            </a:r>
          </a:p>
          <a:p>
            <a:r>
              <a:rPr lang="en-US" sz="1400" dirty="0"/>
              <a:t>OD: oligodendroglioma, A : </a:t>
            </a:r>
            <a:r>
              <a:rPr lang="en-US" sz="1400" dirty="0" err="1"/>
              <a:t>Astrocyotoma</a:t>
            </a:r>
            <a:r>
              <a:rPr lang="en-US" sz="1400" dirty="0"/>
              <a:t> IDHmt, GBM: Glioblastoma, H3.3mt : histone mutant, MAPK : tumors with MAPK pathway alteration, g. : grade, IHC : immunohistochemistry, TMM: telomere maintenance mechanism</a:t>
            </a:r>
          </a:p>
        </p:txBody>
      </p:sp>
    </p:spTree>
    <p:extLst>
      <p:ext uri="{BB962C8B-B14F-4D97-AF65-F5344CB8AC3E}">
        <p14:creationId xmlns:p14="http://schemas.microsoft.com/office/powerpoint/2010/main" val="9400063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431</Words>
  <Application>Microsoft Office PowerPoint</Application>
  <PresentationFormat>Grand écran</PresentationFormat>
  <Paragraphs>30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lphine Poncet</dc:creator>
  <cp:lastModifiedBy>delphine Poncet</cp:lastModifiedBy>
  <cp:revision>8</cp:revision>
  <dcterms:created xsi:type="dcterms:W3CDTF">2025-09-25T13:56:40Z</dcterms:created>
  <dcterms:modified xsi:type="dcterms:W3CDTF">2025-09-27T16:52:45Z</dcterms:modified>
</cp:coreProperties>
</file>